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3.xml" ContentType="application/vnd.openxmlformats-officedocument.presentationml.notesSl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6" r:id="rId2"/>
    <p:sldId id="273" r:id="rId3"/>
    <p:sldId id="269" r:id="rId4"/>
    <p:sldId id="281" r:id="rId5"/>
    <p:sldId id="283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naliese Mason" initials="ASM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79" autoAdjust="0"/>
    <p:restoredTop sz="96281" autoAdjust="0"/>
  </p:normalViewPr>
  <p:slideViewPr>
    <p:cSldViewPr>
      <p:cViewPr>
        <p:scale>
          <a:sx n="150" d="100"/>
          <a:sy n="150" d="100"/>
        </p:scale>
        <p:origin x="-504" y="4560"/>
      </p:cViewPr>
      <p:guideLst>
        <p:guide orient="horz" pos="2160"/>
        <p:guide pos="52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UNI%20RESEARCH\Active%20Projects\5x-DH\Data\2015-03-25_by%20genome%20chiasma%20and%20allele%20inheritanc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UNI%20RESEARCH\Active%20Projects\5x-DH\Data\2015-03-25_by%20genome%20chiasma%20and%20allele%20inheritanc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UNI%20RESEARCH\Active%20Projects\5x-DH\Data\2015-03-25_by%20genome%20chiasma%20and%20allele%20inheritanc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UNI%20RESEARCH\Active%20Projects\5x-DH\Data\2015-03-25_by%20genome%20chiasma%20and%20allele%20inheritanc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UNI%20RESEARCH\Active%20Projects\5x-DH\Data\2015-03-25_by%20genome%20chiasma%20and%20allele%20inheritance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UNI%20RESEARCH\Active%20Projects\5x-DH\Data\2015-03-25_by%20genome%20chiasma%20and%20allele%20inheritance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UNI%20RESEARCH\Active%20Projects\5x-DH\Data\2014-08-26_Phenotype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8199839671340759E-2"/>
          <c:y val="5.6247655269660149E-2"/>
          <c:w val="0.92719759709958782"/>
          <c:h val="0.88750468946067962"/>
        </c:manualLayout>
      </c:layout>
      <c:lineChart>
        <c:grouping val="standard"/>
        <c:varyColors val="0"/>
        <c:ser>
          <c:idx val="0"/>
          <c:order val="0"/>
          <c:spPr>
            <a:ln w="25400">
              <a:solidFill>
                <a:srgbClr val="002060"/>
              </a:solidFill>
            </a:ln>
          </c:spPr>
          <c:marker>
            <c:symbol val="none"/>
          </c:marker>
          <c:val>
            <c:numRef>
              <c:f>'A genome'!$B$2:$B$387</c:f>
              <c:numCache>
                <c:formatCode>0%</c:formatCode>
                <c:ptCount val="386"/>
                <c:pt idx="0">
                  <c:v>0.60563380281690138</c:v>
                </c:pt>
                <c:pt idx="1">
                  <c:v>0.61971830985915488</c:v>
                </c:pt>
                <c:pt idx="2">
                  <c:v>0.60563380281690138</c:v>
                </c:pt>
                <c:pt idx="3">
                  <c:v>0.54929577464788737</c:v>
                </c:pt>
                <c:pt idx="4">
                  <c:v>0.53521126760563376</c:v>
                </c:pt>
                <c:pt idx="5">
                  <c:v>0.53521126760563376</c:v>
                </c:pt>
                <c:pt idx="6">
                  <c:v>0.54929577464788737</c:v>
                </c:pt>
                <c:pt idx="7">
                  <c:v>0.53521126760563376</c:v>
                </c:pt>
                <c:pt idx="8">
                  <c:v>0.52112676056338025</c:v>
                </c:pt>
                <c:pt idx="9">
                  <c:v>0.53521126760563376</c:v>
                </c:pt>
                <c:pt idx="10">
                  <c:v>0.50704225352112675</c:v>
                </c:pt>
                <c:pt idx="11">
                  <c:v>0.52112676056338025</c:v>
                </c:pt>
                <c:pt idx="12">
                  <c:v>0.53521126760563376</c:v>
                </c:pt>
                <c:pt idx="13">
                  <c:v>0.54929577464788737</c:v>
                </c:pt>
                <c:pt idx="14">
                  <c:v>0.53521126760563376</c:v>
                </c:pt>
                <c:pt idx="15">
                  <c:v>0.54929577464788737</c:v>
                </c:pt>
                <c:pt idx="16">
                  <c:v>0.53521126760563376</c:v>
                </c:pt>
                <c:pt idx="17">
                  <c:v>0.50704225352112675</c:v>
                </c:pt>
                <c:pt idx="18">
                  <c:v>0.50704225352112675</c:v>
                </c:pt>
                <c:pt idx="19">
                  <c:v>0.49295774647887325</c:v>
                </c:pt>
                <c:pt idx="20">
                  <c:v>0.47887323943661969</c:v>
                </c:pt>
                <c:pt idx="21">
                  <c:v>0.45070422535211269</c:v>
                </c:pt>
                <c:pt idx="22">
                  <c:v>0.43661971830985913</c:v>
                </c:pt>
                <c:pt idx="23">
                  <c:v>0.43661971830985913</c:v>
                </c:pt>
                <c:pt idx="24">
                  <c:v>0.42253521126760563</c:v>
                </c:pt>
                <c:pt idx="25">
                  <c:v>0.43661971830985913</c:v>
                </c:pt>
                <c:pt idx="26">
                  <c:v>0.45070422535211269</c:v>
                </c:pt>
                <c:pt idx="27">
                  <c:v>0.46478873239436619</c:v>
                </c:pt>
                <c:pt idx="28">
                  <c:v>0.45070422535211269</c:v>
                </c:pt>
                <c:pt idx="29">
                  <c:v>0.46478873239436619</c:v>
                </c:pt>
                <c:pt idx="30">
                  <c:v>0.47887323943661969</c:v>
                </c:pt>
                <c:pt idx="31">
                  <c:v>0.49295774647887325</c:v>
                </c:pt>
                <c:pt idx="32">
                  <c:v>0.47887323943661969</c:v>
                </c:pt>
                <c:pt idx="33">
                  <c:v>0.46478873239436619</c:v>
                </c:pt>
                <c:pt idx="34">
                  <c:v>0.46478873239436619</c:v>
                </c:pt>
                <c:pt idx="35">
                  <c:v>0.43661971830985913</c:v>
                </c:pt>
                <c:pt idx="36">
                  <c:v>0.45070422535211269</c:v>
                </c:pt>
                <c:pt idx="37">
                  <c:v>0.45070422535211269</c:v>
                </c:pt>
                <c:pt idx="38">
                  <c:v>0.45070422535211269</c:v>
                </c:pt>
                <c:pt idx="39">
                  <c:v>0.46478873239436619</c:v>
                </c:pt>
                <c:pt idx="40">
                  <c:v>0.47887323943661969</c:v>
                </c:pt>
                <c:pt idx="41">
                  <c:v>0.45070422535211269</c:v>
                </c:pt>
                <c:pt idx="42">
                  <c:v>0.43661971830985913</c:v>
                </c:pt>
                <c:pt idx="43">
                  <c:v>0.45070422535211269</c:v>
                </c:pt>
                <c:pt idx="44">
                  <c:v>0.43661971830985913</c:v>
                </c:pt>
                <c:pt idx="45">
                  <c:v>0.42253521126760563</c:v>
                </c:pt>
                <c:pt idx="46">
                  <c:v>0.42253521126760563</c:v>
                </c:pt>
                <c:pt idx="47">
                  <c:v>0.40845070422535212</c:v>
                </c:pt>
                <c:pt idx="48">
                  <c:v>0.42253521126760563</c:v>
                </c:pt>
                <c:pt idx="49">
                  <c:v>0.40845070422535212</c:v>
                </c:pt>
                <c:pt idx="50">
                  <c:v>0.39436619718309857</c:v>
                </c:pt>
                <c:pt idx="51">
                  <c:v>0.36619718309859156</c:v>
                </c:pt>
                <c:pt idx="52">
                  <c:v>0.38028169014084506</c:v>
                </c:pt>
                <c:pt idx="55">
                  <c:v>0.38028169014084506</c:v>
                </c:pt>
                <c:pt idx="56">
                  <c:v>0.38028169014084506</c:v>
                </c:pt>
                <c:pt idx="57">
                  <c:v>0.39436619718309857</c:v>
                </c:pt>
                <c:pt idx="58">
                  <c:v>0.38028169014084506</c:v>
                </c:pt>
                <c:pt idx="59">
                  <c:v>0.39436619718309857</c:v>
                </c:pt>
                <c:pt idx="60">
                  <c:v>0.38028169014084506</c:v>
                </c:pt>
                <c:pt idx="61">
                  <c:v>0.39436619718309857</c:v>
                </c:pt>
                <c:pt idx="62">
                  <c:v>0.38028169014084506</c:v>
                </c:pt>
                <c:pt idx="63">
                  <c:v>0.36619718309859156</c:v>
                </c:pt>
                <c:pt idx="64">
                  <c:v>0.352112676056338</c:v>
                </c:pt>
                <c:pt idx="65">
                  <c:v>0.3380281690140845</c:v>
                </c:pt>
                <c:pt idx="66">
                  <c:v>0.323943661971831</c:v>
                </c:pt>
                <c:pt idx="68">
                  <c:v>0.30985915492957744</c:v>
                </c:pt>
                <c:pt idx="69">
                  <c:v>0.323943661971831</c:v>
                </c:pt>
                <c:pt idx="70">
                  <c:v>0.3380281690140845</c:v>
                </c:pt>
                <c:pt idx="71">
                  <c:v>0.352112676056338</c:v>
                </c:pt>
                <c:pt idx="72">
                  <c:v>0.352112676056338</c:v>
                </c:pt>
                <c:pt idx="73">
                  <c:v>0.3380281690140845</c:v>
                </c:pt>
                <c:pt idx="74">
                  <c:v>0.36619718309859156</c:v>
                </c:pt>
                <c:pt idx="75">
                  <c:v>0.39436619718309857</c:v>
                </c:pt>
                <c:pt idx="76">
                  <c:v>0.38028169014084506</c:v>
                </c:pt>
                <c:pt idx="77">
                  <c:v>0.39436619718309857</c:v>
                </c:pt>
                <c:pt idx="78">
                  <c:v>0.38028169014084506</c:v>
                </c:pt>
                <c:pt idx="79">
                  <c:v>0.38028169014084506</c:v>
                </c:pt>
                <c:pt idx="80">
                  <c:v>0.38028169014084506</c:v>
                </c:pt>
                <c:pt idx="81">
                  <c:v>0.36619718309859156</c:v>
                </c:pt>
                <c:pt idx="82">
                  <c:v>0.38028169014084506</c:v>
                </c:pt>
                <c:pt idx="83">
                  <c:v>0.39436619718309857</c:v>
                </c:pt>
                <c:pt idx="84">
                  <c:v>0.40845070422535212</c:v>
                </c:pt>
                <c:pt idx="85">
                  <c:v>0.40845070422535212</c:v>
                </c:pt>
                <c:pt idx="86">
                  <c:v>0.41428571428571431</c:v>
                </c:pt>
                <c:pt idx="87">
                  <c:v>0.43661971830985913</c:v>
                </c:pt>
                <c:pt idx="88">
                  <c:v>0.45070422535211269</c:v>
                </c:pt>
                <c:pt idx="89">
                  <c:v>0.46478873239436619</c:v>
                </c:pt>
                <c:pt idx="90">
                  <c:v>0.47887323943661969</c:v>
                </c:pt>
                <c:pt idx="91">
                  <c:v>0.46478873239436619</c:v>
                </c:pt>
                <c:pt idx="92">
                  <c:v>0.46478873239436619</c:v>
                </c:pt>
                <c:pt idx="93">
                  <c:v>0.45070422535211269</c:v>
                </c:pt>
                <c:pt idx="94">
                  <c:v>0.46478873239436619</c:v>
                </c:pt>
                <c:pt idx="95">
                  <c:v>0.47887323943661969</c:v>
                </c:pt>
                <c:pt idx="96">
                  <c:v>0.46478873239436619</c:v>
                </c:pt>
                <c:pt idx="97">
                  <c:v>0.47887323943661969</c:v>
                </c:pt>
                <c:pt idx="98">
                  <c:v>0.49295774647887325</c:v>
                </c:pt>
                <c:pt idx="99">
                  <c:v>0.49295774647887325</c:v>
                </c:pt>
                <c:pt idx="100">
                  <c:v>0.46478873239436619</c:v>
                </c:pt>
                <c:pt idx="101">
                  <c:v>0.45070422535211269</c:v>
                </c:pt>
                <c:pt idx="102">
                  <c:v>0.43661971830985913</c:v>
                </c:pt>
                <c:pt idx="103">
                  <c:v>0.45070422535211269</c:v>
                </c:pt>
                <c:pt idx="104">
                  <c:v>0.46478873239436619</c:v>
                </c:pt>
                <c:pt idx="105">
                  <c:v>0.45070422535211269</c:v>
                </c:pt>
                <c:pt idx="106">
                  <c:v>0.43661971830985913</c:v>
                </c:pt>
                <c:pt idx="107">
                  <c:v>0.42253521126760563</c:v>
                </c:pt>
                <c:pt idx="108">
                  <c:v>0.42253521126760563</c:v>
                </c:pt>
                <c:pt idx="109">
                  <c:v>0.40845070422535212</c:v>
                </c:pt>
                <c:pt idx="110">
                  <c:v>0.39436619718309857</c:v>
                </c:pt>
                <c:pt idx="111">
                  <c:v>0.38028169014084506</c:v>
                </c:pt>
                <c:pt idx="112">
                  <c:v>0.39436619718309857</c:v>
                </c:pt>
                <c:pt idx="113">
                  <c:v>0.40845070422535212</c:v>
                </c:pt>
                <c:pt idx="114">
                  <c:v>0.39436619718309857</c:v>
                </c:pt>
                <c:pt idx="115">
                  <c:v>0.41428571428571431</c:v>
                </c:pt>
                <c:pt idx="116">
                  <c:v>0.39436619718309857</c:v>
                </c:pt>
                <c:pt idx="117">
                  <c:v>0.38028169014084506</c:v>
                </c:pt>
                <c:pt idx="118">
                  <c:v>0.39436619718309857</c:v>
                </c:pt>
                <c:pt idx="119">
                  <c:v>0.42253521126760563</c:v>
                </c:pt>
                <c:pt idx="120">
                  <c:v>0.43661971830985913</c:v>
                </c:pt>
                <c:pt idx="121">
                  <c:v>0.46478873239436619</c:v>
                </c:pt>
                <c:pt idx="122">
                  <c:v>0.47887323943661969</c:v>
                </c:pt>
                <c:pt idx="123">
                  <c:v>0.49295774647887325</c:v>
                </c:pt>
                <c:pt idx="124">
                  <c:v>0.50704225352112675</c:v>
                </c:pt>
                <c:pt idx="125">
                  <c:v>0.52112676056338025</c:v>
                </c:pt>
                <c:pt idx="126">
                  <c:v>0.49295774647887325</c:v>
                </c:pt>
                <c:pt idx="127">
                  <c:v>0.47887323943661969</c:v>
                </c:pt>
                <c:pt idx="128">
                  <c:v>0.49295774647887325</c:v>
                </c:pt>
                <c:pt idx="129">
                  <c:v>0.52112676056338025</c:v>
                </c:pt>
                <c:pt idx="130">
                  <c:v>0.52112676056338025</c:v>
                </c:pt>
                <c:pt idx="131">
                  <c:v>0.52112676056338025</c:v>
                </c:pt>
                <c:pt idx="132">
                  <c:v>0.50704225352112675</c:v>
                </c:pt>
                <c:pt idx="133">
                  <c:v>0.49295774647887325</c:v>
                </c:pt>
                <c:pt idx="134">
                  <c:v>0.50704225352112675</c:v>
                </c:pt>
                <c:pt idx="135">
                  <c:v>0.52112676056338025</c:v>
                </c:pt>
                <c:pt idx="136">
                  <c:v>0.53521126760563376</c:v>
                </c:pt>
                <c:pt idx="137">
                  <c:v>0.52112676056338025</c:v>
                </c:pt>
                <c:pt idx="138">
                  <c:v>0.52112676056338025</c:v>
                </c:pt>
                <c:pt idx="139">
                  <c:v>0.53521126760563376</c:v>
                </c:pt>
                <c:pt idx="140">
                  <c:v>0.54929577464788737</c:v>
                </c:pt>
                <c:pt idx="141">
                  <c:v>0.54929577464788737</c:v>
                </c:pt>
                <c:pt idx="142">
                  <c:v>0.53521126760563376</c:v>
                </c:pt>
                <c:pt idx="143">
                  <c:v>0.54929577464788737</c:v>
                </c:pt>
                <c:pt idx="144">
                  <c:v>0.54929577464788737</c:v>
                </c:pt>
                <c:pt idx="146">
                  <c:v>0.52112676056338025</c:v>
                </c:pt>
                <c:pt idx="147">
                  <c:v>0.50704225352112675</c:v>
                </c:pt>
                <c:pt idx="148">
                  <c:v>0.52112676056338025</c:v>
                </c:pt>
                <c:pt idx="149">
                  <c:v>0.50704225352112675</c:v>
                </c:pt>
                <c:pt idx="150">
                  <c:v>0.50704225352112675</c:v>
                </c:pt>
                <c:pt idx="151">
                  <c:v>0.52112676056338025</c:v>
                </c:pt>
                <c:pt idx="152">
                  <c:v>0.50704225352112675</c:v>
                </c:pt>
                <c:pt idx="153">
                  <c:v>0.52112676056338025</c:v>
                </c:pt>
                <c:pt idx="154">
                  <c:v>0.53521126760563376</c:v>
                </c:pt>
                <c:pt idx="155">
                  <c:v>0.52112676056338025</c:v>
                </c:pt>
                <c:pt idx="156">
                  <c:v>0.54929577464788737</c:v>
                </c:pt>
                <c:pt idx="157">
                  <c:v>0.56338028169014087</c:v>
                </c:pt>
                <c:pt idx="158">
                  <c:v>0.57746478873239437</c:v>
                </c:pt>
                <c:pt idx="159">
                  <c:v>0.56338028169014087</c:v>
                </c:pt>
                <c:pt idx="160">
                  <c:v>0.56338028169014087</c:v>
                </c:pt>
                <c:pt idx="161">
                  <c:v>0.59154929577464788</c:v>
                </c:pt>
                <c:pt idx="162">
                  <c:v>0.59154929577464788</c:v>
                </c:pt>
                <c:pt idx="163">
                  <c:v>0.57746478873239437</c:v>
                </c:pt>
                <c:pt idx="164">
                  <c:v>0.57746478873239437</c:v>
                </c:pt>
                <c:pt idx="165">
                  <c:v>0.56338028169014087</c:v>
                </c:pt>
                <c:pt idx="166">
                  <c:v>0.54929577464788737</c:v>
                </c:pt>
                <c:pt idx="167">
                  <c:v>0.53521126760563376</c:v>
                </c:pt>
                <c:pt idx="168">
                  <c:v>0.52112676056338025</c:v>
                </c:pt>
                <c:pt idx="169">
                  <c:v>0.50704225352112675</c:v>
                </c:pt>
                <c:pt idx="170">
                  <c:v>0.49295774647887325</c:v>
                </c:pt>
                <c:pt idx="171">
                  <c:v>0.50704225352112675</c:v>
                </c:pt>
                <c:pt idx="172">
                  <c:v>0.49295774647887325</c:v>
                </c:pt>
                <c:pt idx="173">
                  <c:v>0.47887323943661969</c:v>
                </c:pt>
                <c:pt idx="174">
                  <c:v>0.46478873239436619</c:v>
                </c:pt>
                <c:pt idx="175">
                  <c:v>0.47887323943661969</c:v>
                </c:pt>
                <c:pt idx="176">
                  <c:v>0.46478873239436619</c:v>
                </c:pt>
                <c:pt idx="177">
                  <c:v>0.45070422535211269</c:v>
                </c:pt>
                <c:pt idx="178">
                  <c:v>0.43661971830985913</c:v>
                </c:pt>
                <c:pt idx="179">
                  <c:v>0.42253521126760563</c:v>
                </c:pt>
                <c:pt idx="180">
                  <c:v>0.45070422535211269</c:v>
                </c:pt>
                <c:pt idx="181">
                  <c:v>0.43661971830985913</c:v>
                </c:pt>
                <c:pt idx="182">
                  <c:v>0.45070422535211269</c:v>
                </c:pt>
                <c:pt idx="183">
                  <c:v>0.43661971830985913</c:v>
                </c:pt>
                <c:pt idx="184">
                  <c:v>0.45070422535211269</c:v>
                </c:pt>
                <c:pt idx="185">
                  <c:v>0.45070422535211269</c:v>
                </c:pt>
                <c:pt idx="186">
                  <c:v>0.43661971830985913</c:v>
                </c:pt>
                <c:pt idx="187">
                  <c:v>0.45070422535211269</c:v>
                </c:pt>
                <c:pt idx="188">
                  <c:v>0.43661971830985913</c:v>
                </c:pt>
                <c:pt idx="189">
                  <c:v>0.42253521126760563</c:v>
                </c:pt>
                <c:pt idx="190">
                  <c:v>0.40845070422535212</c:v>
                </c:pt>
                <c:pt idx="191">
                  <c:v>0.39436619718309857</c:v>
                </c:pt>
                <c:pt idx="192">
                  <c:v>0.40845070422535212</c:v>
                </c:pt>
                <c:pt idx="193">
                  <c:v>0.42253521126760563</c:v>
                </c:pt>
                <c:pt idx="194">
                  <c:v>0.43661971830985913</c:v>
                </c:pt>
                <c:pt idx="195">
                  <c:v>0.44285714285714284</c:v>
                </c:pt>
                <c:pt idx="197">
                  <c:v>0.61971830985915488</c:v>
                </c:pt>
                <c:pt idx="198">
                  <c:v>0.63380281690140849</c:v>
                </c:pt>
                <c:pt idx="199">
                  <c:v>0.647887323943662</c:v>
                </c:pt>
                <c:pt idx="200">
                  <c:v>0.63380281690140849</c:v>
                </c:pt>
                <c:pt idx="201">
                  <c:v>0.647887323943662</c:v>
                </c:pt>
                <c:pt idx="202">
                  <c:v>0.61971830985915488</c:v>
                </c:pt>
                <c:pt idx="203">
                  <c:v>0.60563380281690138</c:v>
                </c:pt>
                <c:pt idx="204">
                  <c:v>0.59154929577464788</c:v>
                </c:pt>
                <c:pt idx="205">
                  <c:v>0.57746478873239437</c:v>
                </c:pt>
                <c:pt idx="206">
                  <c:v>0.56338028169014087</c:v>
                </c:pt>
                <c:pt idx="207">
                  <c:v>0.56338028169014087</c:v>
                </c:pt>
                <c:pt idx="208">
                  <c:v>0.57746478873239437</c:v>
                </c:pt>
                <c:pt idx="209">
                  <c:v>0.60563380281690138</c:v>
                </c:pt>
                <c:pt idx="210">
                  <c:v>0.57746478873239437</c:v>
                </c:pt>
                <c:pt idx="211">
                  <c:v>0.56338028169014087</c:v>
                </c:pt>
                <c:pt idx="212">
                  <c:v>0.57746478873239437</c:v>
                </c:pt>
                <c:pt idx="213">
                  <c:v>0.59154929577464788</c:v>
                </c:pt>
                <c:pt idx="214">
                  <c:v>0.60563380281690138</c:v>
                </c:pt>
                <c:pt idx="215">
                  <c:v>0.59154929577464788</c:v>
                </c:pt>
                <c:pt idx="216">
                  <c:v>0.57746478873239437</c:v>
                </c:pt>
                <c:pt idx="217">
                  <c:v>0.56338028169014087</c:v>
                </c:pt>
                <c:pt idx="218">
                  <c:v>0.54929577464788737</c:v>
                </c:pt>
                <c:pt idx="219">
                  <c:v>0.54929577464788737</c:v>
                </c:pt>
                <c:pt idx="220">
                  <c:v>0.53521126760563376</c:v>
                </c:pt>
                <c:pt idx="221">
                  <c:v>0.54929577464788737</c:v>
                </c:pt>
                <c:pt idx="222">
                  <c:v>0.53521126760563376</c:v>
                </c:pt>
                <c:pt idx="223">
                  <c:v>0.50704225352112675</c:v>
                </c:pt>
                <c:pt idx="224">
                  <c:v>0.49295774647887325</c:v>
                </c:pt>
                <c:pt idx="225">
                  <c:v>0.47887323943661969</c:v>
                </c:pt>
                <c:pt idx="226">
                  <c:v>0.46478873239436619</c:v>
                </c:pt>
                <c:pt idx="227">
                  <c:v>0.45070422535211269</c:v>
                </c:pt>
                <c:pt idx="228">
                  <c:v>0.46478873239436619</c:v>
                </c:pt>
                <c:pt idx="229">
                  <c:v>0.47887323943661969</c:v>
                </c:pt>
                <c:pt idx="230">
                  <c:v>0.49295774647887325</c:v>
                </c:pt>
                <c:pt idx="231">
                  <c:v>0.49295774647887325</c:v>
                </c:pt>
                <c:pt idx="232">
                  <c:v>0.50704225352112675</c:v>
                </c:pt>
                <c:pt idx="233">
                  <c:v>0.50704225352112675</c:v>
                </c:pt>
                <c:pt idx="234">
                  <c:v>0.50704225352112675</c:v>
                </c:pt>
                <c:pt idx="235">
                  <c:v>0.49295774647887325</c:v>
                </c:pt>
                <c:pt idx="236">
                  <c:v>0.47887323943661969</c:v>
                </c:pt>
                <c:pt idx="237">
                  <c:v>0.46478873239436619</c:v>
                </c:pt>
                <c:pt idx="238">
                  <c:v>0.42253521126760563</c:v>
                </c:pt>
                <c:pt idx="239">
                  <c:v>0.43661971830985913</c:v>
                </c:pt>
                <c:pt idx="240">
                  <c:v>0.45070422535211269</c:v>
                </c:pt>
                <c:pt idx="241">
                  <c:v>0.43661971830985913</c:v>
                </c:pt>
                <c:pt idx="242">
                  <c:v>0.40579710144927539</c:v>
                </c:pt>
                <c:pt idx="243">
                  <c:v>0.42253521126760563</c:v>
                </c:pt>
                <c:pt idx="244">
                  <c:v>0.43661971830985913</c:v>
                </c:pt>
                <c:pt idx="245">
                  <c:v>0.42253521126760563</c:v>
                </c:pt>
                <c:pt idx="246">
                  <c:v>0.40845070422535212</c:v>
                </c:pt>
                <c:pt idx="247">
                  <c:v>0.39436619718309857</c:v>
                </c:pt>
                <c:pt idx="248">
                  <c:v>0.38028169014084506</c:v>
                </c:pt>
                <c:pt idx="249">
                  <c:v>0.39436619718309857</c:v>
                </c:pt>
                <c:pt idx="253">
                  <c:v>0.45070422535211269</c:v>
                </c:pt>
                <c:pt idx="254">
                  <c:v>0.46478873239436619</c:v>
                </c:pt>
                <c:pt idx="255">
                  <c:v>0.47887323943661969</c:v>
                </c:pt>
                <c:pt idx="256">
                  <c:v>0.47887323943661969</c:v>
                </c:pt>
                <c:pt idx="257">
                  <c:v>0.49295774647887325</c:v>
                </c:pt>
                <c:pt idx="259">
                  <c:v>0.6619718309859155</c:v>
                </c:pt>
                <c:pt idx="260">
                  <c:v>0.68571428571428572</c:v>
                </c:pt>
                <c:pt idx="261">
                  <c:v>0.6619718309859155</c:v>
                </c:pt>
                <c:pt idx="262">
                  <c:v>0.647887323943662</c:v>
                </c:pt>
                <c:pt idx="263">
                  <c:v>0.63380281690140849</c:v>
                </c:pt>
                <c:pt idx="264">
                  <c:v>0.61971830985915488</c:v>
                </c:pt>
                <c:pt idx="265">
                  <c:v>0.61971830985915488</c:v>
                </c:pt>
                <c:pt idx="266">
                  <c:v>0.60563380281690138</c:v>
                </c:pt>
                <c:pt idx="267">
                  <c:v>0.61971830985915488</c:v>
                </c:pt>
                <c:pt idx="268">
                  <c:v>0.63380281690140849</c:v>
                </c:pt>
                <c:pt idx="269">
                  <c:v>0.61971830985915488</c:v>
                </c:pt>
                <c:pt idx="270">
                  <c:v>0.60563380281690138</c:v>
                </c:pt>
                <c:pt idx="271">
                  <c:v>0.59154929577464788</c:v>
                </c:pt>
                <c:pt idx="272">
                  <c:v>0.57746478873239437</c:v>
                </c:pt>
                <c:pt idx="273">
                  <c:v>0.60563380281690138</c:v>
                </c:pt>
                <c:pt idx="274">
                  <c:v>0.61971830985915488</c:v>
                </c:pt>
                <c:pt idx="275">
                  <c:v>0.63380281690140849</c:v>
                </c:pt>
                <c:pt idx="276">
                  <c:v>0.61971830985915488</c:v>
                </c:pt>
                <c:pt idx="277">
                  <c:v>0.59154929577464788</c:v>
                </c:pt>
                <c:pt idx="278">
                  <c:v>0.59154929577464788</c:v>
                </c:pt>
                <c:pt idx="279">
                  <c:v>0.60563380281690138</c:v>
                </c:pt>
                <c:pt idx="280">
                  <c:v>0.57746478873239437</c:v>
                </c:pt>
                <c:pt idx="281">
                  <c:v>0.59154929577464788</c:v>
                </c:pt>
                <c:pt idx="282">
                  <c:v>0.54285714285714282</c:v>
                </c:pt>
                <c:pt idx="283">
                  <c:v>0.56338028169014087</c:v>
                </c:pt>
                <c:pt idx="284">
                  <c:v>0.54929577464788737</c:v>
                </c:pt>
                <c:pt idx="285">
                  <c:v>0.54285714285714282</c:v>
                </c:pt>
                <c:pt idx="286">
                  <c:v>0.52112676056338025</c:v>
                </c:pt>
                <c:pt idx="287">
                  <c:v>0.50704225352112675</c:v>
                </c:pt>
                <c:pt idx="288">
                  <c:v>0.49295774647887325</c:v>
                </c:pt>
                <c:pt idx="289">
                  <c:v>0.48571428571428571</c:v>
                </c:pt>
                <c:pt idx="290">
                  <c:v>0.5</c:v>
                </c:pt>
                <c:pt idx="291">
                  <c:v>0.51428571428571423</c:v>
                </c:pt>
                <c:pt idx="292">
                  <c:v>0.49295774647887325</c:v>
                </c:pt>
                <c:pt idx="293">
                  <c:v>0.47887323943661969</c:v>
                </c:pt>
                <c:pt idx="294">
                  <c:v>0.49295774647887325</c:v>
                </c:pt>
                <c:pt idx="295">
                  <c:v>0.47887323943661969</c:v>
                </c:pt>
                <c:pt idx="296">
                  <c:v>0.49295774647887325</c:v>
                </c:pt>
                <c:pt idx="297">
                  <c:v>0.46478873239436619</c:v>
                </c:pt>
                <c:pt idx="298">
                  <c:v>0.47887323943661969</c:v>
                </c:pt>
                <c:pt idx="299">
                  <c:v>0.49295774647887325</c:v>
                </c:pt>
                <c:pt idx="300">
                  <c:v>0.49295774647887325</c:v>
                </c:pt>
                <c:pt idx="301">
                  <c:v>0.49295774647887325</c:v>
                </c:pt>
                <c:pt idx="303">
                  <c:v>0.46478873239436619</c:v>
                </c:pt>
                <c:pt idx="304">
                  <c:v>0.45070422535211269</c:v>
                </c:pt>
                <c:pt idx="305">
                  <c:v>0.43661971830985913</c:v>
                </c:pt>
                <c:pt idx="306">
                  <c:v>0.45070422535211269</c:v>
                </c:pt>
                <c:pt idx="307">
                  <c:v>0.46478873239436619</c:v>
                </c:pt>
                <c:pt idx="308">
                  <c:v>0.45070422535211269</c:v>
                </c:pt>
                <c:pt idx="309">
                  <c:v>0.46478873239436619</c:v>
                </c:pt>
                <c:pt idx="310">
                  <c:v>0.43661971830985913</c:v>
                </c:pt>
                <c:pt idx="311">
                  <c:v>0.42253521126760563</c:v>
                </c:pt>
                <c:pt idx="312">
                  <c:v>0.43661971830985913</c:v>
                </c:pt>
                <c:pt idx="313">
                  <c:v>0.42253521126760563</c:v>
                </c:pt>
                <c:pt idx="314">
                  <c:v>0.40845070422535212</c:v>
                </c:pt>
                <c:pt idx="315">
                  <c:v>0.40845070422535212</c:v>
                </c:pt>
                <c:pt idx="316">
                  <c:v>0.39436619718309857</c:v>
                </c:pt>
                <c:pt idx="317">
                  <c:v>0.40845070422535212</c:v>
                </c:pt>
                <c:pt idx="318">
                  <c:v>0.42253521126760563</c:v>
                </c:pt>
                <c:pt idx="319">
                  <c:v>0.40845070422535212</c:v>
                </c:pt>
                <c:pt idx="320">
                  <c:v>0.42253521126760563</c:v>
                </c:pt>
                <c:pt idx="321">
                  <c:v>0.43661971830985913</c:v>
                </c:pt>
                <c:pt idx="322">
                  <c:v>0.42253521126760563</c:v>
                </c:pt>
                <c:pt idx="323">
                  <c:v>0.40845070422535212</c:v>
                </c:pt>
                <c:pt idx="324">
                  <c:v>0.40845070422535212</c:v>
                </c:pt>
                <c:pt idx="325">
                  <c:v>0.39436619718309857</c:v>
                </c:pt>
                <c:pt idx="326">
                  <c:v>0.38028169014084506</c:v>
                </c:pt>
                <c:pt idx="327">
                  <c:v>0.39436619718309857</c:v>
                </c:pt>
                <c:pt idx="328">
                  <c:v>0.40845070422535212</c:v>
                </c:pt>
                <c:pt idx="329">
                  <c:v>0.40845070422535212</c:v>
                </c:pt>
                <c:pt idx="330">
                  <c:v>0.42253521126760563</c:v>
                </c:pt>
                <c:pt idx="331">
                  <c:v>0.42253521126760563</c:v>
                </c:pt>
                <c:pt idx="332">
                  <c:v>0.43661971830985913</c:v>
                </c:pt>
                <c:pt idx="333">
                  <c:v>0.45070422535211269</c:v>
                </c:pt>
                <c:pt idx="334">
                  <c:v>0.46478873239436619</c:v>
                </c:pt>
                <c:pt idx="335">
                  <c:v>0.49295774647887325</c:v>
                </c:pt>
                <c:pt idx="336">
                  <c:v>0.52112676056338025</c:v>
                </c:pt>
                <c:pt idx="337">
                  <c:v>0.53521126760563376</c:v>
                </c:pt>
                <c:pt idx="338">
                  <c:v>0.52112676056338025</c:v>
                </c:pt>
                <c:pt idx="339">
                  <c:v>0.51428571428571423</c:v>
                </c:pt>
                <c:pt idx="340">
                  <c:v>0.53521126760563376</c:v>
                </c:pt>
                <c:pt idx="341">
                  <c:v>0.53521126760563376</c:v>
                </c:pt>
                <c:pt idx="343">
                  <c:v>0.6901408450704225</c:v>
                </c:pt>
                <c:pt idx="344">
                  <c:v>0.71830985915492962</c:v>
                </c:pt>
                <c:pt idx="345">
                  <c:v>0.73239436619718312</c:v>
                </c:pt>
                <c:pt idx="346">
                  <c:v>0.74647887323943662</c:v>
                </c:pt>
                <c:pt idx="347">
                  <c:v>0.76056338028169013</c:v>
                </c:pt>
                <c:pt idx="348">
                  <c:v>0.77464788732394363</c:v>
                </c:pt>
                <c:pt idx="349">
                  <c:v>0.76056338028169013</c:v>
                </c:pt>
                <c:pt idx="350">
                  <c:v>0.74647887323943662</c:v>
                </c:pt>
                <c:pt idx="351">
                  <c:v>0.76056338028169013</c:v>
                </c:pt>
                <c:pt idx="353">
                  <c:v>0.52112676056338025</c:v>
                </c:pt>
                <c:pt idx="354">
                  <c:v>0.53521126760563376</c:v>
                </c:pt>
                <c:pt idx="355">
                  <c:v>0.52857142857142858</c:v>
                </c:pt>
                <c:pt idx="356">
                  <c:v>0.49295774647887325</c:v>
                </c:pt>
                <c:pt idx="357">
                  <c:v>0.50704225352112675</c:v>
                </c:pt>
                <c:pt idx="358">
                  <c:v>0.49295774647887325</c:v>
                </c:pt>
                <c:pt idx="359">
                  <c:v>0.46478873239436619</c:v>
                </c:pt>
                <c:pt idx="360">
                  <c:v>0.45070422535211269</c:v>
                </c:pt>
                <c:pt idx="361">
                  <c:v>0.43661971830985913</c:v>
                </c:pt>
                <c:pt idx="362">
                  <c:v>0.43661971830985913</c:v>
                </c:pt>
                <c:pt idx="363">
                  <c:v>0.43661971830985913</c:v>
                </c:pt>
                <c:pt idx="364">
                  <c:v>0.45714285714285713</c:v>
                </c:pt>
                <c:pt idx="365">
                  <c:v>0.39436619718309857</c:v>
                </c:pt>
                <c:pt idx="366">
                  <c:v>0.38028169014084506</c:v>
                </c:pt>
                <c:pt idx="367">
                  <c:v>0.39436619718309857</c:v>
                </c:pt>
                <c:pt idx="368">
                  <c:v>0.39436619718309857</c:v>
                </c:pt>
                <c:pt idx="369">
                  <c:v>0.40845070422535212</c:v>
                </c:pt>
                <c:pt idx="370">
                  <c:v>0.42857142857142855</c:v>
                </c:pt>
                <c:pt idx="371">
                  <c:v>0.40845070422535212</c:v>
                </c:pt>
                <c:pt idx="372">
                  <c:v>0.42253521126760563</c:v>
                </c:pt>
                <c:pt idx="373">
                  <c:v>0.43661971830985913</c:v>
                </c:pt>
                <c:pt idx="374">
                  <c:v>0.43661971830985913</c:v>
                </c:pt>
                <c:pt idx="375">
                  <c:v>0.4</c:v>
                </c:pt>
                <c:pt idx="376">
                  <c:v>0.39436619718309857</c:v>
                </c:pt>
                <c:pt idx="377">
                  <c:v>0.38028169014084506</c:v>
                </c:pt>
                <c:pt idx="378">
                  <c:v>0.352112676056338</c:v>
                </c:pt>
                <c:pt idx="379">
                  <c:v>0.352112676056338</c:v>
                </c:pt>
                <c:pt idx="380">
                  <c:v>0.3380281690140845</c:v>
                </c:pt>
                <c:pt idx="381">
                  <c:v>0.323943661971831</c:v>
                </c:pt>
                <c:pt idx="382">
                  <c:v>0.3380281690140845</c:v>
                </c:pt>
                <c:pt idx="383">
                  <c:v>0.323943661971831</c:v>
                </c:pt>
                <c:pt idx="384">
                  <c:v>0.30985915492957744</c:v>
                </c:pt>
                <c:pt idx="385">
                  <c:v>0.32394366197183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9499264"/>
        <c:axId val="79500800"/>
      </c:lineChart>
      <c:catAx>
        <c:axId val="79499264"/>
        <c:scaling>
          <c:orientation val="minMax"/>
        </c:scaling>
        <c:delete val="1"/>
        <c:axPos val="b"/>
        <c:majorTickMark val="out"/>
        <c:minorTickMark val="none"/>
        <c:tickLblPos val="none"/>
        <c:crossAx val="79500800"/>
        <c:crosses val="autoZero"/>
        <c:auto val="1"/>
        <c:lblAlgn val="ctr"/>
        <c:lblOffset val="100"/>
        <c:noMultiLvlLbl val="0"/>
      </c:catAx>
      <c:valAx>
        <c:axId val="79500800"/>
        <c:scaling>
          <c:orientation val="minMax"/>
          <c:max val="0.85000000000000009"/>
          <c:min val="0.25"/>
        </c:scaling>
        <c:delete val="0"/>
        <c:axPos val="l"/>
        <c:majorGridlines>
          <c:spPr>
            <a:ln>
              <a:noFill/>
            </a:ln>
          </c:spPr>
        </c:majorGridlines>
        <c:numFmt formatCode="0%" sourceLinked="1"/>
        <c:majorTickMark val="out"/>
        <c:minorTickMark val="none"/>
        <c:tickLblPos val="nextTo"/>
        <c:crossAx val="794992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0754311450207314E-2"/>
          <c:y val="8.7244182170973253E-2"/>
          <c:w val="0.93072203294103062"/>
          <c:h val="0.86300423983898444"/>
        </c:manualLayout>
      </c:layout>
      <c:lineChart>
        <c:grouping val="standard"/>
        <c:varyColors val="0"/>
        <c:ser>
          <c:idx val="0"/>
          <c:order val="0"/>
          <c:spPr>
            <a:ln w="25400">
              <a:solidFill>
                <a:srgbClr val="00B0F0"/>
              </a:solidFill>
            </a:ln>
          </c:spPr>
          <c:marker>
            <c:symbol val="none"/>
          </c:marker>
          <c:val>
            <c:numRef>
              <c:f>'A genome'!$E$2:$E$385</c:f>
              <c:numCache>
                <c:formatCode>0%</c:formatCode>
                <c:ptCount val="384"/>
                <c:pt idx="0">
                  <c:v>0.36619718309859156</c:v>
                </c:pt>
                <c:pt idx="1">
                  <c:v>0.352112676056338</c:v>
                </c:pt>
                <c:pt idx="2">
                  <c:v>0.39436619718309857</c:v>
                </c:pt>
                <c:pt idx="3">
                  <c:v>0.40845070422535212</c:v>
                </c:pt>
                <c:pt idx="4">
                  <c:v>0.45070422535211269</c:v>
                </c:pt>
                <c:pt idx="5">
                  <c:v>0.43661971830985913</c:v>
                </c:pt>
                <c:pt idx="6">
                  <c:v>0.43661971830985913</c:v>
                </c:pt>
                <c:pt idx="7">
                  <c:v>0.45070422535211269</c:v>
                </c:pt>
                <c:pt idx="8">
                  <c:v>0.43661971830985913</c:v>
                </c:pt>
                <c:pt idx="9">
                  <c:v>0.46478873239436619</c:v>
                </c:pt>
                <c:pt idx="10">
                  <c:v>0.45070422535211269</c:v>
                </c:pt>
                <c:pt idx="11">
                  <c:v>0.43661971830985913</c:v>
                </c:pt>
                <c:pt idx="12">
                  <c:v>0.42857142857142855</c:v>
                </c:pt>
                <c:pt idx="13">
                  <c:v>0.43661971830985913</c:v>
                </c:pt>
                <c:pt idx="14">
                  <c:v>0.45070422535211269</c:v>
                </c:pt>
                <c:pt idx="15">
                  <c:v>0.42253521126760563</c:v>
                </c:pt>
                <c:pt idx="16">
                  <c:v>0.43661971830985913</c:v>
                </c:pt>
                <c:pt idx="17">
                  <c:v>0.46478873239436619</c:v>
                </c:pt>
                <c:pt idx="18">
                  <c:v>0.46478873239436619</c:v>
                </c:pt>
                <c:pt idx="19">
                  <c:v>0.47887323943661969</c:v>
                </c:pt>
                <c:pt idx="20">
                  <c:v>0.49295774647887325</c:v>
                </c:pt>
                <c:pt idx="21">
                  <c:v>0.52112676056338025</c:v>
                </c:pt>
                <c:pt idx="22">
                  <c:v>0.53521126760563376</c:v>
                </c:pt>
                <c:pt idx="23">
                  <c:v>0.54929577464788737</c:v>
                </c:pt>
                <c:pt idx="24">
                  <c:v>0.56338028169014087</c:v>
                </c:pt>
                <c:pt idx="25">
                  <c:v>0.54929577464788737</c:v>
                </c:pt>
                <c:pt idx="26">
                  <c:v>0.56338028169014087</c:v>
                </c:pt>
                <c:pt idx="27">
                  <c:v>0.54929577464788737</c:v>
                </c:pt>
                <c:pt idx="28">
                  <c:v>0.56338028169014087</c:v>
                </c:pt>
                <c:pt idx="29">
                  <c:v>0.58571428571428574</c:v>
                </c:pt>
                <c:pt idx="30">
                  <c:v>0.59154929577464788</c:v>
                </c:pt>
                <c:pt idx="31">
                  <c:v>0.57746478873239437</c:v>
                </c:pt>
                <c:pt idx="32">
                  <c:v>0.56338028169014087</c:v>
                </c:pt>
                <c:pt idx="33">
                  <c:v>0.54929577464788737</c:v>
                </c:pt>
                <c:pt idx="34">
                  <c:v>0.54929577464788737</c:v>
                </c:pt>
                <c:pt idx="35">
                  <c:v>0.56338028169014087</c:v>
                </c:pt>
                <c:pt idx="36">
                  <c:v>0.56338028169014087</c:v>
                </c:pt>
                <c:pt idx="37">
                  <c:v>0.59154929577464788</c:v>
                </c:pt>
                <c:pt idx="38">
                  <c:v>0.57746478873239437</c:v>
                </c:pt>
                <c:pt idx="39">
                  <c:v>0.57746478873239437</c:v>
                </c:pt>
                <c:pt idx="40">
                  <c:v>0.57746478873239437</c:v>
                </c:pt>
                <c:pt idx="41">
                  <c:v>0.56338028169014087</c:v>
                </c:pt>
                <c:pt idx="42">
                  <c:v>0.54929577464788737</c:v>
                </c:pt>
                <c:pt idx="43">
                  <c:v>0.57746478873239437</c:v>
                </c:pt>
                <c:pt idx="44">
                  <c:v>0.56338028169014087</c:v>
                </c:pt>
                <c:pt idx="45">
                  <c:v>0.57746478873239437</c:v>
                </c:pt>
                <c:pt idx="46">
                  <c:v>0.59154929577464788</c:v>
                </c:pt>
                <c:pt idx="47">
                  <c:v>0.57746478873239437</c:v>
                </c:pt>
                <c:pt idx="48">
                  <c:v>0.59154929577464788</c:v>
                </c:pt>
                <c:pt idx="49">
                  <c:v>0.57746478873239437</c:v>
                </c:pt>
                <c:pt idx="50">
                  <c:v>0.59154929577464788</c:v>
                </c:pt>
                <c:pt idx="51">
                  <c:v>0.60563380281690138</c:v>
                </c:pt>
                <c:pt idx="52">
                  <c:v>0.61971830985915488</c:v>
                </c:pt>
                <c:pt idx="53">
                  <c:v>0.60563380281690138</c:v>
                </c:pt>
                <c:pt idx="68">
                  <c:v>0.59154929577464788</c:v>
                </c:pt>
                <c:pt idx="69">
                  <c:v>0.60563380281690138</c:v>
                </c:pt>
                <c:pt idx="70">
                  <c:v>0.59154929577464788</c:v>
                </c:pt>
                <c:pt idx="71">
                  <c:v>0.57746478873239437</c:v>
                </c:pt>
                <c:pt idx="72">
                  <c:v>0.56338028169014087</c:v>
                </c:pt>
                <c:pt idx="73">
                  <c:v>0.56338028169014087</c:v>
                </c:pt>
                <c:pt idx="74">
                  <c:v>0.57746478873239437</c:v>
                </c:pt>
                <c:pt idx="75">
                  <c:v>0.61971830985915488</c:v>
                </c:pt>
                <c:pt idx="76">
                  <c:v>0.59154929577464788</c:v>
                </c:pt>
                <c:pt idx="77">
                  <c:v>0.57746478873239437</c:v>
                </c:pt>
                <c:pt idx="78">
                  <c:v>0.59154929577464788</c:v>
                </c:pt>
                <c:pt idx="79">
                  <c:v>0.57746478873239437</c:v>
                </c:pt>
                <c:pt idx="80">
                  <c:v>0.59154929577464788</c:v>
                </c:pt>
                <c:pt idx="81">
                  <c:v>0.57746478873239437</c:v>
                </c:pt>
                <c:pt idx="82">
                  <c:v>0.57746478873239437</c:v>
                </c:pt>
                <c:pt idx="83">
                  <c:v>0.59154929577464788</c:v>
                </c:pt>
                <c:pt idx="84">
                  <c:v>0.57746478873239437</c:v>
                </c:pt>
                <c:pt idx="85">
                  <c:v>0.56338028169014087</c:v>
                </c:pt>
                <c:pt idx="86">
                  <c:v>0.54929577464788737</c:v>
                </c:pt>
                <c:pt idx="87">
                  <c:v>0.53521126760563376</c:v>
                </c:pt>
                <c:pt idx="88">
                  <c:v>0.53521126760563376</c:v>
                </c:pt>
                <c:pt idx="89">
                  <c:v>0.52857142857142858</c:v>
                </c:pt>
                <c:pt idx="90">
                  <c:v>0.50704225352112675</c:v>
                </c:pt>
                <c:pt idx="91">
                  <c:v>0.49295774647887325</c:v>
                </c:pt>
                <c:pt idx="92">
                  <c:v>0.47887323943661969</c:v>
                </c:pt>
                <c:pt idx="93">
                  <c:v>0.46478873239436619</c:v>
                </c:pt>
                <c:pt idx="94">
                  <c:v>0.47887323943661969</c:v>
                </c:pt>
                <c:pt idx="95">
                  <c:v>0.47887323943661969</c:v>
                </c:pt>
                <c:pt idx="96">
                  <c:v>0.49295774647887325</c:v>
                </c:pt>
                <c:pt idx="97">
                  <c:v>0.47887323943661969</c:v>
                </c:pt>
                <c:pt idx="98">
                  <c:v>0.46478873239436619</c:v>
                </c:pt>
                <c:pt idx="99">
                  <c:v>0.47887323943661969</c:v>
                </c:pt>
                <c:pt idx="100">
                  <c:v>0.47887323943661969</c:v>
                </c:pt>
                <c:pt idx="101">
                  <c:v>0.46478873239436619</c:v>
                </c:pt>
                <c:pt idx="102">
                  <c:v>0.46478873239436619</c:v>
                </c:pt>
                <c:pt idx="103">
                  <c:v>0.47887323943661969</c:v>
                </c:pt>
                <c:pt idx="104">
                  <c:v>0.49295774647887325</c:v>
                </c:pt>
                <c:pt idx="105">
                  <c:v>0.47887323943661969</c:v>
                </c:pt>
                <c:pt idx="106">
                  <c:v>0.46478873239436619</c:v>
                </c:pt>
                <c:pt idx="107">
                  <c:v>0.47887323943661969</c:v>
                </c:pt>
                <c:pt idx="108">
                  <c:v>0.49295774647887325</c:v>
                </c:pt>
                <c:pt idx="109">
                  <c:v>0.50704225352112675</c:v>
                </c:pt>
                <c:pt idx="110">
                  <c:v>0.50704225352112675</c:v>
                </c:pt>
                <c:pt idx="111">
                  <c:v>0.52112676056338025</c:v>
                </c:pt>
                <c:pt idx="112">
                  <c:v>0.53521126760563376</c:v>
                </c:pt>
                <c:pt idx="113">
                  <c:v>0.54929577464788737</c:v>
                </c:pt>
                <c:pt idx="114">
                  <c:v>0.54929577464788737</c:v>
                </c:pt>
                <c:pt idx="115">
                  <c:v>0.53521126760563376</c:v>
                </c:pt>
                <c:pt idx="116">
                  <c:v>0.51428571428571423</c:v>
                </c:pt>
                <c:pt idx="117">
                  <c:v>0.53521126760563376</c:v>
                </c:pt>
                <c:pt idx="118">
                  <c:v>0.54929577464788737</c:v>
                </c:pt>
                <c:pt idx="119">
                  <c:v>0.53521126760563376</c:v>
                </c:pt>
                <c:pt idx="120">
                  <c:v>0.50704225352112675</c:v>
                </c:pt>
                <c:pt idx="121">
                  <c:v>0.49295774647887325</c:v>
                </c:pt>
                <c:pt idx="122">
                  <c:v>0.47887323943661969</c:v>
                </c:pt>
                <c:pt idx="123">
                  <c:v>0.46478873239436619</c:v>
                </c:pt>
                <c:pt idx="124">
                  <c:v>0.45070422535211269</c:v>
                </c:pt>
                <c:pt idx="125">
                  <c:v>0.43661971830985913</c:v>
                </c:pt>
                <c:pt idx="126">
                  <c:v>0.42253521126760563</c:v>
                </c:pt>
                <c:pt idx="127">
                  <c:v>0.45070422535211269</c:v>
                </c:pt>
                <c:pt idx="128">
                  <c:v>0.46478873239436619</c:v>
                </c:pt>
                <c:pt idx="129">
                  <c:v>0.43661971830985913</c:v>
                </c:pt>
                <c:pt idx="130">
                  <c:v>0.43661971830985913</c:v>
                </c:pt>
                <c:pt idx="131">
                  <c:v>0.45070422535211269</c:v>
                </c:pt>
                <c:pt idx="132">
                  <c:v>0.43661971830985913</c:v>
                </c:pt>
                <c:pt idx="133">
                  <c:v>0.42253521126760563</c:v>
                </c:pt>
                <c:pt idx="134">
                  <c:v>0.43661971830985913</c:v>
                </c:pt>
                <c:pt idx="135">
                  <c:v>0.42253521126760563</c:v>
                </c:pt>
                <c:pt idx="136">
                  <c:v>0.40845070422535212</c:v>
                </c:pt>
                <c:pt idx="137">
                  <c:v>0.40845070422535212</c:v>
                </c:pt>
                <c:pt idx="138">
                  <c:v>0.42253521126760563</c:v>
                </c:pt>
                <c:pt idx="139">
                  <c:v>0.40845070422535212</c:v>
                </c:pt>
                <c:pt idx="146">
                  <c:v>0.46478873239436619</c:v>
                </c:pt>
                <c:pt idx="147">
                  <c:v>0.47887323943661969</c:v>
                </c:pt>
                <c:pt idx="148">
                  <c:v>0.46478873239436619</c:v>
                </c:pt>
                <c:pt idx="149">
                  <c:v>0.47887323943661969</c:v>
                </c:pt>
                <c:pt idx="150">
                  <c:v>0.47887323943661969</c:v>
                </c:pt>
                <c:pt idx="151">
                  <c:v>0.46478873239436619</c:v>
                </c:pt>
                <c:pt idx="152">
                  <c:v>0.47887323943661969</c:v>
                </c:pt>
                <c:pt idx="153">
                  <c:v>0.46478873239436619</c:v>
                </c:pt>
                <c:pt idx="154">
                  <c:v>0.45070422535211269</c:v>
                </c:pt>
                <c:pt idx="155">
                  <c:v>0.46478873239436619</c:v>
                </c:pt>
                <c:pt idx="156">
                  <c:v>0.43661971830985913</c:v>
                </c:pt>
                <c:pt idx="157">
                  <c:v>0.42253521126760563</c:v>
                </c:pt>
                <c:pt idx="158">
                  <c:v>0.40845070422535212</c:v>
                </c:pt>
                <c:pt idx="159">
                  <c:v>0.42253521126760563</c:v>
                </c:pt>
                <c:pt idx="160">
                  <c:v>0.42253521126760563</c:v>
                </c:pt>
                <c:pt idx="161">
                  <c:v>0.39436619718309857</c:v>
                </c:pt>
                <c:pt idx="162">
                  <c:v>0.40845070422535212</c:v>
                </c:pt>
                <c:pt idx="163">
                  <c:v>0.40845070422535212</c:v>
                </c:pt>
                <c:pt idx="164">
                  <c:v>0.42253521126760563</c:v>
                </c:pt>
                <c:pt idx="165">
                  <c:v>0.43661971830985913</c:v>
                </c:pt>
                <c:pt idx="166">
                  <c:v>0.45070422535211269</c:v>
                </c:pt>
                <c:pt idx="167">
                  <c:v>0.46478873239436619</c:v>
                </c:pt>
                <c:pt idx="168">
                  <c:v>0.47887323943661969</c:v>
                </c:pt>
                <c:pt idx="169">
                  <c:v>0.49295774647887325</c:v>
                </c:pt>
                <c:pt idx="170">
                  <c:v>0.47887323943661969</c:v>
                </c:pt>
                <c:pt idx="171">
                  <c:v>0.49295774647887325</c:v>
                </c:pt>
                <c:pt idx="172">
                  <c:v>0.50704225352112675</c:v>
                </c:pt>
                <c:pt idx="173">
                  <c:v>0.52112676056338025</c:v>
                </c:pt>
                <c:pt idx="174">
                  <c:v>0.50704225352112675</c:v>
                </c:pt>
                <c:pt idx="175">
                  <c:v>0.53521126760563376</c:v>
                </c:pt>
                <c:pt idx="176">
                  <c:v>0.54929577464788737</c:v>
                </c:pt>
                <c:pt idx="177">
                  <c:v>0.56338028169014087</c:v>
                </c:pt>
                <c:pt idx="178">
                  <c:v>0.57746478873239437</c:v>
                </c:pt>
                <c:pt idx="179">
                  <c:v>0.54929577464788737</c:v>
                </c:pt>
                <c:pt idx="180">
                  <c:v>0.56338028169014087</c:v>
                </c:pt>
                <c:pt idx="181">
                  <c:v>0.54929577464788737</c:v>
                </c:pt>
                <c:pt idx="182">
                  <c:v>0.56338028169014087</c:v>
                </c:pt>
                <c:pt idx="183">
                  <c:v>0.54929577464788737</c:v>
                </c:pt>
                <c:pt idx="184">
                  <c:v>0.54929577464788737</c:v>
                </c:pt>
                <c:pt idx="185">
                  <c:v>0.56338028169014087</c:v>
                </c:pt>
                <c:pt idx="186">
                  <c:v>0.54929577464788737</c:v>
                </c:pt>
                <c:pt idx="187">
                  <c:v>0.56338028169014087</c:v>
                </c:pt>
                <c:pt idx="188">
                  <c:v>0.57746478873239437</c:v>
                </c:pt>
                <c:pt idx="189">
                  <c:v>0.59154929577464788</c:v>
                </c:pt>
                <c:pt idx="190">
                  <c:v>0.60563380281690138</c:v>
                </c:pt>
                <c:pt idx="191">
                  <c:v>0.59154929577464788</c:v>
                </c:pt>
                <c:pt idx="192">
                  <c:v>0.57746478873239437</c:v>
                </c:pt>
                <c:pt idx="193">
                  <c:v>0.56338028169014087</c:v>
                </c:pt>
                <c:pt idx="194">
                  <c:v>0.55714285714285716</c:v>
                </c:pt>
                <c:pt idx="197">
                  <c:v>0.36619718309859156</c:v>
                </c:pt>
                <c:pt idx="198">
                  <c:v>0.352112676056338</c:v>
                </c:pt>
                <c:pt idx="199">
                  <c:v>0.3380281690140845</c:v>
                </c:pt>
                <c:pt idx="200">
                  <c:v>0.352112676056338</c:v>
                </c:pt>
                <c:pt idx="201">
                  <c:v>0.3380281690140845</c:v>
                </c:pt>
                <c:pt idx="202">
                  <c:v>0.36619718309859156</c:v>
                </c:pt>
                <c:pt idx="203">
                  <c:v>0.38028169014084506</c:v>
                </c:pt>
                <c:pt idx="204">
                  <c:v>0.38028169014084506</c:v>
                </c:pt>
                <c:pt idx="205">
                  <c:v>0.39436619718309857</c:v>
                </c:pt>
                <c:pt idx="206">
                  <c:v>0.40845070422535212</c:v>
                </c:pt>
                <c:pt idx="207">
                  <c:v>0.42253521126760563</c:v>
                </c:pt>
                <c:pt idx="208">
                  <c:v>0.40845070422535212</c:v>
                </c:pt>
                <c:pt idx="209">
                  <c:v>0.38028169014084506</c:v>
                </c:pt>
                <c:pt idx="210">
                  <c:v>0.40845070422535212</c:v>
                </c:pt>
                <c:pt idx="211">
                  <c:v>0.42253521126760563</c:v>
                </c:pt>
                <c:pt idx="212">
                  <c:v>0.40845070422535212</c:v>
                </c:pt>
                <c:pt idx="213">
                  <c:v>0.39436619718309857</c:v>
                </c:pt>
                <c:pt idx="214">
                  <c:v>0.38028169014084506</c:v>
                </c:pt>
                <c:pt idx="215">
                  <c:v>0.39436619718309857</c:v>
                </c:pt>
                <c:pt idx="216">
                  <c:v>0.40845070422535212</c:v>
                </c:pt>
                <c:pt idx="217">
                  <c:v>0.42253521126760563</c:v>
                </c:pt>
                <c:pt idx="218">
                  <c:v>0.43661971830985913</c:v>
                </c:pt>
                <c:pt idx="219">
                  <c:v>0.43661971830985913</c:v>
                </c:pt>
                <c:pt idx="220">
                  <c:v>0.45070422535211269</c:v>
                </c:pt>
                <c:pt idx="221">
                  <c:v>0.43661971830985913</c:v>
                </c:pt>
                <c:pt idx="222">
                  <c:v>0.45070422535211269</c:v>
                </c:pt>
                <c:pt idx="223">
                  <c:v>0.47887323943661969</c:v>
                </c:pt>
                <c:pt idx="224">
                  <c:v>0.49295774647887325</c:v>
                </c:pt>
                <c:pt idx="225">
                  <c:v>0.50704225352112675</c:v>
                </c:pt>
                <c:pt idx="226">
                  <c:v>0.52112676056338025</c:v>
                </c:pt>
                <c:pt idx="227">
                  <c:v>0.53521126760563376</c:v>
                </c:pt>
                <c:pt idx="228">
                  <c:v>0.54929577464788737</c:v>
                </c:pt>
                <c:pt idx="229">
                  <c:v>0.53521126760563376</c:v>
                </c:pt>
                <c:pt idx="230">
                  <c:v>0.53521126760563376</c:v>
                </c:pt>
                <c:pt idx="231">
                  <c:v>0.52112676056338025</c:v>
                </c:pt>
                <c:pt idx="232">
                  <c:v>0.52112676056338025</c:v>
                </c:pt>
                <c:pt idx="233">
                  <c:v>0.53521126760563376</c:v>
                </c:pt>
                <c:pt idx="234">
                  <c:v>0.52112676056338025</c:v>
                </c:pt>
                <c:pt idx="235">
                  <c:v>0.53521126760563376</c:v>
                </c:pt>
                <c:pt idx="236">
                  <c:v>0.53521126760563376</c:v>
                </c:pt>
                <c:pt idx="237">
                  <c:v>0.53521126760563376</c:v>
                </c:pt>
                <c:pt idx="238">
                  <c:v>0.54929577464788737</c:v>
                </c:pt>
                <c:pt idx="239">
                  <c:v>0.56338028169014087</c:v>
                </c:pt>
                <c:pt idx="240">
                  <c:v>0.57746478873239437</c:v>
                </c:pt>
                <c:pt idx="241">
                  <c:v>0.61971830985915488</c:v>
                </c:pt>
                <c:pt idx="242">
                  <c:v>0.60563380281690138</c:v>
                </c:pt>
                <c:pt idx="243">
                  <c:v>0.59154929577464788</c:v>
                </c:pt>
                <c:pt idx="244">
                  <c:v>0.60563380281690138</c:v>
                </c:pt>
                <c:pt idx="245">
                  <c:v>0.62318840579710144</c:v>
                </c:pt>
                <c:pt idx="246">
                  <c:v>0.61971830985915488</c:v>
                </c:pt>
                <c:pt idx="247">
                  <c:v>0.60563380281690138</c:v>
                </c:pt>
                <c:pt idx="248">
                  <c:v>0.61971830985915488</c:v>
                </c:pt>
                <c:pt idx="249">
                  <c:v>0.63380281690140849</c:v>
                </c:pt>
                <c:pt idx="250">
                  <c:v>0.647887323943662</c:v>
                </c:pt>
                <c:pt idx="251">
                  <c:v>0.63380281690140849</c:v>
                </c:pt>
                <c:pt idx="259">
                  <c:v>0.3380281690140845</c:v>
                </c:pt>
                <c:pt idx="260">
                  <c:v>0.31428571428571428</c:v>
                </c:pt>
                <c:pt idx="261">
                  <c:v>0.3380281690140845</c:v>
                </c:pt>
                <c:pt idx="262">
                  <c:v>0.352112676056338</c:v>
                </c:pt>
                <c:pt idx="263">
                  <c:v>0.36619718309859156</c:v>
                </c:pt>
                <c:pt idx="264">
                  <c:v>0.38028169014084506</c:v>
                </c:pt>
                <c:pt idx="265">
                  <c:v>0.38028169014084506</c:v>
                </c:pt>
                <c:pt idx="266">
                  <c:v>0.39436619718309857</c:v>
                </c:pt>
                <c:pt idx="267">
                  <c:v>0.40845070422535212</c:v>
                </c:pt>
                <c:pt idx="268">
                  <c:v>0.39436619718309857</c:v>
                </c:pt>
                <c:pt idx="269">
                  <c:v>0.40845070422535212</c:v>
                </c:pt>
                <c:pt idx="270">
                  <c:v>0.42253521126760563</c:v>
                </c:pt>
                <c:pt idx="271">
                  <c:v>0.43661971830985913</c:v>
                </c:pt>
                <c:pt idx="272">
                  <c:v>0.45070422535211269</c:v>
                </c:pt>
                <c:pt idx="273">
                  <c:v>0.42253521126760563</c:v>
                </c:pt>
                <c:pt idx="274">
                  <c:v>0.40845070422535212</c:v>
                </c:pt>
                <c:pt idx="275">
                  <c:v>0.39436619718309857</c:v>
                </c:pt>
                <c:pt idx="276">
                  <c:v>0.40845070422535212</c:v>
                </c:pt>
                <c:pt idx="277">
                  <c:v>0.43661971830985913</c:v>
                </c:pt>
                <c:pt idx="278">
                  <c:v>0.43661971830985913</c:v>
                </c:pt>
                <c:pt idx="279">
                  <c:v>0.42253521126760563</c:v>
                </c:pt>
                <c:pt idx="280">
                  <c:v>0.45070422535211269</c:v>
                </c:pt>
                <c:pt idx="281">
                  <c:v>0.43661971830985913</c:v>
                </c:pt>
                <c:pt idx="282">
                  <c:v>0.47142857142857142</c:v>
                </c:pt>
                <c:pt idx="283">
                  <c:v>0.46478873239436619</c:v>
                </c:pt>
                <c:pt idx="284">
                  <c:v>0.47887323943661969</c:v>
                </c:pt>
                <c:pt idx="285">
                  <c:v>0.48571428571428571</c:v>
                </c:pt>
                <c:pt idx="286">
                  <c:v>0.50704225352112675</c:v>
                </c:pt>
                <c:pt idx="287">
                  <c:v>0.50704225352112675</c:v>
                </c:pt>
                <c:pt idx="288">
                  <c:v>0.52112676056338025</c:v>
                </c:pt>
                <c:pt idx="289">
                  <c:v>0.50704225352112675</c:v>
                </c:pt>
                <c:pt idx="290">
                  <c:v>0.52112676056338025</c:v>
                </c:pt>
                <c:pt idx="291">
                  <c:v>0.49295774647887325</c:v>
                </c:pt>
                <c:pt idx="292">
                  <c:v>0.47887323943661969</c:v>
                </c:pt>
                <c:pt idx="293">
                  <c:v>0.47887323943661969</c:v>
                </c:pt>
                <c:pt idx="294">
                  <c:v>0.47887323943661969</c:v>
                </c:pt>
                <c:pt idx="295">
                  <c:v>0.49295774647887325</c:v>
                </c:pt>
                <c:pt idx="296">
                  <c:v>0.50704225352112675</c:v>
                </c:pt>
                <c:pt idx="297">
                  <c:v>0.47887323943661969</c:v>
                </c:pt>
                <c:pt idx="298">
                  <c:v>0.49295774647887325</c:v>
                </c:pt>
                <c:pt idx="299">
                  <c:v>0.74647887323943662</c:v>
                </c:pt>
                <c:pt idx="303">
                  <c:v>0.52112676056338025</c:v>
                </c:pt>
                <c:pt idx="304">
                  <c:v>0.53521126760563376</c:v>
                </c:pt>
                <c:pt idx="305">
                  <c:v>0.54929577464788737</c:v>
                </c:pt>
                <c:pt idx="306">
                  <c:v>0.53521126760563376</c:v>
                </c:pt>
                <c:pt idx="307">
                  <c:v>0.52112676056338025</c:v>
                </c:pt>
                <c:pt idx="308">
                  <c:v>0.53521126760563376</c:v>
                </c:pt>
                <c:pt idx="309">
                  <c:v>0.52112676056338025</c:v>
                </c:pt>
                <c:pt idx="310">
                  <c:v>0.54929577464788737</c:v>
                </c:pt>
                <c:pt idx="311">
                  <c:v>0.56338028169014087</c:v>
                </c:pt>
                <c:pt idx="312">
                  <c:v>0.54929577464788737</c:v>
                </c:pt>
                <c:pt idx="313">
                  <c:v>0.56338028169014087</c:v>
                </c:pt>
                <c:pt idx="314">
                  <c:v>0.57746478873239437</c:v>
                </c:pt>
                <c:pt idx="315">
                  <c:v>0.57746478873239437</c:v>
                </c:pt>
                <c:pt idx="316">
                  <c:v>0.59154929577464788</c:v>
                </c:pt>
                <c:pt idx="317">
                  <c:v>0.57746478873239437</c:v>
                </c:pt>
                <c:pt idx="318">
                  <c:v>0.56338028169014087</c:v>
                </c:pt>
                <c:pt idx="319">
                  <c:v>0.57746478873239437</c:v>
                </c:pt>
                <c:pt idx="320">
                  <c:v>0.56338028169014087</c:v>
                </c:pt>
                <c:pt idx="321">
                  <c:v>0.54929577464788737</c:v>
                </c:pt>
                <c:pt idx="322">
                  <c:v>0.56338028169014087</c:v>
                </c:pt>
                <c:pt idx="323">
                  <c:v>0.57746478873239437</c:v>
                </c:pt>
                <c:pt idx="324">
                  <c:v>0.57746478873239437</c:v>
                </c:pt>
                <c:pt idx="325">
                  <c:v>0.59154929577464788</c:v>
                </c:pt>
                <c:pt idx="326">
                  <c:v>0.60563380281690138</c:v>
                </c:pt>
                <c:pt idx="327">
                  <c:v>0.59154929577464788</c:v>
                </c:pt>
                <c:pt idx="328">
                  <c:v>0.57746478873239437</c:v>
                </c:pt>
                <c:pt idx="329">
                  <c:v>0.57746478873239437</c:v>
                </c:pt>
                <c:pt idx="330">
                  <c:v>0.56338028169014087</c:v>
                </c:pt>
                <c:pt idx="331">
                  <c:v>0.56338028169014087</c:v>
                </c:pt>
                <c:pt idx="332">
                  <c:v>0.54929577464788737</c:v>
                </c:pt>
                <c:pt idx="333">
                  <c:v>0.53521126760563376</c:v>
                </c:pt>
                <c:pt idx="334">
                  <c:v>0.52112676056338025</c:v>
                </c:pt>
                <c:pt idx="335">
                  <c:v>0.49295774647887325</c:v>
                </c:pt>
                <c:pt idx="336">
                  <c:v>0.46478873239436619</c:v>
                </c:pt>
                <c:pt idx="337">
                  <c:v>0.45070422535211269</c:v>
                </c:pt>
                <c:pt idx="338">
                  <c:v>0.46478873239436619</c:v>
                </c:pt>
                <c:pt idx="339">
                  <c:v>0.47142857142857142</c:v>
                </c:pt>
                <c:pt idx="340">
                  <c:v>0.45070422535211269</c:v>
                </c:pt>
                <c:pt idx="341">
                  <c:v>0.45070422535211269</c:v>
                </c:pt>
                <c:pt idx="353">
                  <c:v>0.49295774647887325</c:v>
                </c:pt>
                <c:pt idx="354">
                  <c:v>0.47887323943661969</c:v>
                </c:pt>
                <c:pt idx="355">
                  <c:v>0.48571428571428571</c:v>
                </c:pt>
                <c:pt idx="356">
                  <c:v>0.52112676056338025</c:v>
                </c:pt>
                <c:pt idx="357">
                  <c:v>0.50704225352112675</c:v>
                </c:pt>
                <c:pt idx="358">
                  <c:v>0.52112676056338025</c:v>
                </c:pt>
                <c:pt idx="359">
                  <c:v>0.54929577464788737</c:v>
                </c:pt>
                <c:pt idx="360">
                  <c:v>0.56338028169014087</c:v>
                </c:pt>
                <c:pt idx="361">
                  <c:v>0.57746478873239437</c:v>
                </c:pt>
                <c:pt idx="362">
                  <c:v>0.57746478873239437</c:v>
                </c:pt>
                <c:pt idx="363">
                  <c:v>0.57746478873239437</c:v>
                </c:pt>
                <c:pt idx="364">
                  <c:v>0.55714285714285716</c:v>
                </c:pt>
                <c:pt idx="365">
                  <c:v>0.61971830985915488</c:v>
                </c:pt>
                <c:pt idx="366">
                  <c:v>0.63380281690140849</c:v>
                </c:pt>
                <c:pt idx="367">
                  <c:v>0.61971830985915488</c:v>
                </c:pt>
                <c:pt idx="368">
                  <c:v>0.61971830985915488</c:v>
                </c:pt>
                <c:pt idx="369">
                  <c:v>0.60563380281690138</c:v>
                </c:pt>
                <c:pt idx="370">
                  <c:v>0.58571428571428574</c:v>
                </c:pt>
                <c:pt idx="371">
                  <c:v>0.60563380281690138</c:v>
                </c:pt>
                <c:pt idx="372">
                  <c:v>0.59154929577464788</c:v>
                </c:pt>
                <c:pt idx="373">
                  <c:v>0.57746478873239437</c:v>
                </c:pt>
                <c:pt idx="374">
                  <c:v>0.57746478873239437</c:v>
                </c:pt>
                <c:pt idx="375">
                  <c:v>0.8</c:v>
                </c:pt>
                <c:pt idx="376">
                  <c:v>0.81690140845070425</c:v>
                </c:pt>
                <c:pt idx="377">
                  <c:v>0.83098591549295775</c:v>
                </c:pt>
                <c:pt idx="378">
                  <c:v>0.83098591549295775</c:v>
                </c:pt>
                <c:pt idx="379">
                  <c:v>0.83098591549295775</c:v>
                </c:pt>
                <c:pt idx="380">
                  <c:v>0.81690140845070425</c:v>
                </c:pt>
                <c:pt idx="381">
                  <c:v>0.83098591549295775</c:v>
                </c:pt>
                <c:pt idx="382">
                  <c:v>0.81690140845070425</c:v>
                </c:pt>
                <c:pt idx="383">
                  <c:v>0.8309859154929577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9569664"/>
        <c:axId val="79571200"/>
      </c:lineChart>
      <c:catAx>
        <c:axId val="79569664"/>
        <c:scaling>
          <c:orientation val="minMax"/>
        </c:scaling>
        <c:delete val="1"/>
        <c:axPos val="b"/>
        <c:majorTickMark val="out"/>
        <c:minorTickMark val="none"/>
        <c:tickLblPos val="none"/>
        <c:crossAx val="79571200"/>
        <c:crosses val="autoZero"/>
        <c:auto val="1"/>
        <c:lblAlgn val="ctr"/>
        <c:lblOffset val="100"/>
        <c:noMultiLvlLbl val="0"/>
      </c:catAx>
      <c:valAx>
        <c:axId val="79571200"/>
        <c:scaling>
          <c:orientation val="minMax"/>
          <c:max val="0.85000000000000009"/>
          <c:min val="0.25"/>
        </c:scaling>
        <c:delete val="0"/>
        <c:axPos val="l"/>
        <c:majorGridlines>
          <c:spPr>
            <a:ln>
              <a:noFill/>
            </a:ln>
          </c:spPr>
        </c:majorGridlines>
        <c:numFmt formatCode="0%" sourceLinked="1"/>
        <c:majorTickMark val="out"/>
        <c:minorTickMark val="none"/>
        <c:tickLblPos val="nextTo"/>
        <c:crossAx val="7956966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745361944376039"/>
          <c:y val="3.4226760353575414E-2"/>
          <c:w val="0.86677098219912729"/>
          <c:h val="0.85495495875818006"/>
        </c:manualLayout>
      </c:layout>
      <c:lineChart>
        <c:grouping val="standard"/>
        <c:varyColors val="0"/>
        <c:ser>
          <c:idx val="0"/>
          <c:order val="0"/>
          <c:tx>
            <c:v>B. carinata</c:v>
          </c:tx>
          <c:spPr>
            <a:ln>
              <a:solidFill>
                <a:srgbClr val="92D050"/>
              </a:solidFill>
            </a:ln>
          </c:spPr>
          <c:marker>
            <c:symbol val="none"/>
          </c:marker>
          <c:cat>
            <c:strRef>
              <c:f>'B alleles'!$A$2:$A$57</c:f>
              <c:strCache>
                <c:ptCount val="56"/>
                <c:pt idx="0">
                  <c:v>Bc1_01</c:v>
                </c:pt>
                <c:pt idx="1">
                  <c:v>Bc1_02</c:v>
                </c:pt>
                <c:pt idx="2">
                  <c:v>Bc1_03</c:v>
                </c:pt>
                <c:pt idx="3">
                  <c:v>Bc1_04</c:v>
                </c:pt>
                <c:pt idx="5">
                  <c:v>Bc2_01</c:v>
                </c:pt>
                <c:pt idx="6">
                  <c:v>Bc2_02</c:v>
                </c:pt>
                <c:pt idx="7">
                  <c:v>Bc2_03</c:v>
                </c:pt>
                <c:pt idx="8">
                  <c:v>Bc2_04</c:v>
                </c:pt>
                <c:pt idx="9">
                  <c:v>Bc2_05</c:v>
                </c:pt>
                <c:pt idx="10">
                  <c:v>Bc2_06</c:v>
                </c:pt>
                <c:pt idx="19">
                  <c:v>Bc4_01</c:v>
                </c:pt>
                <c:pt idx="20">
                  <c:v>Bc4_02</c:v>
                </c:pt>
                <c:pt idx="21">
                  <c:v>Bc4_03</c:v>
                </c:pt>
                <c:pt idx="22">
                  <c:v>Bc4_04</c:v>
                </c:pt>
                <c:pt idx="23">
                  <c:v>Bc4_05</c:v>
                </c:pt>
                <c:pt idx="24">
                  <c:v>Bc4_06</c:v>
                </c:pt>
                <c:pt idx="27">
                  <c:v>Bc5_01</c:v>
                </c:pt>
                <c:pt idx="28">
                  <c:v>Bc5_02</c:v>
                </c:pt>
                <c:pt idx="29">
                  <c:v>Bc5_03</c:v>
                </c:pt>
                <c:pt idx="30">
                  <c:v>Bc5_04</c:v>
                </c:pt>
                <c:pt idx="31">
                  <c:v>Bc5_05</c:v>
                </c:pt>
                <c:pt idx="32">
                  <c:v>Bc5_06</c:v>
                </c:pt>
                <c:pt idx="33">
                  <c:v>Bc5_07</c:v>
                </c:pt>
                <c:pt idx="35">
                  <c:v>Bc6_01</c:v>
                </c:pt>
                <c:pt idx="36">
                  <c:v>Bc6_02</c:v>
                </c:pt>
                <c:pt idx="37">
                  <c:v>Bc6_03</c:v>
                </c:pt>
                <c:pt idx="38">
                  <c:v>Bc6_04</c:v>
                </c:pt>
                <c:pt idx="39">
                  <c:v>Bc6_05</c:v>
                </c:pt>
                <c:pt idx="40">
                  <c:v>Bc6_06</c:v>
                </c:pt>
                <c:pt idx="41">
                  <c:v>Bc6_07</c:v>
                </c:pt>
                <c:pt idx="42">
                  <c:v>Bc6_08</c:v>
                </c:pt>
                <c:pt idx="50">
                  <c:v>Bc8_01</c:v>
                </c:pt>
                <c:pt idx="51">
                  <c:v>Bc8_02</c:v>
                </c:pt>
                <c:pt idx="52">
                  <c:v>Bc8_03</c:v>
                </c:pt>
                <c:pt idx="53">
                  <c:v>Bc8_04</c:v>
                </c:pt>
                <c:pt idx="54">
                  <c:v>Bc8_05</c:v>
                </c:pt>
                <c:pt idx="55">
                  <c:v>Bc8_06</c:v>
                </c:pt>
              </c:strCache>
            </c:strRef>
          </c:cat>
          <c:val>
            <c:numRef>
              <c:f>'B alleles'!$B$2:$B$57</c:f>
              <c:numCache>
                <c:formatCode>0%</c:formatCode>
                <c:ptCount val="56"/>
                <c:pt idx="0">
                  <c:v>0.47887323943661969</c:v>
                </c:pt>
                <c:pt idx="1">
                  <c:v>0.53521126760563376</c:v>
                </c:pt>
                <c:pt idx="2">
                  <c:v>0.63380281690140849</c:v>
                </c:pt>
                <c:pt idx="3">
                  <c:v>0.45070422535211274</c:v>
                </c:pt>
                <c:pt idx="5">
                  <c:v>0.50769230769230766</c:v>
                </c:pt>
                <c:pt idx="6">
                  <c:v>0.49275362318840588</c:v>
                </c:pt>
                <c:pt idx="7">
                  <c:v>0.46268656716417911</c:v>
                </c:pt>
                <c:pt idx="8">
                  <c:v>0.46478873239436619</c:v>
                </c:pt>
                <c:pt idx="9">
                  <c:v>0.45070422535211274</c:v>
                </c:pt>
                <c:pt idx="10">
                  <c:v>0.38028169014084506</c:v>
                </c:pt>
                <c:pt idx="19">
                  <c:v>0.38235294117647056</c:v>
                </c:pt>
                <c:pt idx="20">
                  <c:v>0.61971830985915488</c:v>
                </c:pt>
                <c:pt idx="21">
                  <c:v>0.59154929577464788</c:v>
                </c:pt>
                <c:pt idx="22">
                  <c:v>0.58571428571428574</c:v>
                </c:pt>
                <c:pt idx="23">
                  <c:v>0.52459016393442626</c:v>
                </c:pt>
                <c:pt idx="24">
                  <c:v>0.57971014492753625</c:v>
                </c:pt>
                <c:pt idx="27">
                  <c:v>0.39436619718309857</c:v>
                </c:pt>
                <c:pt idx="28">
                  <c:v>0.45714285714285713</c:v>
                </c:pt>
                <c:pt idx="29">
                  <c:v>0.47887323943661969</c:v>
                </c:pt>
                <c:pt idx="30">
                  <c:v>0.47887323943661969</c:v>
                </c:pt>
                <c:pt idx="31">
                  <c:v>0.48529411764705882</c:v>
                </c:pt>
                <c:pt idx="32">
                  <c:v>0.47826086956521741</c:v>
                </c:pt>
                <c:pt idx="33">
                  <c:v>0.54929577464788737</c:v>
                </c:pt>
                <c:pt idx="35">
                  <c:v>0.5357142857142857</c:v>
                </c:pt>
                <c:pt idx="36">
                  <c:v>0.53623188405797106</c:v>
                </c:pt>
                <c:pt idx="37">
                  <c:v>0.50704225352112675</c:v>
                </c:pt>
                <c:pt idx="38">
                  <c:v>0.46478873239436619</c:v>
                </c:pt>
                <c:pt idx="39">
                  <c:v>0.46666666666666662</c:v>
                </c:pt>
                <c:pt idx="40">
                  <c:v>0.43661971830985913</c:v>
                </c:pt>
                <c:pt idx="41">
                  <c:v>0.57971014492753625</c:v>
                </c:pt>
                <c:pt idx="42">
                  <c:v>0.51428571428571423</c:v>
                </c:pt>
                <c:pt idx="50">
                  <c:v>0.45161290322580638</c:v>
                </c:pt>
                <c:pt idx="51">
                  <c:v>0.49295774647887325</c:v>
                </c:pt>
                <c:pt idx="52">
                  <c:v>0.51428571428571423</c:v>
                </c:pt>
                <c:pt idx="53">
                  <c:v>0.5</c:v>
                </c:pt>
                <c:pt idx="54">
                  <c:v>0.52459016393442626</c:v>
                </c:pt>
                <c:pt idx="55">
                  <c:v>0.562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3876224"/>
        <c:axId val="93877760"/>
      </c:lineChart>
      <c:catAx>
        <c:axId val="93876224"/>
        <c:scaling>
          <c:orientation val="minMax"/>
        </c:scaling>
        <c:delete val="1"/>
        <c:axPos val="b"/>
        <c:majorTickMark val="out"/>
        <c:minorTickMark val="none"/>
        <c:tickLblPos val="nextTo"/>
        <c:crossAx val="93877760"/>
        <c:crosses val="autoZero"/>
        <c:auto val="1"/>
        <c:lblAlgn val="ctr"/>
        <c:lblOffset val="100"/>
        <c:noMultiLvlLbl val="0"/>
      </c:catAx>
      <c:valAx>
        <c:axId val="93877760"/>
        <c:scaling>
          <c:orientation val="minMax"/>
          <c:max val="1"/>
          <c:min val="0.2"/>
        </c:scaling>
        <c:delete val="0"/>
        <c:axPos val="l"/>
        <c:majorGridlines>
          <c:spPr>
            <a:ln>
              <a:noFill/>
            </a:ln>
          </c:spPr>
        </c:majorGridlines>
        <c:numFmt formatCode="0%" sourceLinked="1"/>
        <c:majorTickMark val="out"/>
        <c:minorTickMark val="none"/>
        <c:tickLblPos val="nextTo"/>
        <c:crossAx val="938762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114675334553573"/>
          <c:y val="2.3476608752884133E-2"/>
          <c:w val="0.20336154855643043"/>
          <c:h val="8.3717191601049873E-2"/>
        </c:manualLayout>
      </c:layout>
      <c:overlay val="0"/>
      <c:txPr>
        <a:bodyPr/>
        <a:lstStyle/>
        <a:p>
          <a:pPr>
            <a:defRPr i="1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97688732783819"/>
          <c:y val="4.4203547346377429E-2"/>
          <c:w val="0.84328422034394468"/>
          <c:h val="0.83984211058715663"/>
        </c:manualLayout>
      </c:layout>
      <c:lineChart>
        <c:grouping val="standard"/>
        <c:varyColors val="0"/>
        <c:ser>
          <c:idx val="0"/>
          <c:order val="0"/>
          <c:tx>
            <c:v>B. juncea</c:v>
          </c:tx>
          <c:spPr>
            <a:ln>
              <a:solidFill>
                <a:srgbClr val="00B050"/>
              </a:solidFill>
            </a:ln>
          </c:spPr>
          <c:marker>
            <c:symbol val="none"/>
          </c:marker>
          <c:val>
            <c:numRef>
              <c:f>'B alleles'!$E$2:$E$57</c:f>
              <c:numCache>
                <c:formatCode>0%</c:formatCode>
                <c:ptCount val="56"/>
                <c:pt idx="0">
                  <c:v>0.52112676056338025</c:v>
                </c:pt>
                <c:pt idx="1">
                  <c:v>0.46478873239436619</c:v>
                </c:pt>
                <c:pt idx="2">
                  <c:v>0.36619718309859162</c:v>
                </c:pt>
                <c:pt idx="3">
                  <c:v>0.53521126760563376</c:v>
                </c:pt>
                <c:pt idx="5">
                  <c:v>0.49230769230769234</c:v>
                </c:pt>
                <c:pt idx="6">
                  <c:v>0.50724637681159424</c:v>
                </c:pt>
                <c:pt idx="7">
                  <c:v>0.53623188405797106</c:v>
                </c:pt>
                <c:pt idx="8">
                  <c:v>0.53731343283582089</c:v>
                </c:pt>
                <c:pt idx="9">
                  <c:v>0.53521126760563376</c:v>
                </c:pt>
                <c:pt idx="10">
                  <c:v>0.52112676056338025</c:v>
                </c:pt>
                <c:pt idx="12">
                  <c:v>0.92957746478873238</c:v>
                </c:pt>
                <c:pt idx="13">
                  <c:v>0.92753623188405798</c:v>
                </c:pt>
                <c:pt idx="14">
                  <c:v>0.92957746478873238</c:v>
                </c:pt>
                <c:pt idx="15">
                  <c:v>0.92647058823529416</c:v>
                </c:pt>
                <c:pt idx="16">
                  <c:v>0.91549295774647887</c:v>
                </c:pt>
                <c:pt idx="17">
                  <c:v>0.94202898550724645</c:v>
                </c:pt>
                <c:pt idx="19">
                  <c:v>0.62318840579710144</c:v>
                </c:pt>
                <c:pt idx="20">
                  <c:v>0.61428571428571432</c:v>
                </c:pt>
                <c:pt idx="21">
                  <c:v>0.47887323943661969</c:v>
                </c:pt>
                <c:pt idx="22">
                  <c:v>0.40845070422535218</c:v>
                </c:pt>
                <c:pt idx="23">
                  <c:v>0.41428571428571431</c:v>
                </c:pt>
                <c:pt idx="24">
                  <c:v>0.47540983606557374</c:v>
                </c:pt>
                <c:pt idx="25">
                  <c:v>0.42028985507246375</c:v>
                </c:pt>
                <c:pt idx="27">
                  <c:v>0.61971830985915488</c:v>
                </c:pt>
                <c:pt idx="28">
                  <c:v>0.62857142857142856</c:v>
                </c:pt>
                <c:pt idx="29">
                  <c:v>0.54285714285714282</c:v>
                </c:pt>
                <c:pt idx="30">
                  <c:v>0.52112676056338025</c:v>
                </c:pt>
                <c:pt idx="31">
                  <c:v>0.52112676056338025</c:v>
                </c:pt>
                <c:pt idx="32">
                  <c:v>0.52173913043478259</c:v>
                </c:pt>
                <c:pt idx="33">
                  <c:v>0.45070422535211274</c:v>
                </c:pt>
                <c:pt idx="35">
                  <c:v>0.4642857142857143</c:v>
                </c:pt>
                <c:pt idx="36">
                  <c:v>0.46376811594202899</c:v>
                </c:pt>
                <c:pt idx="37">
                  <c:v>0.49295774647887325</c:v>
                </c:pt>
                <c:pt idx="38">
                  <c:v>0.53521126760563376</c:v>
                </c:pt>
                <c:pt idx="39">
                  <c:v>0.53333333333333333</c:v>
                </c:pt>
                <c:pt idx="40">
                  <c:v>0.56338028169014087</c:v>
                </c:pt>
                <c:pt idx="41">
                  <c:v>0.42028985507246375</c:v>
                </c:pt>
                <c:pt idx="42">
                  <c:v>0.52112676056338025</c:v>
                </c:pt>
                <c:pt idx="44">
                  <c:v>0.34328358208955223</c:v>
                </c:pt>
                <c:pt idx="45">
                  <c:v>0.25352112676056338</c:v>
                </c:pt>
                <c:pt idx="46">
                  <c:v>0.23943661971830985</c:v>
                </c:pt>
                <c:pt idx="47">
                  <c:v>0.27536231884057971</c:v>
                </c:pt>
                <c:pt idx="48">
                  <c:v>0.22058823529411764</c:v>
                </c:pt>
                <c:pt idx="50">
                  <c:v>0.54838709677419351</c:v>
                </c:pt>
                <c:pt idx="51">
                  <c:v>0.50704225352112675</c:v>
                </c:pt>
                <c:pt idx="52">
                  <c:v>0.49295774647887325</c:v>
                </c:pt>
                <c:pt idx="53">
                  <c:v>0.5</c:v>
                </c:pt>
                <c:pt idx="54">
                  <c:v>0.48333333333333334</c:v>
                </c:pt>
                <c:pt idx="55">
                  <c:v>0.437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3901952"/>
        <c:axId val="93903488"/>
      </c:lineChart>
      <c:catAx>
        <c:axId val="93901952"/>
        <c:scaling>
          <c:orientation val="minMax"/>
        </c:scaling>
        <c:delete val="1"/>
        <c:axPos val="b"/>
        <c:majorTickMark val="out"/>
        <c:minorTickMark val="none"/>
        <c:tickLblPos val="nextTo"/>
        <c:crossAx val="93903488"/>
        <c:crosses val="autoZero"/>
        <c:auto val="1"/>
        <c:lblAlgn val="ctr"/>
        <c:lblOffset val="100"/>
        <c:noMultiLvlLbl val="0"/>
      </c:catAx>
      <c:valAx>
        <c:axId val="93903488"/>
        <c:scaling>
          <c:orientation val="minMax"/>
          <c:min val="0.2"/>
        </c:scaling>
        <c:delete val="0"/>
        <c:axPos val="l"/>
        <c:majorGridlines>
          <c:spPr>
            <a:ln>
              <a:noFill/>
            </a:ln>
          </c:spPr>
        </c:majorGridlines>
        <c:numFmt formatCode="0%" sourceLinked="1"/>
        <c:majorTickMark val="out"/>
        <c:minorTickMark val="none"/>
        <c:tickLblPos val="nextTo"/>
        <c:crossAx val="939019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9.6874453193350821E-2"/>
          <c:y val="1.8326407115777207E-2"/>
          <c:w val="0.18645888013998252"/>
          <c:h val="8.3717191601049873E-2"/>
        </c:manualLayout>
      </c:layout>
      <c:overlay val="0"/>
      <c:txPr>
        <a:bodyPr/>
        <a:lstStyle/>
        <a:p>
          <a:pPr>
            <a:defRPr i="1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4008843537414969E-2"/>
          <c:y val="4.6752688172043019E-2"/>
          <c:w val="0.80558560090702958"/>
          <c:h val="0.91028793309438472"/>
        </c:manualLayout>
      </c:layout>
      <c:lineChart>
        <c:grouping val="standard"/>
        <c:varyColors val="0"/>
        <c:ser>
          <c:idx val="2"/>
          <c:order val="0"/>
          <c:tx>
            <c:v>B. napus</c:v>
          </c:tx>
          <c:spPr>
            <a:ln w="25400">
              <a:solidFill>
                <a:srgbClr val="FFC000"/>
              </a:solidFill>
            </a:ln>
          </c:spPr>
          <c:marker>
            <c:symbol val="none"/>
          </c:marker>
          <c:val>
            <c:numRef>
              <c:f>'C genome no fixies'!$B$2:$B$319</c:f>
              <c:numCache>
                <c:formatCode>0%</c:formatCode>
                <c:ptCount val="318"/>
                <c:pt idx="0">
                  <c:v>0.40845070422535212</c:v>
                </c:pt>
                <c:pt idx="1">
                  <c:v>0.42253521126760563</c:v>
                </c:pt>
                <c:pt idx="2">
                  <c:v>0.47887323943661969</c:v>
                </c:pt>
                <c:pt idx="3">
                  <c:v>0.50704225352112675</c:v>
                </c:pt>
                <c:pt idx="4">
                  <c:v>0.52112676056338025</c:v>
                </c:pt>
                <c:pt idx="5">
                  <c:v>0.50704225352112675</c:v>
                </c:pt>
                <c:pt idx="6">
                  <c:v>0.49295774647887325</c:v>
                </c:pt>
                <c:pt idx="7">
                  <c:v>0.46478873239436619</c:v>
                </c:pt>
                <c:pt idx="8">
                  <c:v>0.45070422535211269</c:v>
                </c:pt>
                <c:pt idx="9">
                  <c:v>0.46478873239436619</c:v>
                </c:pt>
                <c:pt idx="10">
                  <c:v>0.46478873239436619</c:v>
                </c:pt>
                <c:pt idx="11">
                  <c:v>0.45070422535211269</c:v>
                </c:pt>
                <c:pt idx="12">
                  <c:v>0.46478873239436619</c:v>
                </c:pt>
                <c:pt idx="13">
                  <c:v>0.43661971830985913</c:v>
                </c:pt>
                <c:pt idx="14">
                  <c:v>0.42253521126760563</c:v>
                </c:pt>
                <c:pt idx="15">
                  <c:v>0.39436619718309857</c:v>
                </c:pt>
                <c:pt idx="16">
                  <c:v>0.39436619718309857</c:v>
                </c:pt>
                <c:pt idx="17">
                  <c:v>0.38028169014084506</c:v>
                </c:pt>
                <c:pt idx="18">
                  <c:v>0.352112676056338</c:v>
                </c:pt>
                <c:pt idx="19">
                  <c:v>0.36619718309859156</c:v>
                </c:pt>
                <c:pt idx="20">
                  <c:v>0.36619718309859156</c:v>
                </c:pt>
                <c:pt idx="21">
                  <c:v>0.352112676056338</c:v>
                </c:pt>
                <c:pt idx="22">
                  <c:v>0.3380281690140845</c:v>
                </c:pt>
                <c:pt idx="23">
                  <c:v>0.323943661971831</c:v>
                </c:pt>
                <c:pt idx="24">
                  <c:v>0.323943661971831</c:v>
                </c:pt>
                <c:pt idx="25">
                  <c:v>0.3380281690140845</c:v>
                </c:pt>
                <c:pt idx="26">
                  <c:v>0.647887323943662</c:v>
                </c:pt>
                <c:pt idx="27">
                  <c:v>0.6619718309859155</c:v>
                </c:pt>
                <c:pt idx="28">
                  <c:v>0.6619718309859155</c:v>
                </c:pt>
                <c:pt idx="29">
                  <c:v>0.647887323943662</c:v>
                </c:pt>
                <c:pt idx="30">
                  <c:v>0.6619718309859155</c:v>
                </c:pt>
                <c:pt idx="31">
                  <c:v>0.647887323943662</c:v>
                </c:pt>
                <c:pt idx="32">
                  <c:v>0.61971830985915488</c:v>
                </c:pt>
                <c:pt idx="33">
                  <c:v>0.63380281690140849</c:v>
                </c:pt>
                <c:pt idx="34">
                  <c:v>0.647887323943662</c:v>
                </c:pt>
                <c:pt idx="35">
                  <c:v>0.63380281690140849</c:v>
                </c:pt>
                <c:pt idx="36">
                  <c:v>0.63380281690140849</c:v>
                </c:pt>
                <c:pt idx="37">
                  <c:v>0.61971830985915488</c:v>
                </c:pt>
                <c:pt idx="39">
                  <c:v>0.43661971830985913</c:v>
                </c:pt>
                <c:pt idx="40">
                  <c:v>0.50704225352112675</c:v>
                </c:pt>
                <c:pt idx="41">
                  <c:v>0.49295774647887325</c:v>
                </c:pt>
                <c:pt idx="42">
                  <c:v>0.49295774647887325</c:v>
                </c:pt>
                <c:pt idx="43">
                  <c:v>0.47887323943661969</c:v>
                </c:pt>
                <c:pt idx="44">
                  <c:v>0.46478873239436619</c:v>
                </c:pt>
                <c:pt idx="45">
                  <c:v>0.45070422535211269</c:v>
                </c:pt>
                <c:pt idx="46">
                  <c:v>0.43661971830985913</c:v>
                </c:pt>
                <c:pt idx="47">
                  <c:v>0.43661971830985913</c:v>
                </c:pt>
                <c:pt idx="48">
                  <c:v>0.45070422535211269</c:v>
                </c:pt>
                <c:pt idx="49">
                  <c:v>0.46478873239436619</c:v>
                </c:pt>
                <c:pt idx="50">
                  <c:v>0.47887323943661969</c:v>
                </c:pt>
                <c:pt idx="51">
                  <c:v>0.47887323943661969</c:v>
                </c:pt>
                <c:pt idx="52">
                  <c:v>0.48571428571428571</c:v>
                </c:pt>
                <c:pt idx="53">
                  <c:v>0.47887323943661969</c:v>
                </c:pt>
                <c:pt idx="54">
                  <c:v>0.49295774647887325</c:v>
                </c:pt>
                <c:pt idx="55">
                  <c:v>0.50704225352112675</c:v>
                </c:pt>
                <c:pt idx="56">
                  <c:v>0.52112676056338025</c:v>
                </c:pt>
                <c:pt idx="57">
                  <c:v>0.53521126760563376</c:v>
                </c:pt>
                <c:pt idx="58">
                  <c:v>0.52112676056338025</c:v>
                </c:pt>
                <c:pt idx="59">
                  <c:v>0.52112676056338025</c:v>
                </c:pt>
                <c:pt idx="60">
                  <c:v>0.52112676056338025</c:v>
                </c:pt>
                <c:pt idx="61">
                  <c:v>0.50704225352112675</c:v>
                </c:pt>
                <c:pt idx="66">
                  <c:v>0.42253521126760563</c:v>
                </c:pt>
                <c:pt idx="67">
                  <c:v>0.61971830985915488</c:v>
                </c:pt>
                <c:pt idx="68">
                  <c:v>0.60563380281690138</c:v>
                </c:pt>
                <c:pt idx="69">
                  <c:v>0.59154929577464788</c:v>
                </c:pt>
                <c:pt idx="70">
                  <c:v>0.60563380281690138</c:v>
                </c:pt>
                <c:pt idx="71">
                  <c:v>0.61971830985915488</c:v>
                </c:pt>
                <c:pt idx="72">
                  <c:v>0.60563380281690138</c:v>
                </c:pt>
                <c:pt idx="73">
                  <c:v>0.59154929577464788</c:v>
                </c:pt>
                <c:pt idx="74">
                  <c:v>0.57746478873239437</c:v>
                </c:pt>
                <c:pt idx="75">
                  <c:v>0.39436619718309857</c:v>
                </c:pt>
                <c:pt idx="76">
                  <c:v>0.40845070422535212</c:v>
                </c:pt>
                <c:pt idx="77">
                  <c:v>0.39436619718309857</c:v>
                </c:pt>
                <c:pt idx="78">
                  <c:v>0.39436619718309857</c:v>
                </c:pt>
                <c:pt idx="79">
                  <c:v>0.38028169014084506</c:v>
                </c:pt>
                <c:pt idx="80">
                  <c:v>0.43661971830985913</c:v>
                </c:pt>
                <c:pt idx="81">
                  <c:v>0.59420289855072461</c:v>
                </c:pt>
                <c:pt idx="82">
                  <c:v>0.54929577464788737</c:v>
                </c:pt>
                <c:pt idx="83">
                  <c:v>0.53521126760563376</c:v>
                </c:pt>
                <c:pt idx="84">
                  <c:v>0.52112676056338025</c:v>
                </c:pt>
                <c:pt idx="85">
                  <c:v>0.50704225352112675</c:v>
                </c:pt>
                <c:pt idx="86">
                  <c:v>0.49295774647887325</c:v>
                </c:pt>
                <c:pt idx="87">
                  <c:v>0.47887323943661969</c:v>
                </c:pt>
                <c:pt idx="88">
                  <c:v>0.49295774647887325</c:v>
                </c:pt>
                <c:pt idx="89">
                  <c:v>0.47887323943661969</c:v>
                </c:pt>
                <c:pt idx="90">
                  <c:v>0.46478873239436619</c:v>
                </c:pt>
                <c:pt idx="91">
                  <c:v>0.54929577464788737</c:v>
                </c:pt>
                <c:pt idx="92">
                  <c:v>0.54929577464788737</c:v>
                </c:pt>
                <c:pt idx="93">
                  <c:v>0.53521126760563376</c:v>
                </c:pt>
                <c:pt idx="94">
                  <c:v>0.54929577464788737</c:v>
                </c:pt>
                <c:pt idx="95">
                  <c:v>0.53521126760563376</c:v>
                </c:pt>
                <c:pt idx="96">
                  <c:v>0.50704225352112675</c:v>
                </c:pt>
                <c:pt idx="97">
                  <c:v>0.50704225352112675</c:v>
                </c:pt>
                <c:pt idx="98">
                  <c:v>0.50704225352112675</c:v>
                </c:pt>
                <c:pt idx="99">
                  <c:v>0.49295774647887325</c:v>
                </c:pt>
                <c:pt idx="100">
                  <c:v>0.47887323943661969</c:v>
                </c:pt>
                <c:pt idx="101">
                  <c:v>0.45070422535211269</c:v>
                </c:pt>
                <c:pt idx="102">
                  <c:v>0.45070422535211269</c:v>
                </c:pt>
                <c:pt idx="103">
                  <c:v>0.43661971830985913</c:v>
                </c:pt>
                <c:pt idx="104">
                  <c:v>0.42253521126760563</c:v>
                </c:pt>
                <c:pt idx="105">
                  <c:v>0.40845070422535212</c:v>
                </c:pt>
                <c:pt idx="106">
                  <c:v>0.38028169014084506</c:v>
                </c:pt>
                <c:pt idx="107">
                  <c:v>0.36619718309859156</c:v>
                </c:pt>
                <c:pt idx="109">
                  <c:v>0.49295774647887325</c:v>
                </c:pt>
                <c:pt idx="110">
                  <c:v>0.56338028169014087</c:v>
                </c:pt>
                <c:pt idx="111">
                  <c:v>0.56338028169014087</c:v>
                </c:pt>
                <c:pt idx="112">
                  <c:v>0.57746478873239437</c:v>
                </c:pt>
                <c:pt idx="113">
                  <c:v>0.56338028169014087</c:v>
                </c:pt>
                <c:pt idx="114">
                  <c:v>0.54929577464788737</c:v>
                </c:pt>
                <c:pt idx="115">
                  <c:v>0.55714285714285716</c:v>
                </c:pt>
                <c:pt idx="116">
                  <c:v>0.56338028169014087</c:v>
                </c:pt>
                <c:pt idx="117">
                  <c:v>0.54929577464788737</c:v>
                </c:pt>
                <c:pt idx="118">
                  <c:v>0.53521126760563376</c:v>
                </c:pt>
                <c:pt idx="119">
                  <c:v>0.54929577464788737</c:v>
                </c:pt>
                <c:pt idx="120">
                  <c:v>0.56338028169014087</c:v>
                </c:pt>
                <c:pt idx="121">
                  <c:v>0.76056338028169013</c:v>
                </c:pt>
                <c:pt idx="122">
                  <c:v>0.78873239436619713</c:v>
                </c:pt>
                <c:pt idx="126">
                  <c:v>0.27142857142857141</c:v>
                </c:pt>
                <c:pt idx="127">
                  <c:v>0.29577464788732394</c:v>
                </c:pt>
                <c:pt idx="128">
                  <c:v>0.28169014084507044</c:v>
                </c:pt>
                <c:pt idx="129">
                  <c:v>0.77464788732394363</c:v>
                </c:pt>
                <c:pt idx="130">
                  <c:v>0.76056338028169013</c:v>
                </c:pt>
                <c:pt idx="131">
                  <c:v>0.77464788732394363</c:v>
                </c:pt>
                <c:pt idx="132">
                  <c:v>0.76056338028169013</c:v>
                </c:pt>
                <c:pt idx="133">
                  <c:v>0.74647887323943662</c:v>
                </c:pt>
                <c:pt idx="134">
                  <c:v>0.76056338028169013</c:v>
                </c:pt>
                <c:pt idx="135">
                  <c:v>0.74647887323943662</c:v>
                </c:pt>
                <c:pt idx="136">
                  <c:v>0.71830985915492962</c:v>
                </c:pt>
                <c:pt idx="137">
                  <c:v>0.6901408450704225</c:v>
                </c:pt>
                <c:pt idx="138">
                  <c:v>0.647887323943662</c:v>
                </c:pt>
                <c:pt idx="139">
                  <c:v>0.54929577464788737</c:v>
                </c:pt>
                <c:pt idx="140">
                  <c:v>0.53521126760563376</c:v>
                </c:pt>
                <c:pt idx="141">
                  <c:v>0.54929577464788737</c:v>
                </c:pt>
                <c:pt idx="142">
                  <c:v>0.46478873239436619</c:v>
                </c:pt>
                <c:pt idx="143">
                  <c:v>0.49295774647887325</c:v>
                </c:pt>
                <c:pt idx="144">
                  <c:v>0.47887323943661969</c:v>
                </c:pt>
                <c:pt idx="145">
                  <c:v>0.49295774647887325</c:v>
                </c:pt>
                <c:pt idx="146">
                  <c:v>0.46478873239436619</c:v>
                </c:pt>
                <c:pt idx="147">
                  <c:v>0.56338028169014087</c:v>
                </c:pt>
                <c:pt idx="148">
                  <c:v>0.54929577464788737</c:v>
                </c:pt>
                <c:pt idx="149">
                  <c:v>0.49295774647887325</c:v>
                </c:pt>
                <c:pt idx="150">
                  <c:v>0.47887323943661969</c:v>
                </c:pt>
                <c:pt idx="151">
                  <c:v>0.45070422535211269</c:v>
                </c:pt>
                <c:pt idx="152">
                  <c:v>0.46478873239436619</c:v>
                </c:pt>
                <c:pt idx="153">
                  <c:v>0.49295774647887325</c:v>
                </c:pt>
                <c:pt idx="154">
                  <c:v>0.47887323943661969</c:v>
                </c:pt>
                <c:pt idx="155">
                  <c:v>0.49295774647887325</c:v>
                </c:pt>
                <c:pt idx="156">
                  <c:v>0.50704225352112675</c:v>
                </c:pt>
                <c:pt idx="158">
                  <c:v>0.42253521126760563</c:v>
                </c:pt>
                <c:pt idx="159">
                  <c:v>0.43661971830985913</c:v>
                </c:pt>
                <c:pt idx="160">
                  <c:v>0.42253521126760563</c:v>
                </c:pt>
                <c:pt idx="161">
                  <c:v>0.43661971830985913</c:v>
                </c:pt>
                <c:pt idx="162">
                  <c:v>0.45070422535211269</c:v>
                </c:pt>
                <c:pt idx="163">
                  <c:v>0.43661971830985913</c:v>
                </c:pt>
                <c:pt idx="164">
                  <c:v>0.45070422535211269</c:v>
                </c:pt>
                <c:pt idx="165">
                  <c:v>0.44285714285714284</c:v>
                </c:pt>
                <c:pt idx="166">
                  <c:v>0.43661971830985913</c:v>
                </c:pt>
                <c:pt idx="167">
                  <c:v>0.46478873239436619</c:v>
                </c:pt>
                <c:pt idx="168">
                  <c:v>0.49295774647887325</c:v>
                </c:pt>
                <c:pt idx="169">
                  <c:v>0.47887323943661969</c:v>
                </c:pt>
                <c:pt idx="170">
                  <c:v>0.50704225352112675</c:v>
                </c:pt>
                <c:pt idx="171">
                  <c:v>0.49295774647887325</c:v>
                </c:pt>
                <c:pt idx="172">
                  <c:v>0.49295774647887325</c:v>
                </c:pt>
                <c:pt idx="173">
                  <c:v>0.50704225352112675</c:v>
                </c:pt>
                <c:pt idx="174">
                  <c:v>0.50704225352112675</c:v>
                </c:pt>
                <c:pt idx="175">
                  <c:v>0.52112676056338025</c:v>
                </c:pt>
                <c:pt idx="176">
                  <c:v>0.52112676056338025</c:v>
                </c:pt>
                <c:pt idx="177">
                  <c:v>0.53521126760563376</c:v>
                </c:pt>
                <c:pt idx="178">
                  <c:v>0.54929577464788737</c:v>
                </c:pt>
                <c:pt idx="179">
                  <c:v>0.53521126760563376</c:v>
                </c:pt>
                <c:pt idx="180">
                  <c:v>0.54929577464788737</c:v>
                </c:pt>
                <c:pt idx="181">
                  <c:v>0.52112676056338025</c:v>
                </c:pt>
                <c:pt idx="182">
                  <c:v>0.61971830985915488</c:v>
                </c:pt>
                <c:pt idx="183">
                  <c:v>0.63380281690140849</c:v>
                </c:pt>
                <c:pt idx="184">
                  <c:v>0.59154929577464788</c:v>
                </c:pt>
                <c:pt idx="185">
                  <c:v>0.60563380281690138</c:v>
                </c:pt>
                <c:pt idx="186">
                  <c:v>0.5714285714285714</c:v>
                </c:pt>
                <c:pt idx="187">
                  <c:v>0.56338028169014087</c:v>
                </c:pt>
                <c:pt idx="188">
                  <c:v>0.57746478873239437</c:v>
                </c:pt>
                <c:pt idx="189">
                  <c:v>0.56338028169014087</c:v>
                </c:pt>
                <c:pt idx="190">
                  <c:v>0.54929577464788737</c:v>
                </c:pt>
                <c:pt idx="191">
                  <c:v>0.53521126760563376</c:v>
                </c:pt>
                <c:pt idx="192">
                  <c:v>0.53521126760563376</c:v>
                </c:pt>
                <c:pt idx="193">
                  <c:v>0.52112676056338025</c:v>
                </c:pt>
                <c:pt idx="194">
                  <c:v>0.53521126760563376</c:v>
                </c:pt>
                <c:pt idx="195">
                  <c:v>0.52112676056338025</c:v>
                </c:pt>
                <c:pt idx="196">
                  <c:v>0.50704225352112675</c:v>
                </c:pt>
                <c:pt idx="197">
                  <c:v>0.52112676056338025</c:v>
                </c:pt>
                <c:pt idx="199">
                  <c:v>0.59154929577464788</c:v>
                </c:pt>
                <c:pt idx="200">
                  <c:v>0.57746478873239437</c:v>
                </c:pt>
                <c:pt idx="201">
                  <c:v>0.57746478873239437</c:v>
                </c:pt>
                <c:pt idx="202">
                  <c:v>0.56338028169014087</c:v>
                </c:pt>
                <c:pt idx="203">
                  <c:v>0.57746478873239437</c:v>
                </c:pt>
                <c:pt idx="204">
                  <c:v>0.56338028169014087</c:v>
                </c:pt>
                <c:pt idx="205">
                  <c:v>0.57746478873239437</c:v>
                </c:pt>
                <c:pt idx="206">
                  <c:v>0.59154929577464788</c:v>
                </c:pt>
                <c:pt idx="207">
                  <c:v>0.57746478873239437</c:v>
                </c:pt>
                <c:pt idx="208">
                  <c:v>0.56338028169014087</c:v>
                </c:pt>
                <c:pt idx="209">
                  <c:v>0.53521126760563376</c:v>
                </c:pt>
                <c:pt idx="210">
                  <c:v>0.54929577464788737</c:v>
                </c:pt>
                <c:pt idx="211">
                  <c:v>0.53521126760563376</c:v>
                </c:pt>
                <c:pt idx="212">
                  <c:v>0.52112676056338025</c:v>
                </c:pt>
                <c:pt idx="213">
                  <c:v>0.43661971830985913</c:v>
                </c:pt>
                <c:pt idx="214">
                  <c:v>0.45070422535211269</c:v>
                </c:pt>
                <c:pt idx="215">
                  <c:v>0.38028169014084506</c:v>
                </c:pt>
                <c:pt idx="216">
                  <c:v>0.38028169014084506</c:v>
                </c:pt>
                <c:pt idx="217">
                  <c:v>0.38028169014084506</c:v>
                </c:pt>
                <c:pt idx="218">
                  <c:v>0.39436619718309857</c:v>
                </c:pt>
                <c:pt idx="219">
                  <c:v>0.39436619718309857</c:v>
                </c:pt>
                <c:pt idx="220">
                  <c:v>0.39436619718309857</c:v>
                </c:pt>
                <c:pt idx="221">
                  <c:v>0.63380281690140849</c:v>
                </c:pt>
                <c:pt idx="222">
                  <c:v>0.647887323943662</c:v>
                </c:pt>
                <c:pt idx="223">
                  <c:v>0.63380281690140849</c:v>
                </c:pt>
                <c:pt idx="224">
                  <c:v>0.6619718309859155</c:v>
                </c:pt>
                <c:pt idx="225">
                  <c:v>0.676056338028169</c:v>
                </c:pt>
                <c:pt idx="226">
                  <c:v>0.6619718309859155</c:v>
                </c:pt>
                <c:pt idx="227">
                  <c:v>0.647887323943662</c:v>
                </c:pt>
                <c:pt idx="228">
                  <c:v>0.63380281690140849</c:v>
                </c:pt>
                <c:pt idx="229">
                  <c:v>0.61971830985915488</c:v>
                </c:pt>
                <c:pt idx="230">
                  <c:v>0.63380281690140849</c:v>
                </c:pt>
                <c:pt idx="231">
                  <c:v>0.647887323943662</c:v>
                </c:pt>
                <c:pt idx="232">
                  <c:v>0.61971830985915488</c:v>
                </c:pt>
                <c:pt idx="233">
                  <c:v>0.60563380281690138</c:v>
                </c:pt>
                <c:pt idx="234">
                  <c:v>0.63380281690140849</c:v>
                </c:pt>
                <c:pt idx="235">
                  <c:v>0.647887323943662</c:v>
                </c:pt>
                <c:pt idx="236">
                  <c:v>0.63380281690140849</c:v>
                </c:pt>
                <c:pt idx="237">
                  <c:v>0.61971830985915488</c:v>
                </c:pt>
                <c:pt idx="238">
                  <c:v>0.61971830985915488</c:v>
                </c:pt>
                <c:pt idx="239">
                  <c:v>0.63380281690140849</c:v>
                </c:pt>
                <c:pt idx="240">
                  <c:v>0.63380281690140849</c:v>
                </c:pt>
                <c:pt idx="241">
                  <c:v>0.61971830985915488</c:v>
                </c:pt>
                <c:pt idx="242">
                  <c:v>0.60563380281690138</c:v>
                </c:pt>
                <c:pt idx="243">
                  <c:v>0.57746478873239437</c:v>
                </c:pt>
                <c:pt idx="244">
                  <c:v>0.59154929577464788</c:v>
                </c:pt>
                <c:pt idx="245">
                  <c:v>0.59154929577464788</c:v>
                </c:pt>
                <c:pt idx="246">
                  <c:v>0.57746478873239437</c:v>
                </c:pt>
                <c:pt idx="247">
                  <c:v>0.56338028169014087</c:v>
                </c:pt>
                <c:pt idx="248">
                  <c:v>0.54929577464788737</c:v>
                </c:pt>
                <c:pt idx="249">
                  <c:v>0.53521126760563376</c:v>
                </c:pt>
                <c:pt idx="250">
                  <c:v>0.54929577464788737</c:v>
                </c:pt>
                <c:pt idx="251">
                  <c:v>0.56338028169014087</c:v>
                </c:pt>
                <c:pt idx="252">
                  <c:v>0.54929577464788737</c:v>
                </c:pt>
                <c:pt idx="253">
                  <c:v>0.53521126760563376</c:v>
                </c:pt>
                <c:pt idx="254">
                  <c:v>0.52112676056338025</c:v>
                </c:pt>
                <c:pt idx="255">
                  <c:v>0.52112676056338025</c:v>
                </c:pt>
                <c:pt idx="257">
                  <c:v>0.54929577464788737</c:v>
                </c:pt>
                <c:pt idx="258">
                  <c:v>0.53521126760563376</c:v>
                </c:pt>
                <c:pt idx="259">
                  <c:v>0.54929577464788737</c:v>
                </c:pt>
                <c:pt idx="260">
                  <c:v>0.56338028169014087</c:v>
                </c:pt>
                <c:pt idx="261">
                  <c:v>0.54929577464788737</c:v>
                </c:pt>
                <c:pt idx="262">
                  <c:v>0.52112676056338025</c:v>
                </c:pt>
                <c:pt idx="263">
                  <c:v>0.54929577464788737</c:v>
                </c:pt>
                <c:pt idx="264">
                  <c:v>0.53521126760563376</c:v>
                </c:pt>
                <c:pt idx="265">
                  <c:v>0.54929577464788737</c:v>
                </c:pt>
                <c:pt idx="266">
                  <c:v>0.56338028169014087</c:v>
                </c:pt>
                <c:pt idx="267">
                  <c:v>0.52112676056338025</c:v>
                </c:pt>
                <c:pt idx="268">
                  <c:v>0.52112676056338025</c:v>
                </c:pt>
                <c:pt idx="269">
                  <c:v>0.52112676056338025</c:v>
                </c:pt>
                <c:pt idx="270">
                  <c:v>0.52112676056338025</c:v>
                </c:pt>
                <c:pt idx="271">
                  <c:v>0.47887323943661969</c:v>
                </c:pt>
                <c:pt idx="272">
                  <c:v>0.39436619718309857</c:v>
                </c:pt>
                <c:pt idx="273">
                  <c:v>0.40845070422535212</c:v>
                </c:pt>
                <c:pt idx="274">
                  <c:v>0.38028169014084506</c:v>
                </c:pt>
                <c:pt idx="275">
                  <c:v>0.39436619718309857</c:v>
                </c:pt>
                <c:pt idx="276">
                  <c:v>0.38028169014084506</c:v>
                </c:pt>
                <c:pt idx="277">
                  <c:v>0.38028169014084506</c:v>
                </c:pt>
                <c:pt idx="278">
                  <c:v>0.39436619718309857</c:v>
                </c:pt>
                <c:pt idx="279">
                  <c:v>0.60563380281690138</c:v>
                </c:pt>
                <c:pt idx="280">
                  <c:v>0.6</c:v>
                </c:pt>
                <c:pt idx="281">
                  <c:v>0.60563380281690138</c:v>
                </c:pt>
                <c:pt idx="282">
                  <c:v>0.59154929577464788</c:v>
                </c:pt>
                <c:pt idx="283">
                  <c:v>0.57746478873239437</c:v>
                </c:pt>
                <c:pt idx="284">
                  <c:v>0.59154929577464788</c:v>
                </c:pt>
                <c:pt idx="285">
                  <c:v>0.5714285714285714</c:v>
                </c:pt>
                <c:pt idx="287">
                  <c:v>0.46478873239436619</c:v>
                </c:pt>
                <c:pt idx="288">
                  <c:v>0.43661971830985913</c:v>
                </c:pt>
                <c:pt idx="289">
                  <c:v>0.45070422535211269</c:v>
                </c:pt>
                <c:pt idx="290">
                  <c:v>0.43661971830985913</c:v>
                </c:pt>
                <c:pt idx="291">
                  <c:v>0.42253521126760563</c:v>
                </c:pt>
                <c:pt idx="292">
                  <c:v>0.40845070422535212</c:v>
                </c:pt>
                <c:pt idx="293">
                  <c:v>0.43661971830985913</c:v>
                </c:pt>
                <c:pt idx="294">
                  <c:v>0.45070422535211269</c:v>
                </c:pt>
                <c:pt idx="295">
                  <c:v>0.47887323943661969</c:v>
                </c:pt>
                <c:pt idx="296">
                  <c:v>0.46478873239436619</c:v>
                </c:pt>
                <c:pt idx="297">
                  <c:v>0.47887323943661969</c:v>
                </c:pt>
                <c:pt idx="298">
                  <c:v>0.49295774647887325</c:v>
                </c:pt>
                <c:pt idx="299">
                  <c:v>0.47887323943661969</c:v>
                </c:pt>
                <c:pt idx="300">
                  <c:v>0.54929577464788737</c:v>
                </c:pt>
                <c:pt idx="301">
                  <c:v>0.52112676056338025</c:v>
                </c:pt>
                <c:pt idx="302">
                  <c:v>0.53521126760563376</c:v>
                </c:pt>
                <c:pt idx="303">
                  <c:v>0.52112676056338025</c:v>
                </c:pt>
                <c:pt idx="304">
                  <c:v>0.5</c:v>
                </c:pt>
                <c:pt idx="305">
                  <c:v>0.56338028169014087</c:v>
                </c:pt>
                <c:pt idx="306">
                  <c:v>0.57746478873239437</c:v>
                </c:pt>
                <c:pt idx="307">
                  <c:v>0.59154929577464788</c:v>
                </c:pt>
                <c:pt idx="308">
                  <c:v>0.56338028169014087</c:v>
                </c:pt>
                <c:pt idx="309">
                  <c:v>0.54929577464788737</c:v>
                </c:pt>
                <c:pt idx="310">
                  <c:v>0.56338028169014087</c:v>
                </c:pt>
                <c:pt idx="311">
                  <c:v>0.54929577464788737</c:v>
                </c:pt>
                <c:pt idx="312">
                  <c:v>0.53521126760563376</c:v>
                </c:pt>
                <c:pt idx="313">
                  <c:v>0.52112676056338025</c:v>
                </c:pt>
                <c:pt idx="314">
                  <c:v>0.50704225352112675</c:v>
                </c:pt>
                <c:pt idx="315">
                  <c:v>0.4929577464788732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3960832"/>
        <c:axId val="93966720"/>
      </c:lineChart>
      <c:catAx>
        <c:axId val="93960832"/>
        <c:scaling>
          <c:orientation val="minMax"/>
        </c:scaling>
        <c:delete val="1"/>
        <c:axPos val="b"/>
        <c:majorTickMark val="out"/>
        <c:minorTickMark val="none"/>
        <c:tickLblPos val="none"/>
        <c:crossAx val="93966720"/>
        <c:crosses val="autoZero"/>
        <c:auto val="1"/>
        <c:lblAlgn val="ctr"/>
        <c:lblOffset val="100"/>
        <c:noMultiLvlLbl val="0"/>
      </c:catAx>
      <c:valAx>
        <c:axId val="93966720"/>
        <c:scaling>
          <c:orientation val="minMax"/>
          <c:max val="0.8"/>
          <c:min val="0.2"/>
        </c:scaling>
        <c:delete val="0"/>
        <c:axPos val="l"/>
        <c:majorGridlines>
          <c:spPr>
            <a:ln>
              <a:noFill/>
            </a:ln>
          </c:spPr>
        </c:majorGridlines>
        <c:numFmt formatCode="0%" sourceLinked="1"/>
        <c:majorTickMark val="out"/>
        <c:minorTickMark val="none"/>
        <c:tickLblPos val="nextTo"/>
        <c:crossAx val="939608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1635657596371882"/>
          <c:y val="1.7125448028673836E-2"/>
          <c:w val="0.14122097505668935"/>
          <c:h val="6.2352747909199521E-2"/>
        </c:manualLayout>
      </c:layout>
      <c:overlay val="0"/>
      <c:txPr>
        <a:bodyPr/>
        <a:lstStyle/>
        <a:p>
          <a:pPr>
            <a:defRPr sz="1800" i="1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491213151927439E-2"/>
          <c:y val="4.2115292712066904E-2"/>
          <c:w val="0.80538775510204075"/>
          <c:h val="0.91576941457586625"/>
        </c:manualLayout>
      </c:layout>
      <c:lineChart>
        <c:grouping val="standard"/>
        <c:varyColors val="0"/>
        <c:ser>
          <c:idx val="3"/>
          <c:order val="0"/>
          <c:tx>
            <c:v>B. carinata</c:v>
          </c:tx>
          <c:spPr>
            <a:ln w="25400">
              <a:solidFill>
                <a:srgbClr val="C00000"/>
              </a:solidFill>
            </a:ln>
          </c:spPr>
          <c:marker>
            <c:symbol val="none"/>
          </c:marker>
          <c:val>
            <c:numRef>
              <c:f>'C genome no fixies'!$E$2:$E$317</c:f>
              <c:numCache>
                <c:formatCode>0%</c:formatCode>
                <c:ptCount val="316"/>
                <c:pt idx="0">
                  <c:v>0.54929577464788737</c:v>
                </c:pt>
                <c:pt idx="1">
                  <c:v>0.53521126760563376</c:v>
                </c:pt>
                <c:pt idx="2">
                  <c:v>0.49295774647887325</c:v>
                </c:pt>
                <c:pt idx="3">
                  <c:v>0.46478873239436619</c:v>
                </c:pt>
                <c:pt idx="4">
                  <c:v>0.45070422535211269</c:v>
                </c:pt>
                <c:pt idx="5">
                  <c:v>0.46478873239436619</c:v>
                </c:pt>
                <c:pt idx="6">
                  <c:v>0.47887323943661969</c:v>
                </c:pt>
                <c:pt idx="7">
                  <c:v>0.50704225352112675</c:v>
                </c:pt>
                <c:pt idx="8">
                  <c:v>0.52112676056338025</c:v>
                </c:pt>
                <c:pt idx="9">
                  <c:v>0.50704225352112675</c:v>
                </c:pt>
                <c:pt idx="10">
                  <c:v>0.50704225352112675</c:v>
                </c:pt>
                <c:pt idx="11">
                  <c:v>0.52112676056338025</c:v>
                </c:pt>
                <c:pt idx="12">
                  <c:v>0.49295774647887325</c:v>
                </c:pt>
                <c:pt idx="13">
                  <c:v>0.52112676056338025</c:v>
                </c:pt>
                <c:pt idx="14">
                  <c:v>0.54929577464788737</c:v>
                </c:pt>
                <c:pt idx="15">
                  <c:v>0.57746478873239437</c:v>
                </c:pt>
                <c:pt idx="16">
                  <c:v>0.57746478873239437</c:v>
                </c:pt>
                <c:pt idx="17">
                  <c:v>0.59154929577464788</c:v>
                </c:pt>
                <c:pt idx="18">
                  <c:v>0.60563380281690138</c:v>
                </c:pt>
                <c:pt idx="19">
                  <c:v>0.61971830985915488</c:v>
                </c:pt>
                <c:pt idx="20">
                  <c:v>0.59154929577464788</c:v>
                </c:pt>
                <c:pt idx="21">
                  <c:v>0.59154929577464788</c:v>
                </c:pt>
                <c:pt idx="22">
                  <c:v>0.60563380281690138</c:v>
                </c:pt>
                <c:pt idx="23">
                  <c:v>0.61971830985915488</c:v>
                </c:pt>
                <c:pt idx="24">
                  <c:v>0.63380281690140849</c:v>
                </c:pt>
                <c:pt idx="25">
                  <c:v>0.61971830985915488</c:v>
                </c:pt>
                <c:pt idx="26">
                  <c:v>0.63380281690140849</c:v>
                </c:pt>
                <c:pt idx="27">
                  <c:v>0.323943661971831</c:v>
                </c:pt>
                <c:pt idx="28">
                  <c:v>0.30985915492957744</c:v>
                </c:pt>
                <c:pt idx="29">
                  <c:v>0.29577464788732394</c:v>
                </c:pt>
                <c:pt idx="30">
                  <c:v>0.30985915492957744</c:v>
                </c:pt>
                <c:pt idx="31">
                  <c:v>0.28169014084507044</c:v>
                </c:pt>
                <c:pt idx="32">
                  <c:v>0.30985915492957744</c:v>
                </c:pt>
                <c:pt idx="33">
                  <c:v>0.29577464788732394</c:v>
                </c:pt>
                <c:pt idx="34">
                  <c:v>0.28169014084507044</c:v>
                </c:pt>
                <c:pt idx="35">
                  <c:v>0.323943661971831</c:v>
                </c:pt>
                <c:pt idx="36">
                  <c:v>0.323943661971831</c:v>
                </c:pt>
                <c:pt idx="37">
                  <c:v>0.3380281690140845</c:v>
                </c:pt>
                <c:pt idx="39">
                  <c:v>0.52112676056338025</c:v>
                </c:pt>
                <c:pt idx="40">
                  <c:v>0.42253521126760563</c:v>
                </c:pt>
                <c:pt idx="41">
                  <c:v>0.42253521126760563</c:v>
                </c:pt>
                <c:pt idx="42">
                  <c:v>0.42253521126760563</c:v>
                </c:pt>
                <c:pt idx="43">
                  <c:v>0.43661971830985913</c:v>
                </c:pt>
                <c:pt idx="44">
                  <c:v>0.45070422535211269</c:v>
                </c:pt>
                <c:pt idx="45">
                  <c:v>0.46478873239436619</c:v>
                </c:pt>
                <c:pt idx="46">
                  <c:v>0.47887323943661969</c:v>
                </c:pt>
                <c:pt idx="47">
                  <c:v>0.49295774647887325</c:v>
                </c:pt>
                <c:pt idx="48">
                  <c:v>0.47887323943661969</c:v>
                </c:pt>
                <c:pt idx="49">
                  <c:v>0.49295774647887325</c:v>
                </c:pt>
                <c:pt idx="50">
                  <c:v>0.50704225352112675</c:v>
                </c:pt>
                <c:pt idx="51">
                  <c:v>0.49295774647887325</c:v>
                </c:pt>
                <c:pt idx="52">
                  <c:v>0.47887323943661969</c:v>
                </c:pt>
                <c:pt idx="53">
                  <c:v>0.46478873239436619</c:v>
                </c:pt>
                <c:pt idx="54">
                  <c:v>0.46478873239436619</c:v>
                </c:pt>
                <c:pt idx="55">
                  <c:v>0.45714285714285713</c:v>
                </c:pt>
                <c:pt idx="56">
                  <c:v>0.46478873239436619</c:v>
                </c:pt>
                <c:pt idx="57">
                  <c:v>0.45070422535211269</c:v>
                </c:pt>
                <c:pt idx="58">
                  <c:v>0.43661971830985913</c:v>
                </c:pt>
                <c:pt idx="59">
                  <c:v>0.46478873239436619</c:v>
                </c:pt>
                <c:pt idx="60">
                  <c:v>0.45070422535211269</c:v>
                </c:pt>
                <c:pt idx="61">
                  <c:v>0.46478873239436619</c:v>
                </c:pt>
                <c:pt idx="62">
                  <c:v>0.46478873239436619</c:v>
                </c:pt>
                <c:pt idx="63">
                  <c:v>0.47887323943661969</c:v>
                </c:pt>
                <c:pt idx="64">
                  <c:v>0.49295774647887325</c:v>
                </c:pt>
                <c:pt idx="66">
                  <c:v>0.60563380281690138</c:v>
                </c:pt>
                <c:pt idx="67">
                  <c:v>0.36619718309859156</c:v>
                </c:pt>
                <c:pt idx="68">
                  <c:v>0.39436619718309857</c:v>
                </c:pt>
                <c:pt idx="69">
                  <c:v>0.40845070422535212</c:v>
                </c:pt>
                <c:pt idx="70">
                  <c:v>0.39436619718309857</c:v>
                </c:pt>
                <c:pt idx="71">
                  <c:v>0.38028169014084506</c:v>
                </c:pt>
                <c:pt idx="72">
                  <c:v>0.39436619718309857</c:v>
                </c:pt>
                <c:pt idx="73">
                  <c:v>0.40845070422535212</c:v>
                </c:pt>
                <c:pt idx="74">
                  <c:v>0.42253521126760563</c:v>
                </c:pt>
                <c:pt idx="75">
                  <c:v>0.60563380281690138</c:v>
                </c:pt>
                <c:pt idx="76">
                  <c:v>0.61971830985915488</c:v>
                </c:pt>
                <c:pt idx="77">
                  <c:v>0.61971830985915488</c:v>
                </c:pt>
                <c:pt idx="78">
                  <c:v>0.63380281690140849</c:v>
                </c:pt>
                <c:pt idx="79">
                  <c:v>0.57746478873239437</c:v>
                </c:pt>
                <c:pt idx="80">
                  <c:v>0.43661971830985913</c:v>
                </c:pt>
                <c:pt idx="81">
                  <c:v>0.47887323943661969</c:v>
                </c:pt>
                <c:pt idx="82">
                  <c:v>0.49295774647887325</c:v>
                </c:pt>
                <c:pt idx="83">
                  <c:v>0.50704225352112675</c:v>
                </c:pt>
                <c:pt idx="84">
                  <c:v>0.52112676056338025</c:v>
                </c:pt>
                <c:pt idx="85">
                  <c:v>0.53521126760563376</c:v>
                </c:pt>
                <c:pt idx="86">
                  <c:v>0.52112676056338025</c:v>
                </c:pt>
                <c:pt idx="87">
                  <c:v>0.54929577464788737</c:v>
                </c:pt>
                <c:pt idx="88">
                  <c:v>0.54929577464788737</c:v>
                </c:pt>
                <c:pt idx="89">
                  <c:v>0.46478873239436619</c:v>
                </c:pt>
                <c:pt idx="90">
                  <c:v>0.46478873239436619</c:v>
                </c:pt>
                <c:pt idx="91">
                  <c:v>0.47887323943661969</c:v>
                </c:pt>
                <c:pt idx="92">
                  <c:v>0.46478873239436619</c:v>
                </c:pt>
                <c:pt idx="93">
                  <c:v>0.47887323943661969</c:v>
                </c:pt>
                <c:pt idx="94">
                  <c:v>0.50704225352112675</c:v>
                </c:pt>
                <c:pt idx="95">
                  <c:v>0.50704225352112675</c:v>
                </c:pt>
                <c:pt idx="96">
                  <c:v>0.50704225352112675</c:v>
                </c:pt>
                <c:pt idx="97">
                  <c:v>0.52112676056338025</c:v>
                </c:pt>
                <c:pt idx="98">
                  <c:v>0.53521126760563376</c:v>
                </c:pt>
                <c:pt idx="99">
                  <c:v>0.56338028169014087</c:v>
                </c:pt>
                <c:pt idx="100">
                  <c:v>0.56338028169014087</c:v>
                </c:pt>
                <c:pt idx="101">
                  <c:v>0.57746478873239437</c:v>
                </c:pt>
                <c:pt idx="102">
                  <c:v>0.59154929577464788</c:v>
                </c:pt>
                <c:pt idx="103">
                  <c:v>0.60563380281690138</c:v>
                </c:pt>
                <c:pt idx="104">
                  <c:v>0.63380281690140849</c:v>
                </c:pt>
                <c:pt idx="105">
                  <c:v>0.647887323943662</c:v>
                </c:pt>
                <c:pt idx="109">
                  <c:v>0.53521126760563376</c:v>
                </c:pt>
                <c:pt idx="110">
                  <c:v>0.45070422535211269</c:v>
                </c:pt>
                <c:pt idx="111">
                  <c:v>0.45070422535211269</c:v>
                </c:pt>
                <c:pt idx="112">
                  <c:v>0.43661971830985913</c:v>
                </c:pt>
                <c:pt idx="113">
                  <c:v>0.45070422535211269</c:v>
                </c:pt>
                <c:pt idx="114">
                  <c:v>0.45070422535211269</c:v>
                </c:pt>
                <c:pt idx="115">
                  <c:v>0.46478873239436619</c:v>
                </c:pt>
                <c:pt idx="116">
                  <c:v>0.45714285714285713</c:v>
                </c:pt>
                <c:pt idx="117">
                  <c:v>0.45070422535211269</c:v>
                </c:pt>
                <c:pt idx="118">
                  <c:v>0.45070422535211269</c:v>
                </c:pt>
                <c:pt idx="119">
                  <c:v>0.46478873239436619</c:v>
                </c:pt>
                <c:pt idx="120">
                  <c:v>0.45070422535211269</c:v>
                </c:pt>
                <c:pt idx="121">
                  <c:v>0.43661971830985913</c:v>
                </c:pt>
                <c:pt idx="122">
                  <c:v>0.54929577464788737</c:v>
                </c:pt>
                <c:pt idx="123">
                  <c:v>0.55714285714285716</c:v>
                </c:pt>
                <c:pt idx="124">
                  <c:v>0.52112676056338025</c:v>
                </c:pt>
                <c:pt idx="126">
                  <c:v>0.75714285714285712</c:v>
                </c:pt>
                <c:pt idx="127">
                  <c:v>0.74647887323943662</c:v>
                </c:pt>
                <c:pt idx="128">
                  <c:v>0.25352112676056338</c:v>
                </c:pt>
                <c:pt idx="129">
                  <c:v>0.26760563380281688</c:v>
                </c:pt>
                <c:pt idx="130">
                  <c:v>0.25352112676056338</c:v>
                </c:pt>
                <c:pt idx="131">
                  <c:v>0.26760563380281688</c:v>
                </c:pt>
                <c:pt idx="132">
                  <c:v>0.28169014084507044</c:v>
                </c:pt>
                <c:pt idx="133">
                  <c:v>0.26760563380281688</c:v>
                </c:pt>
                <c:pt idx="134">
                  <c:v>0.28169014084507044</c:v>
                </c:pt>
                <c:pt idx="135">
                  <c:v>0.30985915492957744</c:v>
                </c:pt>
                <c:pt idx="136">
                  <c:v>0.3380281690140845</c:v>
                </c:pt>
                <c:pt idx="137">
                  <c:v>0.38028169014084506</c:v>
                </c:pt>
                <c:pt idx="138">
                  <c:v>0.46478873239436619</c:v>
                </c:pt>
                <c:pt idx="139">
                  <c:v>0.47887323943661969</c:v>
                </c:pt>
                <c:pt idx="140">
                  <c:v>0.46478873239436619</c:v>
                </c:pt>
                <c:pt idx="141">
                  <c:v>0.54929577464788737</c:v>
                </c:pt>
                <c:pt idx="142">
                  <c:v>0.52112676056338025</c:v>
                </c:pt>
                <c:pt idx="143">
                  <c:v>0.53521126760563376</c:v>
                </c:pt>
                <c:pt idx="144">
                  <c:v>0.52112676056338025</c:v>
                </c:pt>
                <c:pt idx="145">
                  <c:v>0.54929577464788737</c:v>
                </c:pt>
                <c:pt idx="146">
                  <c:v>0.43661971830985913</c:v>
                </c:pt>
                <c:pt idx="147">
                  <c:v>0.45070422535211269</c:v>
                </c:pt>
                <c:pt idx="148">
                  <c:v>0.47887323943661969</c:v>
                </c:pt>
                <c:pt idx="149">
                  <c:v>0.49295774647887325</c:v>
                </c:pt>
                <c:pt idx="150">
                  <c:v>0.52112676056338025</c:v>
                </c:pt>
                <c:pt idx="151">
                  <c:v>0.50704225352112675</c:v>
                </c:pt>
                <c:pt idx="152">
                  <c:v>0.47887323943661969</c:v>
                </c:pt>
                <c:pt idx="153">
                  <c:v>0.49295774647887325</c:v>
                </c:pt>
                <c:pt idx="154">
                  <c:v>0.47887323943661969</c:v>
                </c:pt>
                <c:pt idx="155">
                  <c:v>0.47887323943661969</c:v>
                </c:pt>
                <c:pt idx="158">
                  <c:v>0.59154929577464788</c:v>
                </c:pt>
                <c:pt idx="159">
                  <c:v>0.57746478873239437</c:v>
                </c:pt>
                <c:pt idx="160">
                  <c:v>0.59154929577464788</c:v>
                </c:pt>
                <c:pt idx="161">
                  <c:v>0.57746478873239437</c:v>
                </c:pt>
                <c:pt idx="162">
                  <c:v>0.57746478873239437</c:v>
                </c:pt>
                <c:pt idx="163">
                  <c:v>0.59154929577464788</c:v>
                </c:pt>
                <c:pt idx="164">
                  <c:v>0.57746478873239437</c:v>
                </c:pt>
                <c:pt idx="165">
                  <c:v>0.58571428571428574</c:v>
                </c:pt>
                <c:pt idx="166">
                  <c:v>0.59154929577464788</c:v>
                </c:pt>
                <c:pt idx="167">
                  <c:v>0.57746478873239437</c:v>
                </c:pt>
                <c:pt idx="168">
                  <c:v>0.54929577464788737</c:v>
                </c:pt>
                <c:pt idx="169">
                  <c:v>0.56338028169014087</c:v>
                </c:pt>
                <c:pt idx="170">
                  <c:v>0.53521126760563376</c:v>
                </c:pt>
                <c:pt idx="171">
                  <c:v>0.54929577464788737</c:v>
                </c:pt>
                <c:pt idx="172">
                  <c:v>0.54929577464788737</c:v>
                </c:pt>
                <c:pt idx="173">
                  <c:v>0.53521126760563376</c:v>
                </c:pt>
                <c:pt idx="174">
                  <c:v>0.53521126760563376</c:v>
                </c:pt>
                <c:pt idx="175">
                  <c:v>0.52112676056338025</c:v>
                </c:pt>
                <c:pt idx="176">
                  <c:v>0.52112676056338025</c:v>
                </c:pt>
                <c:pt idx="177">
                  <c:v>0.50704225352112675</c:v>
                </c:pt>
                <c:pt idx="178">
                  <c:v>0.52112676056338025</c:v>
                </c:pt>
                <c:pt idx="179">
                  <c:v>0.50704225352112675</c:v>
                </c:pt>
                <c:pt idx="180">
                  <c:v>0.49295774647887325</c:v>
                </c:pt>
                <c:pt idx="181">
                  <c:v>0.50704225352112675</c:v>
                </c:pt>
                <c:pt idx="182">
                  <c:v>0.49295774647887325</c:v>
                </c:pt>
                <c:pt idx="183">
                  <c:v>0.52112676056338025</c:v>
                </c:pt>
                <c:pt idx="184">
                  <c:v>0.42253521126760563</c:v>
                </c:pt>
                <c:pt idx="185">
                  <c:v>0.40845070422535212</c:v>
                </c:pt>
                <c:pt idx="186">
                  <c:v>0.42253521126760563</c:v>
                </c:pt>
                <c:pt idx="187">
                  <c:v>0.45070422535211269</c:v>
                </c:pt>
                <c:pt idx="188">
                  <c:v>0.43661971830985913</c:v>
                </c:pt>
                <c:pt idx="189">
                  <c:v>0.45070422535211269</c:v>
                </c:pt>
                <c:pt idx="190">
                  <c:v>0.45070422535211269</c:v>
                </c:pt>
                <c:pt idx="191">
                  <c:v>0.45070422535211269</c:v>
                </c:pt>
                <c:pt idx="192">
                  <c:v>0.45070422535211269</c:v>
                </c:pt>
                <c:pt idx="193">
                  <c:v>0.43661971830985913</c:v>
                </c:pt>
                <c:pt idx="194">
                  <c:v>0.42253521126760563</c:v>
                </c:pt>
                <c:pt idx="195">
                  <c:v>0.37142857142857144</c:v>
                </c:pt>
                <c:pt idx="199">
                  <c:v>0.42253521126760563</c:v>
                </c:pt>
                <c:pt idx="200">
                  <c:v>0.43661971830985913</c:v>
                </c:pt>
                <c:pt idx="201">
                  <c:v>0.45070422535211269</c:v>
                </c:pt>
                <c:pt idx="202">
                  <c:v>0.46478873239436619</c:v>
                </c:pt>
                <c:pt idx="203">
                  <c:v>0.45070422535211269</c:v>
                </c:pt>
                <c:pt idx="204">
                  <c:v>0.46478873239436619</c:v>
                </c:pt>
                <c:pt idx="205">
                  <c:v>0.45070422535211269</c:v>
                </c:pt>
                <c:pt idx="206">
                  <c:v>0.43661971830985913</c:v>
                </c:pt>
                <c:pt idx="207">
                  <c:v>0.45070422535211269</c:v>
                </c:pt>
                <c:pt idx="208">
                  <c:v>0.43661971830985913</c:v>
                </c:pt>
                <c:pt idx="209">
                  <c:v>0.46478873239436619</c:v>
                </c:pt>
                <c:pt idx="210">
                  <c:v>0.45070422535211269</c:v>
                </c:pt>
                <c:pt idx="211">
                  <c:v>0.46478873239436619</c:v>
                </c:pt>
                <c:pt idx="212">
                  <c:v>0.47887323943661969</c:v>
                </c:pt>
                <c:pt idx="213">
                  <c:v>0.56338028169014087</c:v>
                </c:pt>
                <c:pt idx="214">
                  <c:v>0.54929577464788737</c:v>
                </c:pt>
                <c:pt idx="215">
                  <c:v>0.61971830985915488</c:v>
                </c:pt>
                <c:pt idx="216">
                  <c:v>0.61971830985915488</c:v>
                </c:pt>
                <c:pt idx="217">
                  <c:v>0.61971830985915488</c:v>
                </c:pt>
                <c:pt idx="218">
                  <c:v>0.60563380281690138</c:v>
                </c:pt>
                <c:pt idx="219">
                  <c:v>0.60563380281690138</c:v>
                </c:pt>
                <c:pt idx="220">
                  <c:v>0.60563380281690138</c:v>
                </c:pt>
                <c:pt idx="221">
                  <c:v>0.352112676056338</c:v>
                </c:pt>
                <c:pt idx="222">
                  <c:v>0.3380281690140845</c:v>
                </c:pt>
                <c:pt idx="223">
                  <c:v>0.352112676056338</c:v>
                </c:pt>
                <c:pt idx="224">
                  <c:v>0.323943661971831</c:v>
                </c:pt>
                <c:pt idx="225">
                  <c:v>0.30985915492957744</c:v>
                </c:pt>
                <c:pt idx="226">
                  <c:v>0.323943661971831</c:v>
                </c:pt>
                <c:pt idx="227">
                  <c:v>0.3380281690140845</c:v>
                </c:pt>
                <c:pt idx="228">
                  <c:v>0.352112676056338</c:v>
                </c:pt>
                <c:pt idx="229">
                  <c:v>0.36619718309859156</c:v>
                </c:pt>
                <c:pt idx="230">
                  <c:v>0.352112676056338</c:v>
                </c:pt>
                <c:pt idx="231">
                  <c:v>0.3380281690140845</c:v>
                </c:pt>
                <c:pt idx="232">
                  <c:v>0.36619718309859156</c:v>
                </c:pt>
                <c:pt idx="233">
                  <c:v>0.38028169014084506</c:v>
                </c:pt>
                <c:pt idx="234">
                  <c:v>0.352112676056338</c:v>
                </c:pt>
                <c:pt idx="235">
                  <c:v>0.3380281690140845</c:v>
                </c:pt>
                <c:pt idx="236">
                  <c:v>0.352112676056338</c:v>
                </c:pt>
                <c:pt idx="237">
                  <c:v>0.36619718309859156</c:v>
                </c:pt>
                <c:pt idx="238">
                  <c:v>0.36619718309859156</c:v>
                </c:pt>
                <c:pt idx="239">
                  <c:v>0.352112676056338</c:v>
                </c:pt>
                <c:pt idx="240">
                  <c:v>0.352112676056338</c:v>
                </c:pt>
                <c:pt idx="241">
                  <c:v>0.36619718309859156</c:v>
                </c:pt>
                <c:pt idx="242">
                  <c:v>0.38028169014084506</c:v>
                </c:pt>
                <c:pt idx="243">
                  <c:v>0.40845070422535212</c:v>
                </c:pt>
                <c:pt idx="244">
                  <c:v>0.39436619718309857</c:v>
                </c:pt>
                <c:pt idx="245">
                  <c:v>0.39436619718309857</c:v>
                </c:pt>
                <c:pt idx="246">
                  <c:v>0.40845070422535212</c:v>
                </c:pt>
                <c:pt idx="247">
                  <c:v>0.42253521126760563</c:v>
                </c:pt>
                <c:pt idx="248">
                  <c:v>0.43661971830985913</c:v>
                </c:pt>
                <c:pt idx="249">
                  <c:v>0.45070422535211269</c:v>
                </c:pt>
                <c:pt idx="250">
                  <c:v>0.43661971830985913</c:v>
                </c:pt>
                <c:pt idx="251">
                  <c:v>0.42253521126760563</c:v>
                </c:pt>
                <c:pt idx="252">
                  <c:v>0.43661971830985913</c:v>
                </c:pt>
                <c:pt idx="253">
                  <c:v>0.45070422535211269</c:v>
                </c:pt>
                <c:pt idx="254">
                  <c:v>0.46478873239436619</c:v>
                </c:pt>
                <c:pt idx="255">
                  <c:v>0.46478873239436619</c:v>
                </c:pt>
                <c:pt idx="257">
                  <c:v>0.45070422535211269</c:v>
                </c:pt>
                <c:pt idx="258">
                  <c:v>0.46478873239436619</c:v>
                </c:pt>
                <c:pt idx="259">
                  <c:v>0.45070422535211269</c:v>
                </c:pt>
                <c:pt idx="260">
                  <c:v>0.43661971830985913</c:v>
                </c:pt>
                <c:pt idx="261">
                  <c:v>0.45070422535211269</c:v>
                </c:pt>
                <c:pt idx="262">
                  <c:v>0.47887323943661969</c:v>
                </c:pt>
                <c:pt idx="263">
                  <c:v>0.45070422535211269</c:v>
                </c:pt>
                <c:pt idx="264">
                  <c:v>0.46478873239436619</c:v>
                </c:pt>
                <c:pt idx="265">
                  <c:v>0.45070422535211269</c:v>
                </c:pt>
                <c:pt idx="266">
                  <c:v>0.43661971830985913</c:v>
                </c:pt>
                <c:pt idx="267">
                  <c:v>0.47887323943661969</c:v>
                </c:pt>
                <c:pt idx="268">
                  <c:v>0.47887323943661969</c:v>
                </c:pt>
                <c:pt idx="269">
                  <c:v>0.47887323943661969</c:v>
                </c:pt>
                <c:pt idx="270">
                  <c:v>0.47887323943661969</c:v>
                </c:pt>
                <c:pt idx="271">
                  <c:v>0.52112676056338025</c:v>
                </c:pt>
                <c:pt idx="272">
                  <c:v>0.60563380281690138</c:v>
                </c:pt>
                <c:pt idx="273">
                  <c:v>0.59154929577464788</c:v>
                </c:pt>
                <c:pt idx="274">
                  <c:v>0.61971830985915488</c:v>
                </c:pt>
                <c:pt idx="275">
                  <c:v>0.61971830985915488</c:v>
                </c:pt>
                <c:pt idx="276">
                  <c:v>0.63380281690140849</c:v>
                </c:pt>
                <c:pt idx="277">
                  <c:v>0.61971830985915488</c:v>
                </c:pt>
                <c:pt idx="278">
                  <c:v>0.40845070422535212</c:v>
                </c:pt>
                <c:pt idx="279">
                  <c:v>0.41428571428571431</c:v>
                </c:pt>
                <c:pt idx="280">
                  <c:v>0.42253521126760563</c:v>
                </c:pt>
                <c:pt idx="281">
                  <c:v>0.43661971830985913</c:v>
                </c:pt>
                <c:pt idx="282">
                  <c:v>0.45070422535211269</c:v>
                </c:pt>
                <c:pt idx="283">
                  <c:v>0.43661971830985913</c:v>
                </c:pt>
                <c:pt idx="284">
                  <c:v>0.45070422535211269</c:v>
                </c:pt>
                <c:pt idx="287">
                  <c:v>0.54929577464788737</c:v>
                </c:pt>
                <c:pt idx="288">
                  <c:v>0.57746478873239437</c:v>
                </c:pt>
                <c:pt idx="289">
                  <c:v>0.56338028169014087</c:v>
                </c:pt>
                <c:pt idx="290">
                  <c:v>0.57746478873239437</c:v>
                </c:pt>
                <c:pt idx="291">
                  <c:v>0.57746478873239437</c:v>
                </c:pt>
                <c:pt idx="292">
                  <c:v>0.59154929577464788</c:v>
                </c:pt>
                <c:pt idx="293">
                  <c:v>0.56338028169014087</c:v>
                </c:pt>
                <c:pt idx="294">
                  <c:v>0.54929577464788737</c:v>
                </c:pt>
                <c:pt idx="295">
                  <c:v>0.52112676056338025</c:v>
                </c:pt>
                <c:pt idx="296">
                  <c:v>0.50704225352112675</c:v>
                </c:pt>
                <c:pt idx="297">
                  <c:v>0.50704225352112675</c:v>
                </c:pt>
                <c:pt idx="298">
                  <c:v>0.52112676056338025</c:v>
                </c:pt>
                <c:pt idx="299">
                  <c:v>0.52112676056338025</c:v>
                </c:pt>
                <c:pt idx="300">
                  <c:v>0.43661971830985913</c:v>
                </c:pt>
                <c:pt idx="301">
                  <c:v>0.46478873239436619</c:v>
                </c:pt>
                <c:pt idx="302">
                  <c:v>0.45070422535211269</c:v>
                </c:pt>
                <c:pt idx="303">
                  <c:v>0.46478873239436619</c:v>
                </c:pt>
                <c:pt idx="304">
                  <c:v>0.48571428571428571</c:v>
                </c:pt>
                <c:pt idx="305">
                  <c:v>0.42253521126760563</c:v>
                </c:pt>
                <c:pt idx="306">
                  <c:v>0.40845070422535212</c:v>
                </c:pt>
                <c:pt idx="307">
                  <c:v>0.39436619718309857</c:v>
                </c:pt>
                <c:pt idx="308">
                  <c:v>0.42253521126760563</c:v>
                </c:pt>
                <c:pt idx="309">
                  <c:v>0.43661971830985913</c:v>
                </c:pt>
                <c:pt idx="310">
                  <c:v>0.42253521126760563</c:v>
                </c:pt>
                <c:pt idx="311">
                  <c:v>0.43661971830985913</c:v>
                </c:pt>
                <c:pt idx="312">
                  <c:v>0.45070422535211269</c:v>
                </c:pt>
                <c:pt idx="313">
                  <c:v>0.46478873239436619</c:v>
                </c:pt>
                <c:pt idx="314">
                  <c:v>0.47887323943661969</c:v>
                </c:pt>
                <c:pt idx="315">
                  <c:v>0.4929577464788732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4003200"/>
        <c:axId val="94004736"/>
      </c:lineChart>
      <c:catAx>
        <c:axId val="94003200"/>
        <c:scaling>
          <c:orientation val="minMax"/>
        </c:scaling>
        <c:delete val="1"/>
        <c:axPos val="b"/>
        <c:majorTickMark val="out"/>
        <c:minorTickMark val="none"/>
        <c:tickLblPos val="none"/>
        <c:crossAx val="94004736"/>
        <c:crosses val="autoZero"/>
        <c:auto val="1"/>
        <c:lblAlgn val="ctr"/>
        <c:lblOffset val="100"/>
        <c:noMultiLvlLbl val="0"/>
      </c:catAx>
      <c:valAx>
        <c:axId val="94004736"/>
        <c:scaling>
          <c:orientation val="minMax"/>
          <c:max val="0.8"/>
          <c:min val="0.2"/>
        </c:scaling>
        <c:delete val="0"/>
        <c:axPos val="l"/>
        <c:majorGridlines>
          <c:spPr>
            <a:ln>
              <a:noFill/>
            </a:ln>
          </c:spPr>
        </c:majorGridlines>
        <c:numFmt formatCode="0%" sourceLinked="1"/>
        <c:majorTickMark val="out"/>
        <c:minorTickMark val="none"/>
        <c:tickLblPos val="nextTo"/>
        <c:crossAx val="940032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0771712018140587"/>
          <c:y val="0"/>
          <c:w val="0.16141530612244903"/>
          <c:h val="7.3732560582956394E-2"/>
        </c:manualLayout>
      </c:layout>
      <c:overlay val="0"/>
      <c:txPr>
        <a:bodyPr/>
        <a:lstStyle/>
        <a:p>
          <a:pPr>
            <a:defRPr sz="1800" i="1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896867780974529E-2"/>
          <c:y val="3.3081061071763097E-2"/>
          <c:w val="0.88592060173390685"/>
          <c:h val="0.86366316528995235"/>
        </c:manualLayout>
      </c:layout>
      <c:scatterChart>
        <c:scatterStyle val="lineMarker"/>
        <c:varyColors val="0"/>
        <c:ser>
          <c:idx val="0"/>
          <c:order val="0"/>
          <c:tx>
            <c:v>Microspore-derived population</c:v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rgbClr val="002060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0"/>
            <c:trendlineLbl>
              <c:layout>
                <c:manualLayout>
                  <c:x val="0.12263783993275421"/>
                  <c:y val="-3.0192554482044675E-2"/>
                </c:manualLayout>
              </c:layout>
              <c:numFmt formatCode="General" sourceLinked="0"/>
              <c:spPr>
                <a:solidFill>
                  <a:srgbClr val="002060"/>
                </a:solidFill>
              </c:spPr>
              <c:txPr>
                <a:bodyPr/>
                <a:lstStyle/>
                <a:p>
                  <a:pPr>
                    <a:defRPr>
                      <a:solidFill>
                        <a:schemeClr val="bg1"/>
                      </a:solidFill>
                    </a:defRPr>
                  </a:pPr>
                  <a:endParaRPr lang="de-DE"/>
                </a:p>
              </c:txPr>
            </c:trendlineLbl>
          </c:trendline>
          <c:xVal>
            <c:numRef>
              <c:f>MD!$M$2:$M$68</c:f>
              <c:numCache>
                <c:formatCode>0</c:formatCode>
                <c:ptCount val="6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32786885245901637</c:v>
                </c:pt>
                <c:pt idx="7">
                  <c:v>0.99667774086378735</c:v>
                </c:pt>
                <c:pt idx="8">
                  <c:v>3.9473684210526314</c:v>
                </c:pt>
                <c:pt idx="9">
                  <c:v>45.152354570637122</c:v>
                </c:pt>
                <c:pt idx="10">
                  <c:v>51.632047477744806</c:v>
                </c:pt>
                <c:pt idx="11">
                  <c:v>54.807692307692307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.32894736842105265</c:v>
                </c:pt>
                <c:pt idx="38">
                  <c:v>0.33222591362126247</c:v>
                </c:pt>
                <c:pt idx="39">
                  <c:v>1.3333333333333333</c:v>
                </c:pt>
                <c:pt idx="40">
                  <c:v>1.6447368421052631</c:v>
                </c:pt>
                <c:pt idx="41">
                  <c:v>2.3333333333333335</c:v>
                </c:pt>
                <c:pt idx="42">
                  <c:v>4.193548387096774</c:v>
                </c:pt>
                <c:pt idx="43">
                  <c:v>24.350649350649352</c:v>
                </c:pt>
                <c:pt idx="44">
                  <c:v>31.111111111111111</c:v>
                </c:pt>
                <c:pt idx="45">
                  <c:v>42.319749216300941</c:v>
                </c:pt>
                <c:pt idx="46">
                  <c:v>48.997134670487107</c:v>
                </c:pt>
                <c:pt idx="47">
                  <c:v>52.733118971061096</c:v>
                </c:pt>
                <c:pt idx="48">
                  <c:v>54.662379421221864</c:v>
                </c:pt>
                <c:pt idx="49">
                  <c:v>55.048859934853418</c:v>
                </c:pt>
                <c:pt idx="50">
                  <c:v>56.506849315068493</c:v>
                </c:pt>
                <c:pt idx="51">
                  <c:v>59.672131147540981</c:v>
                </c:pt>
                <c:pt idx="52">
                  <c:v>60</c:v>
                </c:pt>
                <c:pt idx="53">
                  <c:v>61.111111111111114</c:v>
                </c:pt>
                <c:pt idx="54">
                  <c:v>66.853932584269657</c:v>
                </c:pt>
                <c:pt idx="55">
                  <c:v>69.230769230769226</c:v>
                </c:pt>
                <c:pt idx="56">
                  <c:v>70.793650793650798</c:v>
                </c:pt>
                <c:pt idx="57">
                  <c:v>72.727272727272734</c:v>
                </c:pt>
                <c:pt idx="58">
                  <c:v>82.662538699690401</c:v>
                </c:pt>
                <c:pt idx="59">
                  <c:v>83.720930232558146</c:v>
                </c:pt>
                <c:pt idx="60">
                  <c:v>86.971830985915489</c:v>
                </c:pt>
                <c:pt idx="61">
                  <c:v>90.819672131147541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</c:numCache>
            </c:numRef>
          </c:xVal>
          <c:yVal>
            <c:numRef>
              <c:f>MD!$N$2:$N$68</c:f>
              <c:numCache>
                <c:formatCode>General</c:formatCode>
                <c:ptCount val="6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5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35</c:v>
                </c:pt>
                <c:pt idx="11">
                  <c:v>7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2</c:v>
                </c:pt>
                <c:pt idx="36">
                  <c:v>12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15</c:v>
                </c:pt>
                <c:pt idx="43">
                  <c:v>0</c:v>
                </c:pt>
                <c:pt idx="44">
                  <c:v>47</c:v>
                </c:pt>
                <c:pt idx="45">
                  <c:v>1</c:v>
                </c:pt>
                <c:pt idx="46">
                  <c:v>0</c:v>
                </c:pt>
                <c:pt idx="47">
                  <c:v>0</c:v>
                </c:pt>
                <c:pt idx="48">
                  <c:v>65</c:v>
                </c:pt>
                <c:pt idx="49">
                  <c:v>1</c:v>
                </c:pt>
                <c:pt idx="50">
                  <c:v>0</c:v>
                </c:pt>
                <c:pt idx="51">
                  <c:v>1</c:v>
                </c:pt>
                <c:pt idx="52">
                  <c:v>7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16</c:v>
                </c:pt>
                <c:pt idx="57">
                  <c:v>198</c:v>
                </c:pt>
                <c:pt idx="58">
                  <c:v>0</c:v>
                </c:pt>
                <c:pt idx="59">
                  <c:v>25</c:v>
                </c:pt>
                <c:pt idx="60">
                  <c:v>0</c:v>
                </c:pt>
                <c:pt idx="61">
                  <c:v>3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27</c:v>
                </c:pt>
              </c:numCache>
            </c:numRef>
          </c:yVal>
          <c:smooth val="0"/>
        </c:ser>
        <c:ser>
          <c:idx val="1"/>
          <c:order val="1"/>
          <c:tx>
            <c:v>Self-pollinated population</c:v>
          </c:tx>
          <c:spPr>
            <a:ln w="28575">
              <a:noFill/>
            </a:ln>
          </c:spPr>
          <c:marker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0"/>
            <c:trendlineLbl>
              <c:layout>
                <c:manualLayout>
                  <c:x val="-1.0528622279840031E-2"/>
                  <c:y val="-3.2829027456978195E-2"/>
                </c:manualLayout>
              </c:layout>
              <c:numFmt formatCode="General" sourceLinked="0"/>
              <c:spPr>
                <a:solidFill>
                  <a:srgbClr val="FF0000"/>
                </a:solidFill>
              </c:spPr>
            </c:trendlineLbl>
          </c:trendline>
          <c:trendline>
            <c:trendlineType val="linear"/>
            <c:dispRSqr val="0"/>
            <c:dispEq val="0"/>
          </c:trendline>
          <c:trendline>
            <c:trendlineType val="linear"/>
            <c:dispRSqr val="0"/>
            <c:dispEq val="0"/>
          </c:trendline>
          <c:trendline>
            <c:trendlineType val="linear"/>
            <c:dispRSqr val="0"/>
            <c:dispEq val="0"/>
          </c:trendline>
          <c:trendline>
            <c:trendlineType val="linear"/>
            <c:dispRSqr val="0"/>
            <c:dispEq val="0"/>
          </c:trendline>
          <c:xVal>
            <c:numRef>
              <c:f>SP!$S$2:$S$41</c:f>
              <c:numCache>
                <c:formatCode>0</c:formatCode>
                <c:ptCount val="40"/>
                <c:pt idx="0">
                  <c:v>12.5</c:v>
                </c:pt>
                <c:pt idx="1">
                  <c:v>21.019108280254777</c:v>
                </c:pt>
                <c:pt idx="2">
                  <c:v>0</c:v>
                </c:pt>
                <c:pt idx="3">
                  <c:v>13.82636655948553</c:v>
                </c:pt>
                <c:pt idx="4">
                  <c:v>48.35526315789474</c:v>
                </c:pt>
                <c:pt idx="5">
                  <c:v>0</c:v>
                </c:pt>
                <c:pt idx="6">
                  <c:v>0</c:v>
                </c:pt>
                <c:pt idx="7">
                  <c:v>19.020172910662826</c:v>
                </c:pt>
                <c:pt idx="8">
                  <c:v>17.049180327868854</c:v>
                </c:pt>
                <c:pt idx="9">
                  <c:v>0</c:v>
                </c:pt>
                <c:pt idx="10">
                  <c:v>20</c:v>
                </c:pt>
                <c:pt idx="11">
                  <c:v>0</c:v>
                </c:pt>
                <c:pt idx="12">
                  <c:v>29.967426710097719</c:v>
                </c:pt>
                <c:pt idx="13">
                  <c:v>44.554455445544555</c:v>
                </c:pt>
                <c:pt idx="14">
                  <c:v>61.516034985422742</c:v>
                </c:pt>
                <c:pt idx="15">
                  <c:v>10.828025477707007</c:v>
                </c:pt>
                <c:pt idx="16">
                  <c:v>14.551083591331269</c:v>
                </c:pt>
                <c:pt idx="17">
                  <c:v>23.174603174603174</c:v>
                </c:pt>
                <c:pt idx="18">
                  <c:v>76.129032258064512</c:v>
                </c:pt>
                <c:pt idx="19">
                  <c:v>41.955835962145109</c:v>
                </c:pt>
                <c:pt idx="20">
                  <c:v>63.725490196078432</c:v>
                </c:pt>
                <c:pt idx="21">
                  <c:v>67.711598746081506</c:v>
                </c:pt>
                <c:pt idx="22">
                  <c:v>63.46153846153846</c:v>
                </c:pt>
                <c:pt idx="23">
                  <c:v>75.884244372990352</c:v>
                </c:pt>
                <c:pt idx="24">
                  <c:v>42.244224422442244</c:v>
                </c:pt>
                <c:pt idx="25">
                  <c:v>40.79754601226994</c:v>
                </c:pt>
                <c:pt idx="26">
                  <c:v>45.510835913312697</c:v>
                </c:pt>
                <c:pt idx="27">
                  <c:v>85</c:v>
                </c:pt>
                <c:pt idx="28">
                  <c:v>79.245283018867923</c:v>
                </c:pt>
                <c:pt idx="29">
                  <c:v>35.69131832797428</c:v>
                </c:pt>
                <c:pt idx="30">
                  <c:v>65.714285714285708</c:v>
                </c:pt>
                <c:pt idx="31">
                  <c:v>37.951807228915662</c:v>
                </c:pt>
                <c:pt idx="32">
                  <c:v>63.375796178343947</c:v>
                </c:pt>
                <c:pt idx="33">
                  <c:v>41.284403669724767</c:v>
                </c:pt>
                <c:pt idx="34">
                  <c:v>43.515850144092219</c:v>
                </c:pt>
                <c:pt idx="35">
                  <c:v>31.974921630094045</c:v>
                </c:pt>
                <c:pt idx="36">
                  <c:v>21.25</c:v>
                </c:pt>
                <c:pt idx="37">
                  <c:v>23.006134969325153</c:v>
                </c:pt>
                <c:pt idx="38">
                  <c:v>57.758620689655174</c:v>
                </c:pt>
                <c:pt idx="39">
                  <c:v>61.561561561561561</c:v>
                </c:pt>
              </c:numCache>
            </c:numRef>
          </c:xVal>
          <c:yVal>
            <c:numRef>
              <c:f>SP!$T$2:$T$41</c:f>
              <c:numCache>
                <c:formatCode>General</c:formatCode>
                <c:ptCount val="4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</c:v>
                </c:pt>
                <c:pt idx="9">
                  <c:v>5</c:v>
                </c:pt>
                <c:pt idx="10">
                  <c:v>11</c:v>
                </c:pt>
                <c:pt idx="11">
                  <c:v>12</c:v>
                </c:pt>
                <c:pt idx="12">
                  <c:v>12</c:v>
                </c:pt>
                <c:pt idx="13">
                  <c:v>15</c:v>
                </c:pt>
                <c:pt idx="14">
                  <c:v>17</c:v>
                </c:pt>
                <c:pt idx="15">
                  <c:v>21</c:v>
                </c:pt>
                <c:pt idx="16">
                  <c:v>22</c:v>
                </c:pt>
                <c:pt idx="17">
                  <c:v>25</c:v>
                </c:pt>
                <c:pt idx="18">
                  <c:v>27</c:v>
                </c:pt>
                <c:pt idx="19">
                  <c:v>28</c:v>
                </c:pt>
                <c:pt idx="20">
                  <c:v>29</c:v>
                </c:pt>
                <c:pt idx="21">
                  <c:v>33</c:v>
                </c:pt>
                <c:pt idx="22">
                  <c:v>39</c:v>
                </c:pt>
                <c:pt idx="23">
                  <c:v>43</c:v>
                </c:pt>
                <c:pt idx="24">
                  <c:v>47</c:v>
                </c:pt>
                <c:pt idx="25">
                  <c:v>48</c:v>
                </c:pt>
                <c:pt idx="26">
                  <c:v>68</c:v>
                </c:pt>
                <c:pt idx="27">
                  <c:v>73</c:v>
                </c:pt>
                <c:pt idx="28">
                  <c:v>97</c:v>
                </c:pt>
                <c:pt idx="29">
                  <c:v>103</c:v>
                </c:pt>
                <c:pt idx="30">
                  <c:v>105</c:v>
                </c:pt>
                <c:pt idx="31">
                  <c:v>111</c:v>
                </c:pt>
                <c:pt idx="32">
                  <c:v>111</c:v>
                </c:pt>
                <c:pt idx="33">
                  <c:v>119</c:v>
                </c:pt>
                <c:pt idx="34">
                  <c:v>123</c:v>
                </c:pt>
                <c:pt idx="35">
                  <c:v>132</c:v>
                </c:pt>
                <c:pt idx="36">
                  <c:v>138</c:v>
                </c:pt>
                <c:pt idx="37">
                  <c:v>149</c:v>
                </c:pt>
                <c:pt idx="38">
                  <c:v>187</c:v>
                </c:pt>
                <c:pt idx="39">
                  <c:v>294</c:v>
                </c:pt>
              </c:numCache>
            </c:numRef>
          </c:yVal>
          <c:smooth val="0"/>
        </c:ser>
        <c:ser>
          <c:idx val="2"/>
          <c:order val="2"/>
          <c:tx>
            <c:v>Open-pollinated population</c:v>
          </c:tx>
          <c:spPr>
            <a:ln w="28575">
              <a:noFill/>
            </a:ln>
          </c:spPr>
          <c:marker>
            <c:symbol val="circle"/>
            <c:size val="7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0"/>
            <c:trendlineLbl>
              <c:layout>
                <c:manualLayout>
                  <c:x val="9.7561307483206725E-2"/>
                  <c:y val="-3.1239800279211392E-2"/>
                </c:manualLayout>
              </c:layout>
              <c:numFmt formatCode="General" sourceLinked="0"/>
              <c:spPr>
                <a:solidFill>
                  <a:schemeClr val="bg1">
                    <a:lumMod val="95000"/>
                  </a:schemeClr>
                </a:solidFill>
              </c:spPr>
            </c:trendlineLbl>
          </c:trendline>
          <c:xVal>
            <c:numRef>
              <c:f>OP!$I$2:$I$47</c:f>
              <c:numCache>
                <c:formatCode>0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2894736842105265</c:v>
                </c:pt>
                <c:pt idx="5">
                  <c:v>2.6315789473684212</c:v>
                </c:pt>
                <c:pt idx="6">
                  <c:v>3.8095238095238093</c:v>
                </c:pt>
                <c:pt idx="7">
                  <c:v>6.962025316455696</c:v>
                </c:pt>
                <c:pt idx="8">
                  <c:v>7</c:v>
                </c:pt>
                <c:pt idx="9">
                  <c:v>11.147540983606557</c:v>
                </c:pt>
                <c:pt idx="10">
                  <c:v>15.584415584415584</c:v>
                </c:pt>
                <c:pt idx="11">
                  <c:v>17.021276595744681</c:v>
                </c:pt>
                <c:pt idx="12">
                  <c:v>17.589576547231271</c:v>
                </c:pt>
                <c:pt idx="13">
                  <c:v>19.685039370078741</c:v>
                </c:pt>
                <c:pt idx="14">
                  <c:v>26.795580110497237</c:v>
                </c:pt>
                <c:pt idx="15">
                  <c:v>28.313253012048193</c:v>
                </c:pt>
                <c:pt idx="16">
                  <c:v>28.4375</c:v>
                </c:pt>
                <c:pt idx="17">
                  <c:v>28.792569659442723</c:v>
                </c:pt>
                <c:pt idx="18">
                  <c:v>29.47019867549669</c:v>
                </c:pt>
                <c:pt idx="19">
                  <c:v>30.303030303030305</c:v>
                </c:pt>
                <c:pt idx="20">
                  <c:v>30.529595015576323</c:v>
                </c:pt>
                <c:pt idx="21">
                  <c:v>38.253012048192772</c:v>
                </c:pt>
                <c:pt idx="22">
                  <c:v>38.871473354231973</c:v>
                </c:pt>
                <c:pt idx="23">
                  <c:v>39.080459770114942</c:v>
                </c:pt>
                <c:pt idx="24">
                  <c:v>39.871382636655952</c:v>
                </c:pt>
                <c:pt idx="25">
                  <c:v>41.691842900302113</c:v>
                </c:pt>
                <c:pt idx="26">
                  <c:v>47.151898734177216</c:v>
                </c:pt>
                <c:pt idx="27">
                  <c:v>48.520710059171599</c:v>
                </c:pt>
                <c:pt idx="28">
                  <c:v>49.83606557377049</c:v>
                </c:pt>
                <c:pt idx="29">
                  <c:v>53.225806451612904</c:v>
                </c:pt>
                <c:pt idx="30">
                  <c:v>53.994490358126718</c:v>
                </c:pt>
                <c:pt idx="31">
                  <c:v>54.487179487179489</c:v>
                </c:pt>
                <c:pt idx="32">
                  <c:v>57.236842105263158</c:v>
                </c:pt>
                <c:pt idx="33">
                  <c:v>62.974683544303801</c:v>
                </c:pt>
                <c:pt idx="34">
                  <c:v>64.01273885350318</c:v>
                </c:pt>
                <c:pt idx="35">
                  <c:v>64.606741573033702</c:v>
                </c:pt>
                <c:pt idx="36">
                  <c:v>65.822784810126578</c:v>
                </c:pt>
                <c:pt idx="37">
                  <c:v>65.895953757225428</c:v>
                </c:pt>
                <c:pt idx="38">
                  <c:v>68.125</c:v>
                </c:pt>
                <c:pt idx="39">
                  <c:v>72.63513513513513</c:v>
                </c:pt>
                <c:pt idx="40">
                  <c:v>78.761061946902657</c:v>
                </c:pt>
                <c:pt idx="41">
                  <c:v>84.307692307692307</c:v>
                </c:pt>
                <c:pt idx="42">
                  <c:v>85.792349726775953</c:v>
                </c:pt>
                <c:pt idx="43">
                  <c:v>87.702265372168284</c:v>
                </c:pt>
                <c:pt idx="44">
                  <c:v>91</c:v>
                </c:pt>
                <c:pt idx="45">
                  <c:v>94.193548387096769</c:v>
                </c:pt>
              </c:numCache>
            </c:numRef>
          </c:xVal>
          <c:yVal>
            <c:numRef>
              <c:f>OP!$J$2:$J$47</c:f>
              <c:numCache>
                <c:formatCode>General</c:formatCode>
                <c:ptCount val="4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0</c:v>
                </c:pt>
                <c:pt idx="4">
                  <c:v>31</c:v>
                </c:pt>
                <c:pt idx="5">
                  <c:v>0</c:v>
                </c:pt>
                <c:pt idx="6">
                  <c:v>12</c:v>
                </c:pt>
                <c:pt idx="7">
                  <c:v>41</c:v>
                </c:pt>
                <c:pt idx="8">
                  <c:v>70</c:v>
                </c:pt>
                <c:pt idx="9">
                  <c:v>117</c:v>
                </c:pt>
                <c:pt idx="10">
                  <c:v>0</c:v>
                </c:pt>
                <c:pt idx="11">
                  <c:v>0</c:v>
                </c:pt>
                <c:pt idx="12">
                  <c:v>68</c:v>
                </c:pt>
                <c:pt idx="13">
                  <c:v>11</c:v>
                </c:pt>
                <c:pt idx="14">
                  <c:v>33</c:v>
                </c:pt>
                <c:pt idx="15">
                  <c:v>0</c:v>
                </c:pt>
                <c:pt idx="16">
                  <c:v>40</c:v>
                </c:pt>
                <c:pt idx="17">
                  <c:v>16</c:v>
                </c:pt>
                <c:pt idx="18">
                  <c:v>32</c:v>
                </c:pt>
                <c:pt idx="19">
                  <c:v>48</c:v>
                </c:pt>
                <c:pt idx="20">
                  <c:v>81</c:v>
                </c:pt>
                <c:pt idx="21">
                  <c:v>76</c:v>
                </c:pt>
                <c:pt idx="22">
                  <c:v>0</c:v>
                </c:pt>
                <c:pt idx="23">
                  <c:v>0</c:v>
                </c:pt>
                <c:pt idx="24">
                  <c:v>84</c:v>
                </c:pt>
                <c:pt idx="25">
                  <c:v>15</c:v>
                </c:pt>
                <c:pt idx="26">
                  <c:v>25</c:v>
                </c:pt>
                <c:pt idx="27">
                  <c:v>103</c:v>
                </c:pt>
                <c:pt idx="28">
                  <c:v>4</c:v>
                </c:pt>
                <c:pt idx="29">
                  <c:v>24</c:v>
                </c:pt>
                <c:pt idx="30">
                  <c:v>1</c:v>
                </c:pt>
                <c:pt idx="31">
                  <c:v>38</c:v>
                </c:pt>
                <c:pt idx="32">
                  <c:v>19</c:v>
                </c:pt>
                <c:pt idx="33">
                  <c:v>187</c:v>
                </c:pt>
                <c:pt idx="34">
                  <c:v>36</c:v>
                </c:pt>
                <c:pt idx="35">
                  <c:v>18</c:v>
                </c:pt>
                <c:pt idx="36">
                  <c:v>168</c:v>
                </c:pt>
                <c:pt idx="37">
                  <c:v>66</c:v>
                </c:pt>
                <c:pt idx="38">
                  <c:v>57</c:v>
                </c:pt>
                <c:pt idx="39">
                  <c:v>192</c:v>
                </c:pt>
                <c:pt idx="40">
                  <c:v>139</c:v>
                </c:pt>
                <c:pt idx="41">
                  <c:v>126</c:v>
                </c:pt>
                <c:pt idx="42">
                  <c:v>65</c:v>
                </c:pt>
                <c:pt idx="43">
                  <c:v>158</c:v>
                </c:pt>
                <c:pt idx="44">
                  <c:v>70</c:v>
                </c:pt>
                <c:pt idx="45">
                  <c:v>1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3670784"/>
        <c:axId val="93693056"/>
      </c:scatterChart>
      <c:valAx>
        <c:axId val="93670784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crossAx val="93693056"/>
        <c:crosses val="autoZero"/>
        <c:crossBetween val="midCat"/>
      </c:valAx>
      <c:valAx>
        <c:axId val="9369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93670784"/>
        <c:crosses val="autoZero"/>
        <c:crossBetween val="midCat"/>
      </c:valAx>
    </c:plotArea>
    <c:legend>
      <c:legendPos val="r"/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egendEntry>
        <c:idx val="6"/>
        <c:delete val="1"/>
      </c:legendEntry>
      <c:legendEntry>
        <c:idx val="7"/>
        <c:delete val="1"/>
      </c:legendEntry>
      <c:legendEntry>
        <c:idx val="8"/>
        <c:delete val="1"/>
      </c:legendEntry>
      <c:legendEntry>
        <c:idx val="9"/>
        <c:delete val="1"/>
      </c:legendEntry>
      <c:layout>
        <c:manualLayout>
          <c:xMode val="edge"/>
          <c:yMode val="edge"/>
          <c:x val="9.4179669691873288E-2"/>
          <c:y val="2.9745273499877229E-2"/>
          <c:w val="0.38279415314007254"/>
          <c:h val="0.2225019514699444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3CF9D7-C342-4630-842F-6977C160162F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9CCC00-E0A0-4478-B1E2-700367A89A27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83193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9CCC00-E0A0-4478-B1E2-700367A89A27}" type="slidenum">
              <a:rPr lang="en-AU" smtClean="0"/>
              <a:pPr/>
              <a:t>1</a:t>
            </a:fld>
            <a:endParaRPr lang="en-AU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9CCC00-E0A0-4478-B1E2-700367A89A27}" type="slidenum">
              <a:rPr lang="en-AU" smtClean="0"/>
              <a:pPr/>
              <a:t>2</a:t>
            </a:fld>
            <a:endParaRPr lang="en-AU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9CCC00-E0A0-4478-B1E2-700367A89A27}" type="slidenum">
              <a:rPr lang="en-AU" smtClean="0"/>
              <a:pPr/>
              <a:t>3</a:t>
            </a:fld>
            <a:endParaRPr lang="en-A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93108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73052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57197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3681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20327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8301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8239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37765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85558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57367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68338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F8F5D-EE28-45F7-8BAB-03E9C17D40EE}" type="datetimeFigureOut">
              <a:rPr lang="en-AU" smtClean="0"/>
              <a:pPr/>
              <a:t>17/04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CC8BE-5B3C-44AB-B4D1-AF0EB2BE4EE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45374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Group 103"/>
          <p:cNvGrpSpPr/>
          <p:nvPr/>
        </p:nvGrpSpPr>
        <p:grpSpPr>
          <a:xfrm>
            <a:off x="-36511" y="-228526"/>
            <a:ext cx="8208936" cy="7185918"/>
            <a:chOff x="-36511" y="-228526"/>
            <a:chExt cx="8208936" cy="7185918"/>
          </a:xfrm>
        </p:grpSpPr>
        <p:sp>
          <p:nvSpPr>
            <p:cNvPr id="87" name="TextBox 86"/>
            <p:cNvSpPr txBox="1"/>
            <p:nvPr/>
          </p:nvSpPr>
          <p:spPr>
            <a:xfrm rot="16200000">
              <a:off x="-1662758" y="2637202"/>
              <a:ext cx="35910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llele presence across the population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65" name="Chart 6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03401795"/>
                </p:ext>
              </p:extLst>
            </p:nvPr>
          </p:nvGraphicFramePr>
          <p:xfrm>
            <a:off x="281295" y="3611572"/>
            <a:ext cx="7879992" cy="33458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1" name="TextBox 1"/>
            <p:cNvSpPr txBox="1"/>
            <p:nvPr/>
          </p:nvSpPr>
          <p:spPr>
            <a:xfrm>
              <a:off x="1151003" y="4539833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1"/>
            <p:cNvSpPr txBox="1"/>
            <p:nvPr/>
          </p:nvSpPr>
          <p:spPr>
            <a:xfrm>
              <a:off x="2639783" y="4548480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1"/>
            <p:cNvSpPr txBox="1"/>
            <p:nvPr/>
          </p:nvSpPr>
          <p:spPr>
            <a:xfrm>
              <a:off x="1760964" y="4535473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1"/>
            <p:cNvSpPr txBox="1"/>
            <p:nvPr/>
          </p:nvSpPr>
          <p:spPr>
            <a:xfrm>
              <a:off x="3844351" y="4566212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Box 1"/>
            <p:cNvSpPr txBox="1"/>
            <p:nvPr/>
          </p:nvSpPr>
          <p:spPr>
            <a:xfrm>
              <a:off x="5363595" y="4581128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6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1"/>
            <p:cNvSpPr txBox="1"/>
            <p:nvPr/>
          </p:nvSpPr>
          <p:spPr>
            <a:xfrm>
              <a:off x="4877138" y="4565774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Box 1"/>
            <p:cNvSpPr txBox="1"/>
            <p:nvPr/>
          </p:nvSpPr>
          <p:spPr>
            <a:xfrm>
              <a:off x="5846878" y="4572918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7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TextBox 1"/>
            <p:cNvSpPr txBox="1"/>
            <p:nvPr/>
          </p:nvSpPr>
          <p:spPr>
            <a:xfrm>
              <a:off x="6609945" y="4539394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8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TextBox 1"/>
            <p:cNvSpPr txBox="1"/>
            <p:nvPr/>
          </p:nvSpPr>
          <p:spPr>
            <a:xfrm>
              <a:off x="7163435" y="3901157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9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1"/>
            <p:cNvSpPr txBox="1"/>
            <p:nvPr/>
          </p:nvSpPr>
          <p:spPr>
            <a:xfrm>
              <a:off x="7544882" y="4555053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j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1" name="Straight Connector 50"/>
            <p:cNvCxnSpPr/>
            <p:nvPr/>
          </p:nvCxnSpPr>
          <p:spPr>
            <a:xfrm>
              <a:off x="818303" y="4911692"/>
              <a:ext cx="7296794" cy="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V="1">
              <a:off x="818303" y="6093295"/>
              <a:ext cx="7296794" cy="1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1848701" y="4911692"/>
              <a:ext cx="0" cy="11603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2098731" y="4911692"/>
              <a:ext cx="0" cy="11709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4526974" y="4920022"/>
              <a:ext cx="0" cy="11708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5544973" y="4920022"/>
              <a:ext cx="0" cy="11642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5706945" y="4920022"/>
              <a:ext cx="0" cy="11732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6537482" y="4920022"/>
              <a:ext cx="0" cy="11642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7282881" y="4920022"/>
              <a:ext cx="0" cy="11642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7452623" y="4920022"/>
              <a:ext cx="0" cy="1165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3570167" y="4920022"/>
              <a:ext cx="0" cy="11626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/>
            <p:cNvSpPr txBox="1"/>
            <p:nvPr/>
          </p:nvSpPr>
          <p:spPr>
            <a:xfrm>
              <a:off x="1125775" y="3789040"/>
              <a:ext cx="1146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 </a:t>
              </a:r>
              <a:r>
                <a:rPr lang="en-AU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juncea</a:t>
              </a:r>
              <a:endParaRPr lang="en-AU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Straight Connector 121"/>
            <p:cNvCxnSpPr/>
            <p:nvPr/>
          </p:nvCxnSpPr>
          <p:spPr>
            <a:xfrm>
              <a:off x="930866" y="3972964"/>
              <a:ext cx="221298" cy="0"/>
            </a:xfrm>
            <a:prstGeom prst="line">
              <a:avLst/>
            </a:prstGeom>
            <a:ln w="2540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8115097" y="4911692"/>
              <a:ext cx="0" cy="117623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66" name="Chart 6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73838507"/>
                </p:ext>
              </p:extLst>
            </p:nvPr>
          </p:nvGraphicFramePr>
          <p:xfrm>
            <a:off x="321669" y="-228526"/>
            <a:ext cx="7850756" cy="38110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" name="TextBox 1"/>
            <p:cNvSpPr txBox="1"/>
            <p:nvPr/>
          </p:nvSpPr>
          <p:spPr>
            <a:xfrm>
              <a:off x="1136927" y="1024571"/>
              <a:ext cx="411275" cy="26067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TextBox 1"/>
            <p:cNvSpPr txBox="1"/>
            <p:nvPr/>
          </p:nvSpPr>
          <p:spPr>
            <a:xfrm>
              <a:off x="2625707" y="1025867"/>
              <a:ext cx="411275" cy="26067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1"/>
            <p:cNvSpPr txBox="1"/>
            <p:nvPr/>
          </p:nvSpPr>
          <p:spPr>
            <a:xfrm>
              <a:off x="3830275" y="1017862"/>
              <a:ext cx="411275" cy="26067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1"/>
            <p:cNvSpPr txBox="1"/>
            <p:nvPr/>
          </p:nvSpPr>
          <p:spPr>
            <a:xfrm>
              <a:off x="4863063" y="1023275"/>
              <a:ext cx="411275" cy="26067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1"/>
            <p:cNvSpPr txBox="1"/>
            <p:nvPr/>
          </p:nvSpPr>
          <p:spPr>
            <a:xfrm>
              <a:off x="5937343" y="1015645"/>
              <a:ext cx="411275" cy="26067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7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1"/>
            <p:cNvSpPr txBox="1"/>
            <p:nvPr/>
          </p:nvSpPr>
          <p:spPr>
            <a:xfrm>
              <a:off x="6624861" y="1012285"/>
              <a:ext cx="411275" cy="26067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8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"/>
            <p:cNvSpPr txBox="1"/>
            <p:nvPr/>
          </p:nvSpPr>
          <p:spPr>
            <a:xfrm>
              <a:off x="7334183" y="1016876"/>
              <a:ext cx="307602" cy="291993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A</a:t>
              </a:r>
              <a:r>
                <a:rPr lang="en-AU" sz="1600" baseline="30000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lang="en-AU" sz="16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" name="Straight Connector 13"/>
            <p:cNvCxnSpPr/>
            <p:nvPr/>
          </p:nvCxnSpPr>
          <p:spPr>
            <a:xfrm>
              <a:off x="849947" y="1351401"/>
              <a:ext cx="7302435" cy="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V="1">
              <a:off x="849947" y="2636910"/>
              <a:ext cx="7302435" cy="2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1886683" y="1351401"/>
              <a:ext cx="0" cy="12841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2084655" y="1351401"/>
              <a:ext cx="0" cy="12841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4563847" y="1351401"/>
              <a:ext cx="0" cy="12841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5771163" y="1351401"/>
              <a:ext cx="0" cy="12744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6556325" y="1351401"/>
              <a:ext cx="0" cy="12765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7326147" y="1351401"/>
              <a:ext cx="0" cy="12841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7485449" y="1351401"/>
              <a:ext cx="0" cy="12841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8144762" y="1351401"/>
              <a:ext cx="1" cy="12855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3577357" y="1351401"/>
              <a:ext cx="0" cy="12841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Box 118"/>
            <p:cNvSpPr txBox="1"/>
            <p:nvPr/>
          </p:nvSpPr>
          <p:spPr>
            <a:xfrm>
              <a:off x="1105688" y="116632"/>
              <a:ext cx="10951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 </a:t>
              </a:r>
              <a:r>
                <a:rPr lang="en-AU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apus</a:t>
              </a:r>
              <a:endParaRPr lang="en-AU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1" name="Straight Connector 120"/>
            <p:cNvCxnSpPr/>
            <p:nvPr/>
          </p:nvCxnSpPr>
          <p:spPr>
            <a:xfrm>
              <a:off x="899592" y="286999"/>
              <a:ext cx="221298" cy="0"/>
            </a:xfrm>
            <a:prstGeom prst="line">
              <a:avLst/>
            </a:prstGeom>
            <a:ln w="254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/>
            <p:cNvCxnSpPr/>
            <p:nvPr/>
          </p:nvCxnSpPr>
          <p:spPr>
            <a:xfrm>
              <a:off x="5633903" y="1351401"/>
              <a:ext cx="0" cy="128271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1"/>
            <p:cNvSpPr txBox="1"/>
            <p:nvPr/>
          </p:nvSpPr>
          <p:spPr>
            <a:xfrm>
              <a:off x="1800200" y="1800173"/>
              <a:ext cx="411275" cy="26067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36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AU" sz="3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TextBox 1"/>
            <p:cNvSpPr txBox="1"/>
            <p:nvPr/>
          </p:nvSpPr>
          <p:spPr>
            <a:xfrm>
              <a:off x="7222066" y="1800173"/>
              <a:ext cx="411275" cy="26067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36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AU" sz="3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TextBox 1"/>
            <p:cNvSpPr txBox="1"/>
            <p:nvPr/>
          </p:nvSpPr>
          <p:spPr>
            <a:xfrm>
              <a:off x="5525773" y="1778907"/>
              <a:ext cx="411275" cy="26067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36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AU" sz="36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2" name="TextBox 61"/>
          <p:cNvSpPr txBox="1"/>
          <p:nvPr/>
        </p:nvSpPr>
        <p:spPr>
          <a:xfrm>
            <a:off x="47510" y="6884870"/>
            <a:ext cx="910300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Figure </a:t>
            </a:r>
            <a:r>
              <a:rPr lang="en-AU" b="1" dirty="0" smtClean="0"/>
              <a:t>S1</a:t>
            </a:r>
            <a:r>
              <a:rPr lang="en-AU" dirty="0" smtClean="0"/>
              <a:t>: </a:t>
            </a:r>
            <a:r>
              <a:rPr lang="en-AU" dirty="0"/>
              <a:t>Transmission frequencies of </a:t>
            </a:r>
            <a:r>
              <a:rPr lang="en-AU" i="1" dirty="0"/>
              <a:t>B. </a:t>
            </a:r>
            <a:r>
              <a:rPr lang="en-AU" i="1" dirty="0" err="1"/>
              <a:t>juncea</a:t>
            </a:r>
            <a:r>
              <a:rPr lang="en-AU" dirty="0"/>
              <a:t> and </a:t>
            </a:r>
            <a:r>
              <a:rPr lang="en-AU" i="1" dirty="0"/>
              <a:t>B. </a:t>
            </a:r>
            <a:r>
              <a:rPr lang="en-AU" i="1" dirty="0" err="1"/>
              <a:t>napus</a:t>
            </a:r>
            <a:r>
              <a:rPr lang="en-AU" dirty="0"/>
              <a:t> A-genome SNP marker alleles from a near-</a:t>
            </a:r>
            <a:r>
              <a:rPr lang="en-AU" dirty="0" err="1"/>
              <a:t>allohexaploid</a:t>
            </a:r>
            <a:r>
              <a:rPr lang="en-AU" dirty="0"/>
              <a:t> hybrid to a population of microspore-derived lines. Horizontal dotted lines show thresholds for significant deviation from 50% inheritance (p&lt;0.05, Pearson’s chi-squared test).  * Chromosomes A</a:t>
            </a:r>
            <a:r>
              <a:rPr lang="en-AU" baseline="30000" dirty="0"/>
              <a:t>n</a:t>
            </a:r>
            <a:r>
              <a:rPr lang="en-AU" dirty="0"/>
              <a:t>2, A</a:t>
            </a:r>
            <a:r>
              <a:rPr lang="en-AU" baseline="30000" dirty="0"/>
              <a:t>n</a:t>
            </a:r>
            <a:r>
              <a:rPr lang="en-AU" dirty="0"/>
              <a:t>6 and A</a:t>
            </a:r>
            <a:r>
              <a:rPr lang="en-AU" baseline="30000" dirty="0"/>
              <a:t>n</a:t>
            </a:r>
            <a:r>
              <a:rPr lang="en-AU" dirty="0"/>
              <a:t>9 were absent in the near-</a:t>
            </a:r>
            <a:r>
              <a:rPr lang="en-AU" dirty="0" err="1"/>
              <a:t>allohexaploid</a:t>
            </a:r>
            <a:r>
              <a:rPr lang="en-AU" dirty="0"/>
              <a:t> hybrid. </a:t>
            </a:r>
          </a:p>
        </p:txBody>
      </p:sp>
    </p:spTree>
    <p:extLst>
      <p:ext uri="{BB962C8B-B14F-4D97-AF65-F5344CB8AC3E}">
        <p14:creationId xmlns:p14="http://schemas.microsoft.com/office/powerpoint/2010/main" val="3915503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53"/>
          <p:cNvGrpSpPr/>
          <p:nvPr/>
        </p:nvGrpSpPr>
        <p:grpSpPr>
          <a:xfrm>
            <a:off x="-36511" y="44624"/>
            <a:ext cx="8258734" cy="5918772"/>
            <a:chOff x="-36511" y="44624"/>
            <a:chExt cx="8258734" cy="5918772"/>
          </a:xfrm>
        </p:grpSpPr>
        <p:sp>
          <p:nvSpPr>
            <p:cNvPr id="24" name="TextBox 1"/>
            <p:cNvSpPr txBox="1"/>
            <p:nvPr/>
          </p:nvSpPr>
          <p:spPr>
            <a:xfrm>
              <a:off x="978390" y="1152186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Straight Connector 25"/>
            <p:cNvCxnSpPr/>
            <p:nvPr/>
          </p:nvCxnSpPr>
          <p:spPr>
            <a:xfrm>
              <a:off x="1549823" y="1569968"/>
              <a:ext cx="0" cy="10614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2442494" y="1554848"/>
              <a:ext cx="0" cy="10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3306590" y="1564041"/>
              <a:ext cx="0" cy="10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 flipV="1">
              <a:off x="935229" y="1559805"/>
              <a:ext cx="7286994" cy="1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 flipV="1">
              <a:off x="935419" y="2636911"/>
              <a:ext cx="7275384" cy="1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 rot="16200000">
              <a:off x="-1662758" y="2853226"/>
              <a:ext cx="35910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presence across the population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Straight Connector 34"/>
            <p:cNvCxnSpPr/>
            <p:nvPr/>
          </p:nvCxnSpPr>
          <p:spPr>
            <a:xfrm>
              <a:off x="4325335" y="1569968"/>
              <a:ext cx="0" cy="10669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5456197" y="1559335"/>
              <a:ext cx="0" cy="10693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6618958" y="1548702"/>
              <a:ext cx="0" cy="10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7411046" y="1554848"/>
              <a:ext cx="0" cy="10738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8221436" y="1548702"/>
              <a:ext cx="0" cy="10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1"/>
            <p:cNvSpPr txBox="1"/>
            <p:nvPr/>
          </p:nvSpPr>
          <p:spPr>
            <a:xfrm>
              <a:off x="1794422" y="1152186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r>
                <a:rPr lang="en-AU" sz="1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41" name="TextBox 1"/>
            <p:cNvSpPr txBox="1"/>
            <p:nvPr/>
          </p:nvSpPr>
          <p:spPr>
            <a:xfrm>
              <a:off x="2699792" y="44624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1"/>
            <p:cNvSpPr txBox="1"/>
            <p:nvPr/>
          </p:nvSpPr>
          <p:spPr>
            <a:xfrm>
              <a:off x="3594622" y="1152186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1"/>
            <p:cNvSpPr txBox="1"/>
            <p:nvPr/>
          </p:nvSpPr>
          <p:spPr>
            <a:xfrm>
              <a:off x="4791780" y="1152186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r>
                <a:rPr lang="en-AU" sz="1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4" name="TextBox 1"/>
            <p:cNvSpPr txBox="1"/>
            <p:nvPr/>
          </p:nvSpPr>
          <p:spPr>
            <a:xfrm>
              <a:off x="5847643" y="1152186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1"/>
            <p:cNvSpPr txBox="1"/>
            <p:nvPr/>
          </p:nvSpPr>
          <p:spPr>
            <a:xfrm>
              <a:off x="6783747" y="2636912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r>
                <a:rPr lang="en-AU" sz="16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46" name="TextBox 1"/>
            <p:cNvSpPr txBox="1"/>
            <p:nvPr/>
          </p:nvSpPr>
          <p:spPr>
            <a:xfrm>
              <a:off x="7625262" y="1152186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1"/>
            <p:cNvSpPr txBox="1"/>
            <p:nvPr/>
          </p:nvSpPr>
          <p:spPr>
            <a:xfrm>
              <a:off x="997430" y="4449313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Straight Connector 83"/>
            <p:cNvCxnSpPr/>
            <p:nvPr/>
          </p:nvCxnSpPr>
          <p:spPr>
            <a:xfrm>
              <a:off x="1506390" y="4941168"/>
              <a:ext cx="0" cy="10036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>
              <a:off x="2442494" y="4941168"/>
              <a:ext cx="0" cy="10071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>
              <a:off x="3234582" y="4941168"/>
              <a:ext cx="0" cy="10163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 flipV="1">
              <a:off x="934111" y="4941168"/>
              <a:ext cx="7236000" cy="1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>
              <a:off x="4242694" y="4941168"/>
              <a:ext cx="0" cy="10222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5394822" y="4941168"/>
              <a:ext cx="0" cy="10222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>
              <a:off x="6516216" y="4941168"/>
              <a:ext cx="0" cy="10222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/>
            <p:cNvCxnSpPr/>
            <p:nvPr/>
          </p:nvCxnSpPr>
          <p:spPr>
            <a:xfrm>
              <a:off x="7380312" y="4928527"/>
              <a:ext cx="0" cy="10163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/>
            <p:cNvCxnSpPr/>
            <p:nvPr/>
          </p:nvCxnSpPr>
          <p:spPr>
            <a:xfrm>
              <a:off x="8172400" y="4941168"/>
              <a:ext cx="0" cy="10222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1"/>
            <p:cNvSpPr txBox="1"/>
            <p:nvPr/>
          </p:nvSpPr>
          <p:spPr>
            <a:xfrm>
              <a:off x="1730231" y="4449313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1"/>
            <p:cNvSpPr txBox="1"/>
            <p:nvPr/>
          </p:nvSpPr>
          <p:spPr>
            <a:xfrm>
              <a:off x="3615395" y="4449313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1"/>
            <p:cNvSpPr txBox="1"/>
            <p:nvPr/>
          </p:nvSpPr>
          <p:spPr>
            <a:xfrm>
              <a:off x="4602734" y="4449313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1"/>
            <p:cNvSpPr txBox="1"/>
            <p:nvPr/>
          </p:nvSpPr>
          <p:spPr>
            <a:xfrm>
              <a:off x="5836595" y="4449313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"/>
            <p:cNvSpPr txBox="1"/>
            <p:nvPr/>
          </p:nvSpPr>
          <p:spPr>
            <a:xfrm>
              <a:off x="7606202" y="4449313"/>
              <a:ext cx="411275" cy="26167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1"/>
            <p:cNvSpPr txBox="1"/>
            <p:nvPr/>
          </p:nvSpPr>
          <p:spPr>
            <a:xfrm>
              <a:off x="2658518" y="5279942"/>
              <a:ext cx="411275" cy="432048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36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AU" sz="3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TextBox 1"/>
            <p:cNvSpPr txBox="1"/>
            <p:nvPr/>
          </p:nvSpPr>
          <p:spPr>
            <a:xfrm>
              <a:off x="6804248" y="5261099"/>
              <a:ext cx="411275" cy="432048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36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AU" sz="3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6" name="Straight Connector 95"/>
            <p:cNvCxnSpPr/>
            <p:nvPr/>
          </p:nvCxnSpPr>
          <p:spPr>
            <a:xfrm flipV="1">
              <a:off x="927903" y="5959912"/>
              <a:ext cx="7236000" cy="1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TextBox 46"/>
          <p:cNvSpPr txBox="1"/>
          <p:nvPr/>
        </p:nvSpPr>
        <p:spPr>
          <a:xfrm>
            <a:off x="47510" y="6884870"/>
            <a:ext cx="909649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Figure </a:t>
            </a:r>
            <a:r>
              <a:rPr lang="en-AU" b="1" dirty="0" smtClean="0"/>
              <a:t>S2</a:t>
            </a:r>
            <a:r>
              <a:rPr lang="en-AU" dirty="0" smtClean="0"/>
              <a:t>: </a:t>
            </a:r>
            <a:r>
              <a:rPr lang="en-AU" dirty="0"/>
              <a:t>Transmission frequencies of </a:t>
            </a:r>
            <a:r>
              <a:rPr lang="en-AU" i="1" dirty="0"/>
              <a:t>B. </a:t>
            </a:r>
            <a:r>
              <a:rPr lang="en-AU" i="1" dirty="0" err="1"/>
              <a:t>juncea</a:t>
            </a:r>
            <a:r>
              <a:rPr lang="en-AU" dirty="0"/>
              <a:t> and </a:t>
            </a:r>
            <a:r>
              <a:rPr lang="en-AU" i="1" dirty="0"/>
              <a:t>B. </a:t>
            </a:r>
            <a:r>
              <a:rPr lang="en-AU" i="1" dirty="0" err="1"/>
              <a:t>carinata</a:t>
            </a:r>
            <a:r>
              <a:rPr lang="en-AU" dirty="0"/>
              <a:t> B-genome SSR marker alleles from a near-</a:t>
            </a:r>
            <a:r>
              <a:rPr lang="en-AU" dirty="0" err="1"/>
              <a:t>allohexaploid</a:t>
            </a:r>
            <a:r>
              <a:rPr lang="en-AU" dirty="0"/>
              <a:t> hybrid to a population of microspore-derived lines. Horizontal dotted lines show thresholds for significant deviation from 50% inheritance (p&lt;0.05, Pearson’s chi-squared test).  * Chromosomes B</a:t>
            </a:r>
            <a:r>
              <a:rPr lang="en-AU" baseline="30000" dirty="0"/>
              <a:t>c</a:t>
            </a:r>
            <a:r>
              <a:rPr lang="en-AU" dirty="0"/>
              <a:t>3 and B</a:t>
            </a:r>
            <a:r>
              <a:rPr lang="en-AU" baseline="30000" dirty="0"/>
              <a:t>c</a:t>
            </a:r>
            <a:r>
              <a:rPr lang="en-AU" dirty="0"/>
              <a:t>7 were absent in the near-</a:t>
            </a:r>
            <a:r>
              <a:rPr lang="en-AU" dirty="0" err="1"/>
              <a:t>allohexaploid</a:t>
            </a:r>
            <a:r>
              <a:rPr lang="en-AU" dirty="0"/>
              <a:t> hybrid. </a:t>
            </a:r>
          </a:p>
        </p:txBody>
      </p:sp>
      <p:graphicFrame>
        <p:nvGraphicFramePr>
          <p:cNvPr id="50" name="Chart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9070223"/>
              </p:ext>
            </p:extLst>
          </p:nvPr>
        </p:nvGraphicFramePr>
        <p:xfrm>
          <a:off x="34282" y="3501008"/>
          <a:ext cx="8354141" cy="34182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1" name="Chart 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8049113"/>
              </p:ext>
            </p:extLst>
          </p:nvPr>
        </p:nvGraphicFramePr>
        <p:xfrm>
          <a:off x="47510" y="0"/>
          <a:ext cx="8628946" cy="37170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5264052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Group 100"/>
          <p:cNvGrpSpPr/>
          <p:nvPr/>
        </p:nvGrpSpPr>
        <p:grpSpPr>
          <a:xfrm>
            <a:off x="-51899" y="9525"/>
            <a:ext cx="9267435" cy="6731843"/>
            <a:chOff x="-51899" y="9525"/>
            <a:chExt cx="9267435" cy="6731843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43656925"/>
                </p:ext>
              </p:extLst>
            </p:nvPr>
          </p:nvGraphicFramePr>
          <p:xfrm>
            <a:off x="360512" y="9525"/>
            <a:ext cx="8820000" cy="334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9" name="Straight Connector 8"/>
            <p:cNvCxnSpPr/>
            <p:nvPr/>
          </p:nvCxnSpPr>
          <p:spPr>
            <a:xfrm>
              <a:off x="927051" y="1052736"/>
              <a:ext cx="7077995" cy="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927051" y="2338247"/>
              <a:ext cx="7077995" cy="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1791147" y="1052736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2390453" y="1052736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3346748" y="1052736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3735363" y="1052736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4445918" y="1052736"/>
              <a:ext cx="0" cy="12706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5362972" y="1052736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6653783" y="1052736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971600" y="578376"/>
              <a:ext cx="5212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799461" y="592346"/>
              <a:ext cx="5212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592760" y="592346"/>
              <a:ext cx="5212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203848" y="599422"/>
              <a:ext cx="5212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924621" y="570166"/>
              <a:ext cx="5212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499992" y="567743"/>
              <a:ext cx="5212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922911" y="578376"/>
              <a:ext cx="5212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758488" y="592346"/>
              <a:ext cx="5212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7440468" y="592113"/>
              <a:ext cx="5212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77272003"/>
                </p:ext>
              </p:extLst>
            </p:nvPr>
          </p:nvGraphicFramePr>
          <p:xfrm>
            <a:off x="395536" y="3393368"/>
            <a:ext cx="8820000" cy="334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6" name="Straight Connector 5"/>
            <p:cNvCxnSpPr/>
            <p:nvPr/>
          </p:nvCxnSpPr>
          <p:spPr>
            <a:xfrm>
              <a:off x="902385" y="5697624"/>
              <a:ext cx="7149760" cy="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899592" y="4026550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802725" y="4022623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554046" y="4022390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263493" y="4029064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819825" y="4039697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607853" y="4022390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724128" y="4022623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753506" y="4022623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7401578" y="4022623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Straight Connector 56"/>
            <p:cNvCxnSpPr/>
            <p:nvPr/>
          </p:nvCxnSpPr>
          <p:spPr>
            <a:xfrm>
              <a:off x="1778131" y="4412113"/>
              <a:ext cx="0" cy="12855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2395652" y="4422746"/>
              <a:ext cx="0" cy="12642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3337924" y="4422746"/>
              <a:ext cx="0" cy="12642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3736758" y="4412113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4436887" y="4422746"/>
              <a:ext cx="0" cy="12706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5350617" y="4422746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6692377" y="4412113"/>
              <a:ext cx="0" cy="12855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7355307" y="4422746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8040611" y="4422746"/>
              <a:ext cx="0" cy="12706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 rot="16200000">
              <a:off x="-1678146" y="2687916"/>
              <a:ext cx="35910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itchFamily="34" charset="0"/>
                </a:rPr>
                <a:t>Allele presence across the population</a:t>
              </a:r>
              <a:endParaRPr lang="en-AU" sz="1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929761" y="4412113"/>
              <a:ext cx="7094884" cy="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>
              <a:off x="7324022" y="1052736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/>
            <p:cNvCxnSpPr/>
            <p:nvPr/>
          </p:nvCxnSpPr>
          <p:spPr>
            <a:xfrm>
              <a:off x="7993360" y="1063369"/>
              <a:ext cx="0" cy="12748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TextBox 46"/>
          <p:cNvSpPr txBox="1"/>
          <p:nvPr/>
        </p:nvSpPr>
        <p:spPr>
          <a:xfrm>
            <a:off x="47511" y="6884870"/>
            <a:ext cx="949304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Figure </a:t>
            </a:r>
            <a:r>
              <a:rPr lang="en-AU" b="1" dirty="0" smtClean="0"/>
              <a:t>S3</a:t>
            </a:r>
            <a:r>
              <a:rPr lang="en-AU" dirty="0" smtClean="0"/>
              <a:t>: </a:t>
            </a:r>
            <a:r>
              <a:rPr lang="en-AU" dirty="0"/>
              <a:t>Transmission frequencies of </a:t>
            </a:r>
            <a:r>
              <a:rPr lang="en-AU" i="1" dirty="0"/>
              <a:t>B. </a:t>
            </a:r>
            <a:r>
              <a:rPr lang="en-AU" i="1" dirty="0" err="1"/>
              <a:t>juncea</a:t>
            </a:r>
            <a:r>
              <a:rPr lang="en-AU" dirty="0"/>
              <a:t> and </a:t>
            </a:r>
            <a:r>
              <a:rPr lang="en-AU" i="1" dirty="0"/>
              <a:t>B. </a:t>
            </a:r>
            <a:r>
              <a:rPr lang="en-AU" i="1" dirty="0" err="1"/>
              <a:t>carinata</a:t>
            </a:r>
            <a:r>
              <a:rPr lang="en-AU" dirty="0"/>
              <a:t> B-genome SSR marker alleles from a near-</a:t>
            </a:r>
            <a:r>
              <a:rPr lang="en-AU" dirty="0" err="1"/>
              <a:t>allohexaploid</a:t>
            </a:r>
            <a:r>
              <a:rPr lang="en-AU" dirty="0"/>
              <a:t> hybrid to a population of microspore-derived lines. Horizontal dotted lines indicate significant deviation from 50% inheritance (p&lt;0.05, Pearson’s chi-squared test).</a:t>
            </a:r>
          </a:p>
        </p:txBody>
      </p:sp>
    </p:spTree>
    <p:extLst>
      <p:ext uri="{BB962C8B-B14F-4D97-AF65-F5344CB8AC3E}">
        <p14:creationId xmlns:p14="http://schemas.microsoft.com/office/powerpoint/2010/main" val="24570497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131840" y="6470337"/>
            <a:ext cx="32031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/>
              <a:t>Estimated pollen viability (%)</a:t>
            </a:r>
            <a:endParaRPr lang="en-AU" sz="2000" dirty="0"/>
          </a:p>
        </p:txBody>
      </p:sp>
      <p:sp>
        <p:nvSpPr>
          <p:cNvPr id="4" name="TextBox 3"/>
          <p:cNvSpPr txBox="1"/>
          <p:nvPr/>
        </p:nvSpPr>
        <p:spPr>
          <a:xfrm rot="16200000">
            <a:off x="-2043556" y="3354139"/>
            <a:ext cx="45708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/>
              <a:t>Number of self-pollinated seeds produced</a:t>
            </a:r>
            <a:endParaRPr lang="en-AU" sz="2000" dirty="0"/>
          </a:p>
        </p:txBody>
      </p:sp>
      <p:sp>
        <p:nvSpPr>
          <p:cNvPr id="8" name="Rectangle 7"/>
          <p:cNvSpPr/>
          <p:nvPr/>
        </p:nvSpPr>
        <p:spPr>
          <a:xfrm>
            <a:off x="-41286" y="6860739"/>
            <a:ext cx="918528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dirty="0"/>
              <a:t>Figure </a:t>
            </a:r>
            <a:r>
              <a:rPr lang="en-AU" dirty="0" smtClean="0"/>
              <a:t>S4: The relationship between pollen viability estimates and self-pollinated seed production in </a:t>
            </a:r>
            <a:r>
              <a:rPr lang="en-AU" dirty="0"/>
              <a:t>three populations derived from microspore culture, self-pollination and open-pollination of the same </a:t>
            </a:r>
            <a:r>
              <a:rPr lang="en-AU" dirty="0" err="1"/>
              <a:t>trigenomic</a:t>
            </a:r>
            <a:r>
              <a:rPr lang="en-AU" dirty="0"/>
              <a:t> </a:t>
            </a:r>
            <a:r>
              <a:rPr lang="en-AU" dirty="0" err="1"/>
              <a:t>hexaploid</a:t>
            </a:r>
            <a:r>
              <a:rPr lang="en-AU" dirty="0"/>
              <a:t> hybrid resulting from the cross (</a:t>
            </a:r>
            <a:r>
              <a:rPr lang="en-AU" i="1" dirty="0"/>
              <a:t>B. </a:t>
            </a:r>
            <a:r>
              <a:rPr lang="en-AU" i="1" dirty="0" err="1"/>
              <a:t>napus</a:t>
            </a:r>
            <a:r>
              <a:rPr lang="en-AU" dirty="0"/>
              <a:t> x </a:t>
            </a:r>
            <a:r>
              <a:rPr lang="en-AU" i="1" dirty="0"/>
              <a:t>B. </a:t>
            </a:r>
            <a:r>
              <a:rPr lang="en-AU" i="1" dirty="0" err="1"/>
              <a:t>carinata</a:t>
            </a:r>
            <a:r>
              <a:rPr lang="en-AU" dirty="0"/>
              <a:t>) x </a:t>
            </a:r>
            <a:r>
              <a:rPr lang="en-AU" i="1" dirty="0"/>
              <a:t>B. </a:t>
            </a:r>
            <a:r>
              <a:rPr lang="en-AU" i="1" dirty="0" err="1" smtClean="0"/>
              <a:t>juncea</a:t>
            </a:r>
            <a:r>
              <a:rPr lang="en-AU" i="1" dirty="0" smtClean="0"/>
              <a:t>.</a:t>
            </a:r>
            <a:endParaRPr lang="en-AU" dirty="0"/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4917755"/>
              </p:ext>
            </p:extLst>
          </p:nvPr>
        </p:nvGraphicFramePr>
        <p:xfrm>
          <a:off x="384722" y="515199"/>
          <a:ext cx="8525142" cy="61551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7581362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6436" y="2162069"/>
            <a:ext cx="261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ar-</a:t>
            </a:r>
            <a:r>
              <a:rPr lang="en-US" dirty="0" err="1" smtClean="0"/>
              <a:t>allohexaploid</a:t>
            </a:r>
            <a:r>
              <a:rPr lang="en-US" dirty="0" smtClean="0"/>
              <a:t> </a:t>
            </a:r>
            <a:r>
              <a:rPr lang="en-US" dirty="0" smtClean="0"/>
              <a:t>hybrid</a:t>
            </a:r>
            <a:endParaRPr lang="de-DE" dirty="0"/>
          </a:p>
        </p:txBody>
      </p:sp>
      <p:sp>
        <p:nvSpPr>
          <p:cNvPr id="6" name="TextBox 5"/>
          <p:cNvSpPr txBox="1"/>
          <p:nvPr/>
        </p:nvSpPr>
        <p:spPr>
          <a:xfrm>
            <a:off x="22165" y="2144977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)</a:t>
            </a:r>
            <a:endParaRPr lang="de-DE" dirty="0"/>
          </a:p>
        </p:txBody>
      </p:sp>
      <p:grpSp>
        <p:nvGrpSpPr>
          <p:cNvPr id="144" name="Group 143"/>
          <p:cNvGrpSpPr/>
          <p:nvPr/>
        </p:nvGrpSpPr>
        <p:grpSpPr>
          <a:xfrm>
            <a:off x="35497" y="2492896"/>
            <a:ext cx="8933243" cy="2079956"/>
            <a:chOff x="35497" y="304206"/>
            <a:chExt cx="8933243" cy="207995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54" t="74114" r="4253" b="9105"/>
            <a:stretch/>
          </p:blipFill>
          <p:spPr>
            <a:xfrm>
              <a:off x="1152400" y="1340065"/>
              <a:ext cx="7811600" cy="480714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3697104" y="2045608"/>
              <a:ext cx="238706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Chromosome and position</a:t>
              </a:r>
              <a:endParaRPr lang="de-DE" sz="1600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-176356" y="1410705"/>
              <a:ext cx="94692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/>
                <a:t>B Allele </a:t>
              </a:r>
            </a:p>
            <a:p>
              <a:pPr algn="ctr"/>
              <a:r>
                <a:rPr lang="en-US" sz="1400" dirty="0" smtClean="0"/>
                <a:t>Frequency</a:t>
              </a:r>
              <a:endParaRPr lang="de-DE" sz="1400" dirty="0"/>
            </a:p>
          </p:txBody>
        </p:sp>
        <p:sp>
          <p:nvSpPr>
            <p:cNvPr id="10" name="Rectangle 9"/>
            <p:cNvSpPr/>
            <p:nvPr/>
          </p:nvSpPr>
          <p:spPr>
            <a:xfrm rot="16200000">
              <a:off x="-71471" y="648979"/>
              <a:ext cx="99732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Log R Ratio</a:t>
              </a:r>
              <a:endParaRPr lang="de-DE" sz="1400" dirty="0"/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45" t="40775" r="4233" b="42569"/>
            <a:stretch/>
          </p:blipFill>
          <p:spPr>
            <a:xfrm>
              <a:off x="1152000" y="557281"/>
              <a:ext cx="7812000" cy="4824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596066" y="410311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.0</a:t>
              </a:r>
              <a:endParaRPr lang="de-DE" sz="14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16692" y="872442"/>
              <a:ext cx="506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- 1.0</a:t>
              </a:r>
              <a:endParaRPr lang="de-DE" sz="14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60708" y="645876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de-DE" sz="14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115616" y="1797177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1</a:t>
              </a:r>
              <a:endParaRPr lang="de-DE" sz="14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394612" y="1797177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2</a:t>
              </a:r>
              <a:endParaRPr lang="de-DE" sz="14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761002" y="1797177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3</a:t>
              </a:r>
              <a:endParaRPr lang="de-DE" sz="14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193050" y="1797177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4</a:t>
              </a:r>
              <a:endParaRPr lang="de-DE" sz="14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625098" y="1797177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5</a:t>
              </a:r>
              <a:endParaRPr lang="de-DE" sz="14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023238" y="1797177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6</a:t>
              </a:r>
              <a:endParaRPr lang="de-DE" sz="14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442586" y="1797177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7</a:t>
              </a:r>
              <a:endParaRPr lang="de-DE" sz="14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843412" y="1797177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8</a:t>
              </a:r>
              <a:endParaRPr lang="de-DE" sz="14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150494" y="1797177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9</a:t>
              </a:r>
              <a:endParaRPr lang="de-DE" sz="14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399336" y="1797177"/>
              <a:ext cx="4716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10</a:t>
              </a:r>
              <a:endParaRPr lang="de-DE" sz="14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938972" y="1797177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1</a:t>
              </a:r>
              <a:endParaRPr lang="de-DE" sz="14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489636" y="1797177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/>
                <a:t>C2</a:t>
              </a:r>
              <a:endParaRPr lang="de-DE" sz="14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012160" y="1797177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/>
                <a:t>C3</a:t>
              </a:r>
              <a:endParaRPr lang="de-DE" sz="14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706840" y="1797177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4</a:t>
              </a:r>
              <a:endParaRPr lang="de-DE" sz="14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7196620" y="1797177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5</a:t>
              </a:r>
              <a:endParaRPr lang="de-DE" sz="14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516402" y="1797177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6</a:t>
              </a:r>
              <a:endParaRPr lang="de-DE" sz="14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7904000" y="1797177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/>
                <a:t>C7</a:t>
              </a:r>
              <a:endParaRPr lang="de-DE" sz="14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238640" y="1797177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8</a:t>
              </a:r>
              <a:endParaRPr lang="de-DE" sz="14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8596522" y="1797177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9</a:t>
              </a:r>
              <a:endParaRPr lang="de-DE" sz="14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611560" y="1178556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.0</a:t>
              </a:r>
              <a:endParaRPr lang="de-DE" sz="14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82796" y="1638832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de-DE" sz="14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617462" y="1412073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5</a:t>
              </a:r>
              <a:endParaRPr lang="de-DE" sz="14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899592" y="1209184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BB</a:t>
              </a:r>
              <a:endParaRPr lang="de-DE" sz="11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893408" y="1435231"/>
              <a:ext cx="34336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AB</a:t>
              </a:r>
              <a:endParaRPr lang="de-DE" sz="11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888544" y="1666197"/>
              <a:ext cx="348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AA</a:t>
              </a:r>
              <a:endParaRPr lang="de-DE" sz="1100" dirty="0"/>
            </a:p>
          </p:txBody>
        </p:sp>
      </p:grpSp>
      <p:grpSp>
        <p:nvGrpSpPr>
          <p:cNvPr id="145" name="Group 144"/>
          <p:cNvGrpSpPr/>
          <p:nvPr/>
        </p:nvGrpSpPr>
        <p:grpSpPr>
          <a:xfrm>
            <a:off x="-3049" y="4390208"/>
            <a:ext cx="8971789" cy="2438571"/>
            <a:chOff x="-3049" y="2201518"/>
            <a:chExt cx="8971789" cy="2438571"/>
          </a:xfrm>
        </p:grpSpPr>
        <p:pic>
          <p:nvPicPr>
            <p:cNvPr id="66" name="Picture 6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01" t="74512" r="4626" b="8952"/>
            <a:stretch/>
          </p:blipFill>
          <p:spPr>
            <a:xfrm>
              <a:off x="1125548" y="3535762"/>
              <a:ext cx="7838452" cy="483429"/>
            </a:xfrm>
            <a:prstGeom prst="rect">
              <a:avLst/>
            </a:prstGeom>
          </p:spPr>
        </p:pic>
        <p:pic>
          <p:nvPicPr>
            <p:cNvPr id="67" name="Picture 6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01" t="40261" r="4626" b="42023"/>
            <a:stretch/>
          </p:blipFill>
          <p:spPr>
            <a:xfrm>
              <a:off x="1152400" y="2728434"/>
              <a:ext cx="7816340" cy="516498"/>
            </a:xfrm>
            <a:prstGeom prst="rect">
              <a:avLst/>
            </a:prstGeom>
          </p:spPr>
        </p:pic>
        <p:sp>
          <p:nvSpPr>
            <p:cNvPr id="68" name="TextBox 67"/>
            <p:cNvSpPr txBox="1"/>
            <p:nvPr/>
          </p:nvSpPr>
          <p:spPr>
            <a:xfrm>
              <a:off x="275216" y="2201518"/>
              <a:ext cx="9909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MD_042</a:t>
              </a:r>
              <a:endParaRPr lang="de-DE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9858" y="2204864"/>
              <a:ext cx="3882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C)</a:t>
              </a:r>
              <a:endParaRPr lang="de-DE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697104" y="4301535"/>
              <a:ext cx="238706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Chromosome and position</a:t>
              </a:r>
              <a:endParaRPr lang="de-DE" sz="160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114350" y="4031858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1</a:t>
              </a:r>
              <a:endParaRPr lang="de-DE" sz="1400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393346" y="4031858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2</a:t>
              </a:r>
              <a:endParaRPr lang="de-DE" sz="14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759736" y="4031858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3</a:t>
              </a:r>
              <a:endParaRPr lang="de-DE" sz="1400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191784" y="4031858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4</a:t>
              </a:r>
              <a:endParaRPr lang="de-DE" sz="14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623832" y="4031858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5</a:t>
              </a:r>
              <a:endParaRPr lang="de-DE" sz="140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021972" y="4031858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6</a:t>
              </a:r>
              <a:endParaRPr lang="de-DE" sz="14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441320" y="4031858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7</a:t>
              </a:r>
              <a:endParaRPr lang="de-DE" sz="1400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3842146" y="4031858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8</a:t>
              </a:r>
              <a:endParaRPr lang="de-DE" sz="1400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149228" y="4031858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9</a:t>
              </a:r>
              <a:endParaRPr lang="de-DE" sz="1400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398070" y="4031858"/>
              <a:ext cx="4716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10</a:t>
              </a:r>
              <a:endParaRPr lang="de-DE" sz="1400" dirty="0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937706" y="403185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1</a:t>
              </a:r>
              <a:endParaRPr lang="de-DE" sz="1400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5488370" y="403185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/>
                <a:t>C2</a:t>
              </a:r>
              <a:endParaRPr lang="de-DE" sz="14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6010894" y="403185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/>
                <a:t>C3</a:t>
              </a:r>
              <a:endParaRPr lang="de-DE" sz="1400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6705574" y="403185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4</a:t>
              </a:r>
              <a:endParaRPr lang="de-DE" sz="1400" dirty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7195354" y="403185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5</a:t>
              </a:r>
              <a:endParaRPr lang="de-DE" sz="1400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7515136" y="403185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6</a:t>
              </a:r>
              <a:endParaRPr lang="de-DE" sz="1400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7902734" y="403185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/>
                <a:t>C7</a:t>
              </a:r>
              <a:endParaRPr lang="de-DE" sz="1400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8237374" y="403185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8</a:t>
              </a:r>
              <a:endParaRPr lang="de-DE" sz="1400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8595256" y="4031858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9</a:t>
              </a:r>
              <a:endParaRPr lang="de-DE" sz="1400" dirty="0"/>
            </a:p>
          </p:txBody>
        </p:sp>
        <p:sp>
          <p:nvSpPr>
            <p:cNvPr id="90" name="TextBox 89"/>
            <p:cNvSpPr txBox="1"/>
            <p:nvPr/>
          </p:nvSpPr>
          <p:spPr>
            <a:xfrm rot="16200000">
              <a:off x="-214902" y="3603818"/>
              <a:ext cx="94692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/>
                <a:t>B Allele </a:t>
              </a:r>
            </a:p>
            <a:p>
              <a:pPr algn="ctr"/>
              <a:r>
                <a:rPr lang="en-US" sz="1400" dirty="0" smtClean="0"/>
                <a:t>Frequency</a:t>
              </a:r>
              <a:endParaRPr lang="de-DE" sz="1400" dirty="0"/>
            </a:p>
          </p:txBody>
        </p:sp>
        <p:sp>
          <p:nvSpPr>
            <p:cNvPr id="91" name="Rectangle 90"/>
            <p:cNvSpPr/>
            <p:nvPr/>
          </p:nvSpPr>
          <p:spPr>
            <a:xfrm rot="16200000">
              <a:off x="-110017" y="2826852"/>
              <a:ext cx="99732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Log R Ratio</a:t>
              </a:r>
              <a:endParaRPr lang="de-DE" sz="1400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557520" y="2588184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.0</a:t>
              </a:r>
              <a:endParaRPr lang="de-DE" sz="1400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78146" y="3050315"/>
              <a:ext cx="506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- 1.0</a:t>
              </a:r>
              <a:endParaRPr lang="de-DE" sz="1400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622162" y="2823749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de-DE" sz="1400" dirty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573014" y="3371669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.0</a:t>
              </a:r>
              <a:endParaRPr lang="de-DE" sz="1400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644250" y="3831945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de-DE" sz="1400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578916" y="3605186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5</a:t>
              </a:r>
              <a:endParaRPr lang="de-DE" sz="1400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861046" y="3402297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BB</a:t>
              </a:r>
              <a:endParaRPr lang="de-DE" sz="1100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854862" y="3628344"/>
              <a:ext cx="34336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AB</a:t>
              </a:r>
              <a:endParaRPr lang="de-DE" sz="1100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849998" y="3859310"/>
              <a:ext cx="348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AA</a:t>
              </a:r>
              <a:endParaRPr lang="de-DE" sz="1100" dirty="0"/>
            </a:p>
          </p:txBody>
        </p:sp>
      </p:grpSp>
      <p:grpSp>
        <p:nvGrpSpPr>
          <p:cNvPr id="146" name="Group 145"/>
          <p:cNvGrpSpPr/>
          <p:nvPr/>
        </p:nvGrpSpPr>
        <p:grpSpPr>
          <a:xfrm>
            <a:off x="7288" y="1148"/>
            <a:ext cx="9029208" cy="2382503"/>
            <a:chOff x="-64720" y="4458535"/>
            <a:chExt cx="9029208" cy="2382503"/>
          </a:xfrm>
        </p:grpSpPr>
        <p:pic>
          <p:nvPicPr>
            <p:cNvPr id="106" name="Picture 10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78" t="73644" r="4752" b="8640"/>
            <a:stretch/>
          </p:blipFill>
          <p:spPr>
            <a:xfrm>
              <a:off x="1125076" y="5727602"/>
              <a:ext cx="7838940" cy="517991"/>
            </a:xfrm>
            <a:prstGeom prst="rect">
              <a:avLst/>
            </a:prstGeom>
          </p:spPr>
        </p:pic>
        <p:pic>
          <p:nvPicPr>
            <p:cNvPr id="107" name="Picture 106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78" t="40317" r="4752" b="41967"/>
            <a:stretch/>
          </p:blipFill>
          <p:spPr>
            <a:xfrm>
              <a:off x="1125548" y="4941168"/>
              <a:ext cx="7838940" cy="517991"/>
            </a:xfrm>
            <a:prstGeom prst="rect">
              <a:avLst/>
            </a:prstGeom>
          </p:spPr>
        </p:pic>
        <p:sp>
          <p:nvSpPr>
            <p:cNvPr id="108" name="TextBox 107"/>
            <p:cNvSpPr txBox="1"/>
            <p:nvPr/>
          </p:nvSpPr>
          <p:spPr>
            <a:xfrm>
              <a:off x="3625096" y="6502484"/>
              <a:ext cx="238706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Chromosome and position</a:t>
              </a:r>
              <a:endParaRPr lang="de-DE" sz="1600" dirty="0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1111364" y="6246673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1</a:t>
              </a:r>
              <a:endParaRPr lang="de-DE" sz="1400" dirty="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1390360" y="6246673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2</a:t>
              </a:r>
              <a:endParaRPr lang="de-DE" sz="1400" dirty="0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1756750" y="6246673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3</a:t>
              </a:r>
              <a:endParaRPr lang="de-DE" sz="1400" dirty="0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188798" y="6246673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4</a:t>
              </a:r>
              <a:endParaRPr lang="de-DE" sz="1400" dirty="0"/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2620846" y="6246673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5</a:t>
              </a:r>
              <a:endParaRPr lang="de-DE" sz="1400" dirty="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3018986" y="6246673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6</a:t>
              </a:r>
              <a:endParaRPr lang="de-DE" sz="1400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3438334" y="6246673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7</a:t>
              </a:r>
              <a:endParaRPr lang="de-DE" sz="1400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839160" y="6246673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8</a:t>
              </a:r>
              <a:endParaRPr lang="de-DE" sz="1400" dirty="0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4146242" y="6246673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9</a:t>
              </a:r>
              <a:endParaRPr lang="de-DE" sz="1400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4395084" y="6246673"/>
              <a:ext cx="4716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10</a:t>
              </a:r>
              <a:endParaRPr lang="de-DE" sz="1400" dirty="0"/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4934720" y="62466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1</a:t>
              </a:r>
              <a:endParaRPr lang="de-DE" sz="1400" dirty="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5485384" y="62466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/>
                <a:t>C2</a:t>
              </a:r>
              <a:endParaRPr lang="de-DE" sz="1400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6007908" y="62466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/>
                <a:t>C3</a:t>
              </a:r>
              <a:endParaRPr lang="de-DE" sz="1400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6702588" y="62466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4</a:t>
              </a:r>
              <a:endParaRPr lang="de-DE" sz="1400" dirty="0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7192368" y="62466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5</a:t>
              </a:r>
              <a:endParaRPr lang="de-DE" sz="1400" dirty="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7512150" y="62466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6</a:t>
              </a:r>
              <a:endParaRPr lang="de-DE" sz="1400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7899748" y="62466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/>
                <a:t>C7</a:t>
              </a:r>
              <a:endParaRPr lang="de-DE" sz="1400" dirty="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8234388" y="62466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8</a:t>
              </a:r>
              <a:endParaRPr lang="de-DE" sz="1400" dirty="0"/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8592270" y="62466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9</a:t>
              </a:r>
              <a:endParaRPr lang="de-DE" sz="1400" dirty="0"/>
            </a:p>
          </p:txBody>
        </p:sp>
        <p:sp>
          <p:nvSpPr>
            <p:cNvPr id="128" name="TextBox 127"/>
            <p:cNvSpPr txBox="1"/>
            <p:nvPr/>
          </p:nvSpPr>
          <p:spPr>
            <a:xfrm rot="16200000">
              <a:off x="-253166" y="5831799"/>
              <a:ext cx="94692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/>
                <a:t>B Allele </a:t>
              </a:r>
            </a:p>
            <a:p>
              <a:pPr algn="ctr"/>
              <a:r>
                <a:rPr lang="en-US" sz="1400" dirty="0" smtClean="0"/>
                <a:t>Frequency</a:t>
              </a:r>
              <a:endParaRPr lang="de-DE" sz="1400" dirty="0"/>
            </a:p>
          </p:txBody>
        </p:sp>
        <p:sp>
          <p:nvSpPr>
            <p:cNvPr id="129" name="Rectangle 128"/>
            <p:cNvSpPr/>
            <p:nvPr/>
          </p:nvSpPr>
          <p:spPr>
            <a:xfrm rot="16200000">
              <a:off x="-148281" y="5054833"/>
              <a:ext cx="99732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Log R Ratio</a:t>
              </a:r>
              <a:endParaRPr lang="de-DE" sz="1400" dirty="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519256" y="4816165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.0</a:t>
              </a:r>
              <a:endParaRPr lang="de-DE" sz="1400" dirty="0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439882" y="5278296"/>
              <a:ext cx="506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- 1.0</a:t>
              </a:r>
              <a:endParaRPr lang="de-DE" sz="1400" dirty="0"/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583898" y="505173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de-DE" sz="1400" dirty="0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534750" y="5599650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.0</a:t>
              </a:r>
              <a:endParaRPr lang="de-DE" sz="1400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605986" y="6059926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de-DE" sz="1400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540652" y="5833167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5</a:t>
              </a:r>
              <a:endParaRPr lang="de-DE" sz="1400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822782" y="5630278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BB</a:t>
              </a:r>
              <a:endParaRPr lang="de-DE" sz="1100" dirty="0"/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816598" y="5856325"/>
              <a:ext cx="34336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AB</a:t>
              </a:r>
              <a:endParaRPr lang="de-DE" sz="1100" dirty="0"/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811734" y="6087291"/>
              <a:ext cx="348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AA</a:t>
              </a:r>
              <a:endParaRPr lang="de-DE" sz="1100" dirty="0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236010" y="4475627"/>
              <a:ext cx="2806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i="1" dirty="0" smtClean="0"/>
                <a:t>B. </a:t>
              </a:r>
              <a:r>
                <a:rPr lang="en-US" i="1" dirty="0" err="1" smtClean="0"/>
                <a:t>carinata</a:t>
              </a:r>
              <a:r>
                <a:rPr lang="en-US" dirty="0" smtClean="0"/>
                <a:t> parent genotype</a:t>
              </a:r>
              <a:endParaRPr lang="de-DE" i="1" dirty="0"/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-64720" y="4458535"/>
              <a:ext cx="3882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)</a:t>
              </a:r>
              <a:endParaRPr lang="de-DE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05623" y="6889948"/>
            <a:ext cx="8744764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5: Copy number variation for A and C genome SNP alleles. </a:t>
            </a:r>
            <a:r>
              <a:rPr lang="en-US" dirty="0"/>
              <a:t>Log R Ratio is averaged </a:t>
            </a:r>
            <a:r>
              <a:rPr lang="en-US" dirty="0" smtClean="0"/>
              <a:t>for all SNPs within </a:t>
            </a:r>
            <a:r>
              <a:rPr lang="en-US" dirty="0"/>
              <a:t>each individual such that </a:t>
            </a:r>
            <a:r>
              <a:rPr lang="en-US" dirty="0" smtClean="0"/>
              <a:t>dots (SNPs) </a:t>
            </a:r>
            <a:r>
              <a:rPr lang="en-US" dirty="0"/>
              <a:t>above the line indicate higher copy </a:t>
            </a:r>
            <a:r>
              <a:rPr lang="en-US" dirty="0" smtClean="0"/>
              <a:t>number for those SNPs relative to other SNPs and </a:t>
            </a:r>
            <a:r>
              <a:rPr lang="en-US" dirty="0"/>
              <a:t>dots below the line indicate lower copy </a:t>
            </a:r>
            <a:r>
              <a:rPr lang="en-US" dirty="0" smtClean="0"/>
              <a:t>number of those SNPs relative to other SNPs. </a:t>
            </a:r>
            <a:r>
              <a:rPr lang="en-US" dirty="0"/>
              <a:t>B Allele Frequency refers to the ratio of A:B allele amplification, where a ratio of 0.5 indicates a heterozygote (AB) and 0 or 1 indicates </a:t>
            </a:r>
            <a:r>
              <a:rPr lang="en-US" dirty="0" err="1"/>
              <a:t>homozygosity</a:t>
            </a:r>
            <a:r>
              <a:rPr lang="en-US" dirty="0"/>
              <a:t> (presence or absence of the B allele</a:t>
            </a:r>
            <a:r>
              <a:rPr lang="en-US" dirty="0" smtClean="0"/>
              <a:t>).</a:t>
            </a:r>
            <a:r>
              <a:rPr lang="de-DE" dirty="0" smtClean="0"/>
              <a:t> </a:t>
            </a:r>
            <a:r>
              <a:rPr lang="en-US" dirty="0" smtClean="0"/>
              <a:t>A</a:t>
            </a:r>
            <a:r>
              <a:rPr lang="en-US" dirty="0" smtClean="0"/>
              <a:t>) Absence of all A genome chromosomes and presence of two identical copies of each C genome chromosome in a </a:t>
            </a:r>
            <a:r>
              <a:rPr lang="en-US" i="1" dirty="0" smtClean="0"/>
              <a:t>B. </a:t>
            </a:r>
            <a:r>
              <a:rPr lang="en-US" i="1" dirty="0" err="1" smtClean="0"/>
              <a:t>carinata</a:t>
            </a:r>
            <a:r>
              <a:rPr lang="en-US" dirty="0" smtClean="0"/>
              <a:t> line. B) One copy of chromosomes A2, A6 and A9 and two copies of all other chromosomes in a near-</a:t>
            </a:r>
            <a:r>
              <a:rPr lang="en-US" dirty="0" err="1" smtClean="0"/>
              <a:t>allohexaploid</a:t>
            </a:r>
            <a:r>
              <a:rPr lang="en-US" dirty="0" smtClean="0"/>
              <a:t> </a:t>
            </a:r>
            <a:r>
              <a:rPr lang="en-US" dirty="0" smtClean="0"/>
              <a:t>hybrid</a:t>
            </a:r>
            <a:r>
              <a:rPr lang="en-US" dirty="0" smtClean="0"/>
              <a:t>. C) Example microspore-derived line </a:t>
            </a:r>
            <a:r>
              <a:rPr lang="en-US" dirty="0" smtClean="0"/>
              <a:t>MD_042 </a:t>
            </a:r>
            <a:r>
              <a:rPr lang="en-US" dirty="0" smtClean="0"/>
              <a:t>from </a:t>
            </a:r>
            <a:r>
              <a:rPr lang="en-US" dirty="0" smtClean="0"/>
              <a:t>the near-</a:t>
            </a:r>
            <a:r>
              <a:rPr lang="en-US" dirty="0" err="1" smtClean="0"/>
              <a:t>allohexaploid</a:t>
            </a:r>
            <a:r>
              <a:rPr lang="en-US" dirty="0" smtClean="0"/>
              <a:t> hybrid, </a:t>
            </a:r>
            <a:r>
              <a:rPr lang="en-US" dirty="0" smtClean="0"/>
              <a:t>with absence of chromosomes A2, A6 and part of C6, an extra copy of chromosome A5 and a duplication of part of chromosome A7</a:t>
            </a:r>
            <a:r>
              <a:rPr lang="en-US" dirty="0" smtClean="0"/>
              <a:t>.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132044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5</Words>
  <Application>Microsoft Office PowerPoint</Application>
  <PresentationFormat>On-screen Show (4:3)</PresentationFormat>
  <Paragraphs>171</Paragraphs>
  <Slides>5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Faculty of Science - The University of Queensla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liese Mason</dc:creator>
  <cp:lastModifiedBy>PZ1</cp:lastModifiedBy>
  <cp:revision>203</cp:revision>
  <dcterms:created xsi:type="dcterms:W3CDTF">2013-04-29T08:19:45Z</dcterms:created>
  <dcterms:modified xsi:type="dcterms:W3CDTF">2015-04-17T15:26:10Z</dcterms:modified>
</cp:coreProperties>
</file>